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5" r:id="rId5"/>
    <p:sldId id="267" r:id="rId6"/>
    <p:sldId id="293" r:id="rId7"/>
    <p:sldId id="291" r:id="rId8"/>
    <p:sldId id="283" r:id="rId9"/>
    <p:sldId id="292" r:id="rId10"/>
    <p:sldId id="272" r:id="rId11"/>
    <p:sldId id="275" r:id="rId12"/>
    <p:sldId id="278" r:id="rId13"/>
    <p:sldId id="279" r:id="rId14"/>
    <p:sldId id="295" r:id="rId15"/>
    <p:sldId id="287" r:id="rId16"/>
    <p:sldId id="294" r:id="rId17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5371E0-F447-4064-84F8-A642625BBAD4}" v="113" dt="2020-06-23T14:44:18.89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020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https://scientificnet-my.sharepoint.com/personal/ecorretto_unibz_it/Documents/microbacterium/reviewers_response/HM_mob_greenhouse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IT\CorrettoE\Microbacterium%20Collection\Comparative_Genomics\NCBIgenomes\paper\figures_tables2\HM_mob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M mob'!$N$1</c:f>
              <c:strCache>
                <c:ptCount val="1"/>
                <c:pt idx="0">
                  <c:v>Cu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2C9-44DE-8B39-9A98A204160E}"/>
              </c:ext>
            </c:extLst>
          </c:dPt>
          <c:dPt>
            <c:idx val="1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B2C9-44DE-8B39-9A98A204160E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2C9-44DE-8B39-9A98A204160E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B2C9-44DE-8B39-9A98A204160E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2C9-44DE-8B39-9A98A204160E}"/>
              </c:ext>
            </c:extLst>
          </c:dPt>
          <c:dPt>
            <c:idx val="5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B2C9-44DE-8B39-9A98A204160E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2C9-44DE-8B39-9A98A204160E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B2C9-44DE-8B39-9A98A204160E}"/>
              </c:ext>
            </c:extLst>
          </c:dPt>
          <c:dPt>
            <c:idx val="8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2C9-44DE-8B39-9A98A204160E}"/>
              </c:ext>
            </c:extLst>
          </c:dPt>
          <c:dPt>
            <c:idx val="9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B2C9-44DE-8B39-9A98A204160E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2C9-44DE-8B39-9A98A204160E}"/>
              </c:ext>
            </c:extLst>
          </c:dPt>
          <c:dPt>
            <c:idx val="11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B2C9-44DE-8B39-9A98A204160E}"/>
              </c:ext>
            </c:extLst>
          </c:dPt>
          <c:dPt>
            <c:idx val="12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2C9-44DE-8B39-9A98A204160E}"/>
              </c:ext>
            </c:extLst>
          </c:dPt>
          <c:dPt>
            <c:idx val="13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B2C9-44DE-8B39-9A98A204160E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2C9-44DE-8B39-9A98A204160E}"/>
              </c:ext>
            </c:extLst>
          </c:dPt>
          <c:dPt>
            <c:idx val="15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B2C9-44DE-8B39-9A98A204160E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2C9-44DE-8B39-9A98A204160E}"/>
              </c:ext>
            </c:extLst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B2C9-44DE-8B39-9A98A204160E}"/>
              </c:ext>
            </c:extLst>
          </c:dPt>
          <c:dPt>
            <c:idx val="1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B2C9-44DE-8B39-9A98A204160E}"/>
              </c:ext>
            </c:extLst>
          </c:dPt>
          <c:dPt>
            <c:idx val="19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B2C9-44DE-8B39-9A98A204160E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B2C9-44DE-8B39-9A98A204160E}"/>
              </c:ext>
            </c:extLst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B2C9-44DE-8B39-9A98A204160E}"/>
              </c:ext>
            </c:extLst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B2C9-44DE-8B39-9A98A204160E}"/>
              </c:ext>
            </c:extLst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B2C9-44DE-8B39-9A98A204160E}"/>
              </c:ext>
            </c:extLst>
          </c:dPt>
          <c:dPt>
            <c:idx val="24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B2C9-44DE-8B39-9A98A204160E}"/>
              </c:ext>
            </c:extLst>
          </c:dPt>
          <c:dPt>
            <c:idx val="25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B2C9-44DE-8B39-9A98A204160E}"/>
              </c:ext>
            </c:extLst>
          </c:dPt>
          <c:dPt>
            <c:idx val="26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B2C9-44DE-8B39-9A98A204160E}"/>
              </c:ext>
            </c:extLst>
          </c:dPt>
          <c:dPt>
            <c:idx val="27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B2C9-44DE-8B39-9A98A204160E}"/>
              </c:ext>
            </c:extLst>
          </c:dPt>
          <c:dPt>
            <c:idx val="28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B2C9-44DE-8B39-9A98A204160E}"/>
              </c:ext>
            </c:extLst>
          </c:dPt>
          <c:dPt>
            <c:idx val="2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B2C9-44DE-8B39-9A98A204160E}"/>
              </c:ext>
            </c:extLst>
          </c:dPt>
          <c:errBars>
            <c:errBarType val="both"/>
            <c:errValType val="cust"/>
            <c:noEndCap val="0"/>
            <c:plus>
              <c:numRef>
                <c:f>'HM mob'!$AD$3:$AD$32</c:f>
                <c:numCache>
                  <c:formatCode>General</c:formatCode>
                  <c:ptCount val="30"/>
                  <c:pt idx="0">
                    <c:v>0.19910377046939601</c:v>
                  </c:pt>
                  <c:pt idx="1">
                    <c:v>6.6585960456569865E-2</c:v>
                  </c:pt>
                  <c:pt idx="2">
                    <c:v>7.1426445312313624E-2</c:v>
                  </c:pt>
                  <c:pt idx="3">
                    <c:v>5.599706840074898E-2</c:v>
                  </c:pt>
                  <c:pt idx="4">
                    <c:v>4.5692495061273972E-2</c:v>
                  </c:pt>
                  <c:pt idx="5">
                    <c:v>3.6471355616013335E-2</c:v>
                  </c:pt>
                  <c:pt idx="6">
                    <c:v>7.8378218563185331E-2</c:v>
                  </c:pt>
                  <c:pt idx="7">
                    <c:v>7.2687930355843061E-2</c:v>
                  </c:pt>
                  <c:pt idx="8">
                    <c:v>0.18042201157830057</c:v>
                  </c:pt>
                  <c:pt idx="9">
                    <c:v>5.3091407140428704E-2</c:v>
                  </c:pt>
                  <c:pt idx="10">
                    <c:v>6.7165745818635603E-2</c:v>
                  </c:pt>
                  <c:pt idx="11">
                    <c:v>0.2614208797678963</c:v>
                  </c:pt>
                  <c:pt idx="12">
                    <c:v>0.15507230414383799</c:v>
                  </c:pt>
                  <c:pt idx="13">
                    <c:v>0.25665033424529471</c:v>
                  </c:pt>
                  <c:pt idx="14">
                    <c:v>4.7536684695932689E-2</c:v>
                  </c:pt>
                  <c:pt idx="15">
                    <c:v>2.3989407693966673E-2</c:v>
                  </c:pt>
                  <c:pt idx="16">
                    <c:v>1.9806381002049591E-2</c:v>
                  </c:pt>
                  <c:pt idx="17">
                    <c:v>0.18840598218279261</c:v>
                  </c:pt>
                  <c:pt idx="18">
                    <c:v>0.16544269319318031</c:v>
                  </c:pt>
                  <c:pt idx="19">
                    <c:v>2.6099438270187344E-2</c:v>
                  </c:pt>
                  <c:pt idx="21">
                    <c:v>0.18189754049815063</c:v>
                  </c:pt>
                  <c:pt idx="22">
                    <c:v>3.3452840850758489E-2</c:v>
                  </c:pt>
                  <c:pt idx="23">
                    <c:v>2.4489309459121807E-2</c:v>
                  </c:pt>
                  <c:pt idx="24">
                    <c:v>4.3608647530661952E-2</c:v>
                  </c:pt>
                  <c:pt idx="25">
                    <c:v>4.0263202606524433E-2</c:v>
                  </c:pt>
                  <c:pt idx="26">
                    <c:v>8.2104303329157205E-2</c:v>
                  </c:pt>
                  <c:pt idx="27">
                    <c:v>9.42224435721295E-2</c:v>
                  </c:pt>
                  <c:pt idx="28">
                    <c:v>0.78209049714562073</c:v>
                  </c:pt>
                  <c:pt idx="29">
                    <c:v>7.5712527716122399E-2</c:v>
                  </c:pt>
                </c:numCache>
              </c:numRef>
            </c:plus>
            <c:minus>
              <c:numRef>
                <c:f>'HM mob'!$AD$3:$AD$32</c:f>
                <c:numCache>
                  <c:formatCode>General</c:formatCode>
                  <c:ptCount val="30"/>
                  <c:pt idx="0">
                    <c:v>0.19910377046939601</c:v>
                  </c:pt>
                  <c:pt idx="1">
                    <c:v>6.6585960456569865E-2</c:v>
                  </c:pt>
                  <c:pt idx="2">
                    <c:v>7.1426445312313624E-2</c:v>
                  </c:pt>
                  <c:pt idx="3">
                    <c:v>5.599706840074898E-2</c:v>
                  </c:pt>
                  <c:pt idx="4">
                    <c:v>4.5692495061273972E-2</c:v>
                  </c:pt>
                  <c:pt idx="5">
                    <c:v>3.6471355616013335E-2</c:v>
                  </c:pt>
                  <c:pt idx="6">
                    <c:v>7.8378218563185331E-2</c:v>
                  </c:pt>
                  <c:pt idx="7">
                    <c:v>7.2687930355843061E-2</c:v>
                  </c:pt>
                  <c:pt idx="8">
                    <c:v>0.18042201157830057</c:v>
                  </c:pt>
                  <c:pt idx="9">
                    <c:v>5.3091407140428704E-2</c:v>
                  </c:pt>
                  <c:pt idx="10">
                    <c:v>6.7165745818635603E-2</c:v>
                  </c:pt>
                  <c:pt idx="11">
                    <c:v>0.2614208797678963</c:v>
                  </c:pt>
                  <c:pt idx="12">
                    <c:v>0.15507230414383799</c:v>
                  </c:pt>
                  <c:pt idx="13">
                    <c:v>0.25665033424529471</c:v>
                  </c:pt>
                  <c:pt idx="14">
                    <c:v>4.7536684695932689E-2</c:v>
                  </c:pt>
                  <c:pt idx="15">
                    <c:v>2.3989407693966673E-2</c:v>
                  </c:pt>
                  <c:pt idx="16">
                    <c:v>1.9806381002049591E-2</c:v>
                  </c:pt>
                  <c:pt idx="17">
                    <c:v>0.18840598218279261</c:v>
                  </c:pt>
                  <c:pt idx="18">
                    <c:v>0.16544269319318031</c:v>
                  </c:pt>
                  <c:pt idx="19">
                    <c:v>2.6099438270187344E-2</c:v>
                  </c:pt>
                  <c:pt idx="21">
                    <c:v>0.18189754049815063</c:v>
                  </c:pt>
                  <c:pt idx="22">
                    <c:v>3.3452840850758489E-2</c:v>
                  </c:pt>
                  <c:pt idx="23">
                    <c:v>2.4489309459121807E-2</c:v>
                  </c:pt>
                  <c:pt idx="24">
                    <c:v>4.3608647530661952E-2</c:v>
                  </c:pt>
                  <c:pt idx="25">
                    <c:v>4.0263202606524433E-2</c:v>
                  </c:pt>
                  <c:pt idx="26">
                    <c:v>8.2104303329157205E-2</c:v>
                  </c:pt>
                  <c:pt idx="27">
                    <c:v>9.42224435721295E-2</c:v>
                  </c:pt>
                  <c:pt idx="28">
                    <c:v>0.78209049714562073</c:v>
                  </c:pt>
                  <c:pt idx="29">
                    <c:v>7.57125277161223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M mob'!$I$3:$I$32</c:f>
              <c:strCache>
                <c:ptCount val="30"/>
                <c:pt idx="0">
                  <c:v>ARN176</c:v>
                </c:pt>
                <c:pt idx="1">
                  <c:v> SA35</c:v>
                </c:pt>
                <c:pt idx="2">
                  <c:v> BEL4b</c:v>
                </c:pt>
                <c:pt idx="3">
                  <c:v>BEL156</c:v>
                </c:pt>
                <c:pt idx="4">
                  <c:v>BEL163</c:v>
                </c:pt>
                <c:pt idx="5">
                  <c:v>BEL125bM</c:v>
                </c:pt>
                <c:pt idx="6">
                  <c:v>EX104</c:v>
                </c:pt>
                <c:pt idx="7">
                  <c:v>EX72</c:v>
                </c:pt>
                <c:pt idx="8">
                  <c:v>SA5b</c:v>
                </c:pt>
                <c:pt idx="9">
                  <c:v>SA39</c:v>
                </c:pt>
                <c:pt idx="10">
                  <c:v>8.11S</c:v>
                </c:pt>
                <c:pt idx="11">
                  <c:v>444</c:v>
                </c:pt>
                <c:pt idx="12">
                  <c:v>DSM 23848</c:v>
                </c:pt>
                <c:pt idx="13">
                  <c:v>DSM 12966</c:v>
                </c:pt>
                <c:pt idx="14">
                  <c:v>DSM 18659</c:v>
                </c:pt>
                <c:pt idx="15">
                  <c:v>138</c:v>
                </c:pt>
                <c:pt idx="16">
                  <c:v>DSM 12510</c:v>
                </c:pt>
                <c:pt idx="17">
                  <c:v>280</c:v>
                </c:pt>
                <c:pt idx="18">
                  <c:v>DSM 13468</c:v>
                </c:pt>
                <c:pt idx="19">
                  <c:v>228</c:v>
                </c:pt>
                <c:pt idx="20">
                  <c:v>DSM 8608</c:v>
                </c:pt>
                <c:pt idx="21">
                  <c:v>P1-3</c:v>
                </c:pt>
                <c:pt idx="22">
                  <c:v>1.5R</c:v>
                </c:pt>
                <c:pt idx="23">
                  <c:v>8</c:v>
                </c:pt>
                <c:pt idx="24">
                  <c:v>8.4Sa</c:v>
                </c:pt>
                <c:pt idx="25">
                  <c:v>507</c:v>
                </c:pt>
                <c:pt idx="26">
                  <c:v>625</c:v>
                </c:pt>
                <c:pt idx="27">
                  <c:v>KO1</c:v>
                </c:pt>
                <c:pt idx="28">
                  <c:v>KO2</c:v>
                </c:pt>
                <c:pt idx="29">
                  <c:v>NC</c:v>
                </c:pt>
              </c:strCache>
            </c:strRef>
          </c:cat>
          <c:val>
            <c:numRef>
              <c:f>'HM mob'!$N$3:$N$32</c:f>
              <c:numCache>
                <c:formatCode>General</c:formatCode>
                <c:ptCount val="30"/>
                <c:pt idx="0">
                  <c:v>4.0450542704852719</c:v>
                </c:pt>
                <c:pt idx="1">
                  <c:v>2.8830514439034274</c:v>
                </c:pt>
                <c:pt idx="2">
                  <c:v>3.3153435343779978</c:v>
                </c:pt>
                <c:pt idx="3">
                  <c:v>3.7117592995759949</c:v>
                </c:pt>
                <c:pt idx="4">
                  <c:v>4.1433570110199787</c:v>
                </c:pt>
                <c:pt idx="5">
                  <c:v>3.6576859410680806</c:v>
                </c:pt>
                <c:pt idx="6">
                  <c:v>4.1065444901267432</c:v>
                </c:pt>
                <c:pt idx="7">
                  <c:v>4.1887594568068742</c:v>
                </c:pt>
                <c:pt idx="8">
                  <c:v>3.0858137649857795</c:v>
                </c:pt>
                <c:pt idx="9">
                  <c:v>3.2120390874691584</c:v>
                </c:pt>
                <c:pt idx="10">
                  <c:v>3.440382920932116</c:v>
                </c:pt>
                <c:pt idx="11">
                  <c:v>3.9420199147301838</c:v>
                </c:pt>
                <c:pt idx="12">
                  <c:v>2.5995400002155225</c:v>
                </c:pt>
                <c:pt idx="13">
                  <c:v>3.2434522944179043</c:v>
                </c:pt>
                <c:pt idx="14">
                  <c:v>4.9802450063069399</c:v>
                </c:pt>
                <c:pt idx="15">
                  <c:v>2.8537757774660859</c:v>
                </c:pt>
                <c:pt idx="16">
                  <c:v>4.0012937202204482</c:v>
                </c:pt>
                <c:pt idx="17">
                  <c:v>3.7152163107465341</c:v>
                </c:pt>
                <c:pt idx="18">
                  <c:v>4.0571201111119874</c:v>
                </c:pt>
                <c:pt idx="19">
                  <c:v>4.9563744514031187</c:v>
                </c:pt>
                <c:pt idx="20">
                  <c:v>2.1123405186274509</c:v>
                </c:pt>
                <c:pt idx="21">
                  <c:v>2.7322003408038831</c:v>
                </c:pt>
                <c:pt idx="22">
                  <c:v>3.0866460620014524</c:v>
                </c:pt>
                <c:pt idx="23">
                  <c:v>4.3335990421032369</c:v>
                </c:pt>
                <c:pt idx="24">
                  <c:v>3.2831666673189823</c:v>
                </c:pt>
                <c:pt idx="25">
                  <c:v>3.2069770308143917</c:v>
                </c:pt>
                <c:pt idx="26">
                  <c:v>6.6648197744976185</c:v>
                </c:pt>
                <c:pt idx="27">
                  <c:v>2.5960428596663396</c:v>
                </c:pt>
                <c:pt idx="28">
                  <c:v>4.4587531295729255</c:v>
                </c:pt>
                <c:pt idx="29">
                  <c:v>4.85408842635611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C9-44DE-8B39-9A98A20416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7251024"/>
        <c:axId val="337252992"/>
      </c:barChart>
      <c:catAx>
        <c:axId val="3372510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337252992"/>
        <c:crosses val="autoZero"/>
        <c:auto val="1"/>
        <c:lblAlgn val="ctr"/>
        <c:lblOffset val="100"/>
        <c:noMultiLvlLbl val="0"/>
      </c:catAx>
      <c:valAx>
        <c:axId val="337252992"/>
        <c:scaling>
          <c:orientation val="minMax"/>
          <c:max val="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Copper (mg kg-1)</a:t>
                </a:r>
              </a:p>
            </c:rich>
          </c:tx>
          <c:layout>
            <c:manualLayout>
              <c:xMode val="edge"/>
              <c:yMode val="edge"/>
              <c:x val="2.1573034725791251E-2"/>
              <c:y val="0.326300176021248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725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1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 i="1" dirty="0">
                <a:solidFill>
                  <a:sysClr val="windowText" lastClr="000000"/>
                </a:solidFill>
              </a:rPr>
              <a:t>B.</a:t>
            </a:r>
            <a:r>
              <a:rPr lang="en-US" b="1" i="1" baseline="0" dirty="0">
                <a:solidFill>
                  <a:sysClr val="windowText" lastClr="000000"/>
                </a:solidFill>
              </a:rPr>
              <a:t> </a:t>
            </a:r>
            <a:r>
              <a:rPr lang="en-US" b="1" i="1" baseline="0" dirty="0" err="1">
                <a:solidFill>
                  <a:sysClr val="windowText" lastClr="000000"/>
                </a:solidFill>
              </a:rPr>
              <a:t>napus</a:t>
            </a:r>
            <a:endParaRPr lang="en-US" b="1" i="1" dirty="0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iomass!$L$53</c:f>
              <c:strCache>
                <c:ptCount val="1"/>
                <c:pt idx="0">
                  <c:v>Shoots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L$60:$L$63</c:f>
                <c:numCache>
                  <c:formatCode>General</c:formatCode>
                  <c:ptCount val="4"/>
                  <c:pt idx="0">
                    <c:v>85.357034468948925</c:v>
                  </c:pt>
                  <c:pt idx="1">
                    <c:v>67.119172621042736</c:v>
                  </c:pt>
                  <c:pt idx="2">
                    <c:v>111.1326734633479</c:v>
                  </c:pt>
                  <c:pt idx="3">
                    <c:v>135.21594251829592</c:v>
                  </c:pt>
                </c:numCache>
              </c:numRef>
            </c:plus>
            <c:minus>
              <c:numRef>
                <c:f>biomass!$L$60:$L$63</c:f>
                <c:numCache>
                  <c:formatCode>General</c:formatCode>
                  <c:ptCount val="4"/>
                  <c:pt idx="0">
                    <c:v>85.357034468948925</c:v>
                  </c:pt>
                  <c:pt idx="1">
                    <c:v>67.119172621042736</c:v>
                  </c:pt>
                  <c:pt idx="2">
                    <c:v>111.1326734633479</c:v>
                  </c:pt>
                  <c:pt idx="3">
                    <c:v>135.215942518295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iomass!$K$54:$K$57</c:f>
              <c:strCache>
                <c:ptCount val="4"/>
                <c:pt idx="0">
                  <c:v>NC</c:v>
                </c:pt>
                <c:pt idx="1">
                  <c:v>ARN176</c:v>
                </c:pt>
                <c:pt idx="2">
                  <c:v>1.5R</c:v>
                </c:pt>
                <c:pt idx="3">
                  <c:v>SA35</c:v>
                </c:pt>
              </c:strCache>
            </c:strRef>
          </c:cat>
          <c:val>
            <c:numRef>
              <c:f>biomass!$L$54:$L$57</c:f>
              <c:numCache>
                <c:formatCode>General</c:formatCode>
                <c:ptCount val="4"/>
                <c:pt idx="0">
                  <c:v>483.3</c:v>
                </c:pt>
                <c:pt idx="1">
                  <c:v>495.5</c:v>
                </c:pt>
                <c:pt idx="2">
                  <c:v>510.4</c:v>
                </c:pt>
                <c:pt idx="3">
                  <c:v>559.2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9C-4A6C-8E37-D1AD84624F42}"/>
            </c:ext>
          </c:extLst>
        </c:ser>
        <c:ser>
          <c:idx val="1"/>
          <c:order val="1"/>
          <c:tx>
            <c:strRef>
              <c:f>biomass!$M$53</c:f>
              <c:strCache>
                <c:ptCount val="1"/>
                <c:pt idx="0">
                  <c:v>Roots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M$60:$M$63</c:f>
                <c:numCache>
                  <c:formatCode>General</c:formatCode>
                  <c:ptCount val="4"/>
                  <c:pt idx="0">
                    <c:v>75.306872196367308</c:v>
                  </c:pt>
                  <c:pt idx="1">
                    <c:v>0.35355339059327373</c:v>
                  </c:pt>
                  <c:pt idx="2">
                    <c:v>7.7781745930520225</c:v>
                  </c:pt>
                  <c:pt idx="3">
                    <c:v>25.102290732122434</c:v>
                  </c:pt>
                </c:numCache>
              </c:numRef>
            </c:plus>
            <c:minus>
              <c:numRef>
                <c:f>biomass!$M$60:$M$63</c:f>
                <c:numCache>
                  <c:formatCode>General</c:formatCode>
                  <c:ptCount val="4"/>
                  <c:pt idx="0">
                    <c:v>75.306872196367308</c:v>
                  </c:pt>
                  <c:pt idx="1">
                    <c:v>0.35355339059327373</c:v>
                  </c:pt>
                  <c:pt idx="2">
                    <c:v>7.7781745930520225</c:v>
                  </c:pt>
                  <c:pt idx="3">
                    <c:v>25.1022907321224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iomass!$K$54:$K$57</c:f>
              <c:strCache>
                <c:ptCount val="4"/>
                <c:pt idx="0">
                  <c:v>NC</c:v>
                </c:pt>
                <c:pt idx="1">
                  <c:v>ARN176</c:v>
                </c:pt>
                <c:pt idx="2">
                  <c:v>1.5R</c:v>
                </c:pt>
                <c:pt idx="3">
                  <c:v>SA35</c:v>
                </c:pt>
              </c:strCache>
            </c:strRef>
          </c:cat>
          <c:val>
            <c:numRef>
              <c:f>biomass!$M$54:$M$57</c:f>
              <c:numCache>
                <c:formatCode>General</c:formatCode>
                <c:ptCount val="4"/>
                <c:pt idx="0">
                  <c:v>237.5</c:v>
                </c:pt>
                <c:pt idx="1">
                  <c:v>255.5</c:v>
                </c:pt>
                <c:pt idx="2">
                  <c:v>229</c:v>
                </c:pt>
                <c:pt idx="3">
                  <c:v>225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9C-4A6C-8E37-D1AD84624F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08757008"/>
        <c:axId val="965639120"/>
      </c:barChart>
      <c:catAx>
        <c:axId val="908757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65639120"/>
        <c:crosses val="autoZero"/>
        <c:auto val="1"/>
        <c:lblAlgn val="ctr"/>
        <c:lblOffset val="100"/>
        <c:noMultiLvlLbl val="0"/>
      </c:catAx>
      <c:valAx>
        <c:axId val="965639120"/>
        <c:scaling>
          <c:orientation val="minMax"/>
          <c:max val="7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dry weight (m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908757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oots!$A$4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12:$F$12</c:f>
                <c:numCache>
                  <c:formatCode>General</c:formatCode>
                  <c:ptCount val="5"/>
                  <c:pt idx="0">
                    <c:v>98.316843826280262</c:v>
                  </c:pt>
                  <c:pt idx="1">
                    <c:v>79.390069904873869</c:v>
                  </c:pt>
                  <c:pt idx="2">
                    <c:v>12.775677577147261</c:v>
                  </c:pt>
                  <c:pt idx="3">
                    <c:v>11.431499355408686</c:v>
                  </c:pt>
                  <c:pt idx="4">
                    <c:v>50.634339197474496</c:v>
                  </c:pt>
                </c:numCache>
              </c:numRef>
            </c:plus>
            <c:minus>
              <c:numRef>
                <c:f>shoots!$B$12:$F$12</c:f>
                <c:numCache>
                  <c:formatCode>General</c:formatCode>
                  <c:ptCount val="5"/>
                  <c:pt idx="0">
                    <c:v>98.316843826280262</c:v>
                  </c:pt>
                  <c:pt idx="1">
                    <c:v>79.390069904873869</c:v>
                  </c:pt>
                  <c:pt idx="2">
                    <c:v>12.775677577147261</c:v>
                  </c:pt>
                  <c:pt idx="3">
                    <c:v>11.431499355408686</c:v>
                  </c:pt>
                  <c:pt idx="4">
                    <c:v>50.6343391974744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:$F$2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4:$F$4</c:f>
              <c:numCache>
                <c:formatCode>General</c:formatCode>
                <c:ptCount val="5"/>
                <c:pt idx="0">
                  <c:v>807.75525141378546</c:v>
                </c:pt>
                <c:pt idx="1">
                  <c:v>494.89620530970723</c:v>
                </c:pt>
                <c:pt idx="2">
                  <c:v>168.99661147928978</c:v>
                </c:pt>
                <c:pt idx="3">
                  <c:v>135.74368078155865</c:v>
                </c:pt>
                <c:pt idx="4">
                  <c:v>564.918383377706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7E-44AE-A301-F8B2EF1A6E6A}"/>
            </c:ext>
          </c:extLst>
        </c:ser>
        <c:ser>
          <c:idx val="1"/>
          <c:order val="1"/>
          <c:tx>
            <c:strRef>
              <c:f>shoots!$A$5</c:f>
              <c:strCache>
                <c:ptCount val="1"/>
                <c:pt idx="0">
                  <c:v>ARN176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13:$F$13</c:f>
                <c:numCache>
                  <c:formatCode>General</c:formatCode>
                  <c:ptCount val="5"/>
                  <c:pt idx="0">
                    <c:v>157.87866446831612</c:v>
                  </c:pt>
                  <c:pt idx="1">
                    <c:v>141.3498138528623</c:v>
                  </c:pt>
                  <c:pt idx="2">
                    <c:v>34.928470839297525</c:v>
                  </c:pt>
                  <c:pt idx="3">
                    <c:v>11.76605883196201</c:v>
                  </c:pt>
                  <c:pt idx="4">
                    <c:v>56.501616484116461</c:v>
                  </c:pt>
                </c:numCache>
              </c:numRef>
            </c:plus>
            <c:minus>
              <c:numRef>
                <c:f>shoots!$B$13:$F$13</c:f>
                <c:numCache>
                  <c:formatCode>General</c:formatCode>
                  <c:ptCount val="5"/>
                  <c:pt idx="0">
                    <c:v>157.87866446831612</c:v>
                  </c:pt>
                  <c:pt idx="1">
                    <c:v>141.3498138528623</c:v>
                  </c:pt>
                  <c:pt idx="2">
                    <c:v>34.928470839297525</c:v>
                  </c:pt>
                  <c:pt idx="3">
                    <c:v>11.76605883196201</c:v>
                  </c:pt>
                  <c:pt idx="4">
                    <c:v>56.5016164841164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:$F$2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5:$F$5</c:f>
              <c:numCache>
                <c:formatCode>General</c:formatCode>
                <c:ptCount val="5"/>
                <c:pt idx="0">
                  <c:v>765.86493158490555</c:v>
                </c:pt>
                <c:pt idx="1">
                  <c:v>469.63839083787269</c:v>
                </c:pt>
                <c:pt idx="2">
                  <c:v>190.32754516820989</c:v>
                </c:pt>
                <c:pt idx="3">
                  <c:v>128.17998369440662</c:v>
                </c:pt>
                <c:pt idx="4">
                  <c:v>541.893153642313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27E-44AE-A301-F8B2EF1A6E6A}"/>
            </c:ext>
          </c:extLst>
        </c:ser>
        <c:ser>
          <c:idx val="2"/>
          <c:order val="2"/>
          <c:tx>
            <c:strRef>
              <c:f>shoots!$A$6</c:f>
              <c:strCache>
                <c:ptCount val="1"/>
                <c:pt idx="0">
                  <c:v>1.5R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14:$F$14</c:f>
                <c:numCache>
                  <c:formatCode>General</c:formatCode>
                  <c:ptCount val="5"/>
                  <c:pt idx="0">
                    <c:v>141.04691066056955</c:v>
                  </c:pt>
                  <c:pt idx="1">
                    <c:v>50.663474857844648</c:v>
                  </c:pt>
                  <c:pt idx="2">
                    <c:v>21.582819300155752</c:v>
                  </c:pt>
                  <c:pt idx="3">
                    <c:v>56.752193630779459</c:v>
                  </c:pt>
                  <c:pt idx="4">
                    <c:v>57.849855595744167</c:v>
                  </c:pt>
                </c:numCache>
              </c:numRef>
            </c:plus>
            <c:minus>
              <c:numRef>
                <c:f>shoots!$B$14:$F$14</c:f>
                <c:numCache>
                  <c:formatCode>General</c:formatCode>
                  <c:ptCount val="5"/>
                  <c:pt idx="0">
                    <c:v>141.04691066056955</c:v>
                  </c:pt>
                  <c:pt idx="1">
                    <c:v>50.663474857844648</c:v>
                  </c:pt>
                  <c:pt idx="2">
                    <c:v>21.582819300155752</c:v>
                  </c:pt>
                  <c:pt idx="3">
                    <c:v>56.752193630779459</c:v>
                  </c:pt>
                  <c:pt idx="4">
                    <c:v>57.8498555957441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:$F$2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6:$F$6</c:f>
              <c:numCache>
                <c:formatCode>General</c:formatCode>
                <c:ptCount val="5"/>
                <c:pt idx="0">
                  <c:v>867.90038336421105</c:v>
                </c:pt>
                <c:pt idx="1">
                  <c:v>479.97025109527482</c:v>
                </c:pt>
                <c:pt idx="2">
                  <c:v>199.10829553025397</c:v>
                </c:pt>
                <c:pt idx="3">
                  <c:v>222.61846910655117</c:v>
                </c:pt>
                <c:pt idx="4">
                  <c:v>778.332825799398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27E-44AE-A301-F8B2EF1A6E6A}"/>
            </c:ext>
          </c:extLst>
        </c:ser>
        <c:ser>
          <c:idx val="3"/>
          <c:order val="3"/>
          <c:tx>
            <c:strRef>
              <c:f>shoots!$A$7</c:f>
              <c:strCache>
                <c:ptCount val="1"/>
                <c:pt idx="0">
                  <c:v>SA35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15:$F$15</c:f>
                <c:numCache>
                  <c:formatCode>General</c:formatCode>
                  <c:ptCount val="5"/>
                  <c:pt idx="0">
                    <c:v>158.65751163642943</c:v>
                  </c:pt>
                  <c:pt idx="1">
                    <c:v>91.800786098790056</c:v>
                  </c:pt>
                  <c:pt idx="2">
                    <c:v>17.158794481339545</c:v>
                  </c:pt>
                  <c:pt idx="3">
                    <c:v>20.754853114318426</c:v>
                  </c:pt>
                  <c:pt idx="4">
                    <c:v>93.126370376597535</c:v>
                  </c:pt>
                </c:numCache>
              </c:numRef>
            </c:plus>
            <c:minus>
              <c:numRef>
                <c:f>shoots!$B$15:$F$15</c:f>
                <c:numCache>
                  <c:formatCode>General</c:formatCode>
                  <c:ptCount val="5"/>
                  <c:pt idx="0">
                    <c:v>158.65751163642943</c:v>
                  </c:pt>
                  <c:pt idx="1">
                    <c:v>91.800786098790056</c:v>
                  </c:pt>
                  <c:pt idx="2">
                    <c:v>17.158794481339545</c:v>
                  </c:pt>
                  <c:pt idx="3">
                    <c:v>20.754853114318426</c:v>
                  </c:pt>
                  <c:pt idx="4">
                    <c:v>93.1263703765975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:$F$2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7:$F$7</c:f>
              <c:numCache>
                <c:formatCode>General</c:formatCode>
                <c:ptCount val="5"/>
                <c:pt idx="0">
                  <c:v>731.14335533861924</c:v>
                </c:pt>
                <c:pt idx="1">
                  <c:v>479.42546145671184</c:v>
                </c:pt>
                <c:pt idx="2">
                  <c:v>192.57663271724695</c:v>
                </c:pt>
                <c:pt idx="3">
                  <c:v>178.72200452671518</c:v>
                </c:pt>
                <c:pt idx="4">
                  <c:v>712.013909899805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27E-44AE-A301-F8B2EF1A6E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0388760"/>
        <c:axId val="570390400"/>
      </c:barChart>
      <c:catAx>
        <c:axId val="570388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70390400"/>
        <c:crosses val="autoZero"/>
        <c:auto val="1"/>
        <c:lblAlgn val="ctr"/>
        <c:lblOffset val="100"/>
        <c:noMultiLvlLbl val="0"/>
      </c:catAx>
      <c:valAx>
        <c:axId val="570390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mg kg-1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70388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oots!$A$26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33:$F$33</c:f>
                <c:numCache>
                  <c:formatCode>General</c:formatCode>
                  <c:ptCount val="5"/>
                  <c:pt idx="0">
                    <c:v>39.579708116041303</c:v>
                  </c:pt>
                  <c:pt idx="1">
                    <c:v>10.60911342969808</c:v>
                  </c:pt>
                  <c:pt idx="2">
                    <c:v>9.7545437282174472</c:v>
                  </c:pt>
                  <c:pt idx="3">
                    <c:v>14.913404974947468</c:v>
                  </c:pt>
                  <c:pt idx="4">
                    <c:v>34.777089167673068</c:v>
                  </c:pt>
                </c:numCache>
              </c:numRef>
            </c:plus>
            <c:minus>
              <c:numRef>
                <c:f>shoots!$B$33:$F$33</c:f>
                <c:numCache>
                  <c:formatCode>General</c:formatCode>
                  <c:ptCount val="5"/>
                  <c:pt idx="0">
                    <c:v>39.579708116041303</c:v>
                  </c:pt>
                  <c:pt idx="1">
                    <c:v>10.60911342969808</c:v>
                  </c:pt>
                  <c:pt idx="2">
                    <c:v>9.7545437282174472</c:v>
                  </c:pt>
                  <c:pt idx="3">
                    <c:v>14.913404974947468</c:v>
                  </c:pt>
                  <c:pt idx="4">
                    <c:v>34.7770891676730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4:$F$24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26:$F$26</c:f>
              <c:numCache>
                <c:formatCode>General</c:formatCode>
                <c:ptCount val="5"/>
                <c:pt idx="0">
                  <c:v>447.20248366682335</c:v>
                </c:pt>
                <c:pt idx="1">
                  <c:v>105.2805866395461</c:v>
                </c:pt>
                <c:pt idx="2">
                  <c:v>107.08339049135586</c:v>
                </c:pt>
                <c:pt idx="3">
                  <c:v>208.36319534721127</c:v>
                </c:pt>
                <c:pt idx="4">
                  <c:v>363.546502652972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AF-47C5-BAB4-62D5C886DF40}"/>
            </c:ext>
          </c:extLst>
        </c:ser>
        <c:ser>
          <c:idx val="1"/>
          <c:order val="1"/>
          <c:tx>
            <c:strRef>
              <c:f>shoots!$A$27</c:f>
              <c:strCache>
                <c:ptCount val="1"/>
                <c:pt idx="0">
                  <c:v>ARN176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34:$F$34</c:f>
                <c:numCache>
                  <c:formatCode>General</c:formatCode>
                  <c:ptCount val="5"/>
                  <c:pt idx="0">
                    <c:v>18.772133305596842</c:v>
                  </c:pt>
                  <c:pt idx="1">
                    <c:v>1.8497763104588838</c:v>
                  </c:pt>
                  <c:pt idx="2">
                    <c:v>6.6732495604829252</c:v>
                  </c:pt>
                  <c:pt idx="3">
                    <c:v>19.673861761040762</c:v>
                  </c:pt>
                  <c:pt idx="4">
                    <c:v>14.27125895969737</c:v>
                  </c:pt>
                </c:numCache>
              </c:numRef>
            </c:plus>
            <c:minus>
              <c:numRef>
                <c:f>shoots!$B$34:$F$34</c:f>
                <c:numCache>
                  <c:formatCode>General</c:formatCode>
                  <c:ptCount val="5"/>
                  <c:pt idx="0">
                    <c:v>18.772133305596842</c:v>
                  </c:pt>
                  <c:pt idx="1">
                    <c:v>1.8497763104588838</c:v>
                  </c:pt>
                  <c:pt idx="2">
                    <c:v>6.6732495604829252</c:v>
                  </c:pt>
                  <c:pt idx="3">
                    <c:v>19.673861761040762</c:v>
                  </c:pt>
                  <c:pt idx="4">
                    <c:v>14.271258959697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4:$F$24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27:$F$27</c:f>
              <c:numCache>
                <c:formatCode>General</c:formatCode>
                <c:ptCount val="5"/>
                <c:pt idx="0">
                  <c:v>350.0082034762666</c:v>
                </c:pt>
                <c:pt idx="1">
                  <c:v>44.834353895688089</c:v>
                </c:pt>
                <c:pt idx="2">
                  <c:v>54.025862940584283</c:v>
                </c:pt>
                <c:pt idx="3">
                  <c:v>159.6876298798467</c:v>
                </c:pt>
                <c:pt idx="4">
                  <c:v>251.142193783260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AF-47C5-BAB4-62D5C886DF40}"/>
            </c:ext>
          </c:extLst>
        </c:ser>
        <c:ser>
          <c:idx val="2"/>
          <c:order val="2"/>
          <c:tx>
            <c:strRef>
              <c:f>shoots!$A$28</c:f>
              <c:strCache>
                <c:ptCount val="1"/>
                <c:pt idx="0">
                  <c:v>1.5R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35:$F$35</c:f>
                <c:numCache>
                  <c:formatCode>General</c:formatCode>
                  <c:ptCount val="5"/>
                  <c:pt idx="0">
                    <c:v>16.253776079297634</c:v>
                  </c:pt>
                  <c:pt idx="1">
                    <c:v>2.8845237999730262</c:v>
                  </c:pt>
                  <c:pt idx="2">
                    <c:v>15.513640911596621</c:v>
                  </c:pt>
                  <c:pt idx="3">
                    <c:v>55.381956667180887</c:v>
                  </c:pt>
                  <c:pt idx="4">
                    <c:v>14.977260204637059</c:v>
                  </c:pt>
                </c:numCache>
              </c:numRef>
            </c:plus>
            <c:minus>
              <c:numRef>
                <c:f>shoots!$B$35:$F$35</c:f>
                <c:numCache>
                  <c:formatCode>General</c:formatCode>
                  <c:ptCount val="5"/>
                  <c:pt idx="0">
                    <c:v>16.253776079297634</c:v>
                  </c:pt>
                  <c:pt idx="1">
                    <c:v>2.8845237999730262</c:v>
                  </c:pt>
                  <c:pt idx="2">
                    <c:v>15.513640911596621</c:v>
                  </c:pt>
                  <c:pt idx="3">
                    <c:v>55.381956667180887</c:v>
                  </c:pt>
                  <c:pt idx="4">
                    <c:v>14.9772602046370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4:$F$24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28:$F$28</c:f>
              <c:numCache>
                <c:formatCode>General</c:formatCode>
                <c:ptCount val="5"/>
                <c:pt idx="0">
                  <c:v>418.02575774105253</c:v>
                </c:pt>
                <c:pt idx="1">
                  <c:v>72.86246002517079</c:v>
                </c:pt>
                <c:pt idx="2">
                  <c:v>72.092099133739836</c:v>
                </c:pt>
                <c:pt idx="3">
                  <c:v>279.48745405292613</c:v>
                </c:pt>
                <c:pt idx="4">
                  <c:v>356.10555326062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7AF-47C5-BAB4-62D5C886DF40}"/>
            </c:ext>
          </c:extLst>
        </c:ser>
        <c:ser>
          <c:idx val="3"/>
          <c:order val="3"/>
          <c:tx>
            <c:strRef>
              <c:f>shoots!$A$29</c:f>
              <c:strCache>
                <c:ptCount val="1"/>
                <c:pt idx="0">
                  <c:v>SA35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B$36:$F$36</c:f>
                <c:numCache>
                  <c:formatCode>General</c:formatCode>
                  <c:ptCount val="5"/>
                  <c:pt idx="0">
                    <c:v>13.499284022444272</c:v>
                  </c:pt>
                  <c:pt idx="1">
                    <c:v>3.3707525144015351</c:v>
                  </c:pt>
                  <c:pt idx="2">
                    <c:v>8.8294694503532867</c:v>
                  </c:pt>
                  <c:pt idx="3">
                    <c:v>48.661690637052821</c:v>
                  </c:pt>
                  <c:pt idx="4">
                    <c:v>14.026360577121688</c:v>
                  </c:pt>
                </c:numCache>
              </c:numRef>
            </c:plus>
            <c:minus>
              <c:numRef>
                <c:f>shoots!$B$36:$F$36</c:f>
                <c:numCache>
                  <c:formatCode>General</c:formatCode>
                  <c:ptCount val="5"/>
                  <c:pt idx="0">
                    <c:v>13.499284022444272</c:v>
                  </c:pt>
                  <c:pt idx="1">
                    <c:v>3.3707525144015351</c:v>
                  </c:pt>
                  <c:pt idx="2">
                    <c:v>8.8294694503532867</c:v>
                  </c:pt>
                  <c:pt idx="3">
                    <c:v>48.661690637052821</c:v>
                  </c:pt>
                  <c:pt idx="4">
                    <c:v>14.0263605771216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B$24:$F$24</c:f>
              <c:strCache>
                <c:ptCount val="5"/>
                <c:pt idx="0">
                  <c:v>Zn</c:v>
                </c:pt>
                <c:pt idx="1">
                  <c:v>Cd</c:v>
                </c:pt>
                <c:pt idx="2">
                  <c:v>Pb</c:v>
                </c:pt>
                <c:pt idx="3">
                  <c:v>Fe</c:v>
                </c:pt>
                <c:pt idx="4">
                  <c:v>Mn</c:v>
                </c:pt>
              </c:strCache>
            </c:strRef>
          </c:cat>
          <c:val>
            <c:numRef>
              <c:f>shoots!$B$29:$F$29</c:f>
              <c:numCache>
                <c:formatCode>General</c:formatCode>
                <c:ptCount val="5"/>
                <c:pt idx="0">
                  <c:v>386.73896619949772</c:v>
                </c:pt>
                <c:pt idx="1">
                  <c:v>64.62314417730515</c:v>
                </c:pt>
                <c:pt idx="2">
                  <c:v>65.615288897697269</c:v>
                </c:pt>
                <c:pt idx="3">
                  <c:v>276.58098576091118</c:v>
                </c:pt>
                <c:pt idx="4">
                  <c:v>360.096492147572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7AF-47C5-BAB4-62D5C886DF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0388760"/>
        <c:axId val="570390400"/>
      </c:barChart>
      <c:catAx>
        <c:axId val="570388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70390400"/>
        <c:crosses val="autoZero"/>
        <c:auto val="1"/>
        <c:lblAlgn val="ctr"/>
        <c:lblOffset val="100"/>
        <c:noMultiLvlLbl val="0"/>
      </c:catAx>
      <c:valAx>
        <c:axId val="5703904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mg kg-1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70388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oots!$Q$4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R$12:$S$12</c:f>
                <c:numCache>
                  <c:formatCode>General</c:formatCode>
                  <c:ptCount val="2"/>
                  <c:pt idx="0">
                    <c:v>0.40698165945044357</c:v>
                  </c:pt>
                  <c:pt idx="1">
                    <c:v>0.52687139596670196</c:v>
                  </c:pt>
                </c:numCache>
              </c:numRef>
            </c:plus>
            <c:minus>
              <c:numRef>
                <c:f>shoots!$R$12:$S$12</c:f>
                <c:numCache>
                  <c:formatCode>General</c:formatCode>
                  <c:ptCount val="2"/>
                  <c:pt idx="0">
                    <c:v>0.40698165945044357</c:v>
                  </c:pt>
                  <c:pt idx="1">
                    <c:v>0.526871395966701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R$2:$S$2</c:f>
              <c:strCache>
                <c:ptCount val="2"/>
                <c:pt idx="0">
                  <c:v>N. caerulescens</c:v>
                </c:pt>
                <c:pt idx="1">
                  <c:v>B. napus</c:v>
                </c:pt>
              </c:strCache>
            </c:strRef>
          </c:cat>
          <c:val>
            <c:numRef>
              <c:f>shoots!$R$4:$S$4</c:f>
              <c:numCache>
                <c:formatCode>General</c:formatCode>
                <c:ptCount val="2"/>
                <c:pt idx="0">
                  <c:v>1.4670266118480664</c:v>
                </c:pt>
                <c:pt idx="1">
                  <c:v>14.5444265178323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5E-45B4-B5BD-5FC62A2187BA}"/>
            </c:ext>
          </c:extLst>
        </c:ser>
        <c:ser>
          <c:idx val="1"/>
          <c:order val="1"/>
          <c:tx>
            <c:strRef>
              <c:f>shoots!$Q$5</c:f>
              <c:strCache>
                <c:ptCount val="1"/>
                <c:pt idx="0">
                  <c:v>ARN176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R$13:$S$13</c:f>
                <c:numCache>
                  <c:formatCode>General</c:formatCode>
                  <c:ptCount val="2"/>
                  <c:pt idx="0">
                    <c:v>1.5757766319023583</c:v>
                  </c:pt>
                  <c:pt idx="1">
                    <c:v>0.5915257399116175</c:v>
                  </c:pt>
                </c:numCache>
              </c:numRef>
            </c:plus>
            <c:minus>
              <c:numRef>
                <c:f>shoots!$R$13:$S$13</c:f>
                <c:numCache>
                  <c:formatCode>General</c:formatCode>
                  <c:ptCount val="2"/>
                  <c:pt idx="0">
                    <c:v>1.5757766319023583</c:v>
                  </c:pt>
                  <c:pt idx="1">
                    <c:v>0.59152573991161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R$2:$S$2</c:f>
              <c:strCache>
                <c:ptCount val="2"/>
                <c:pt idx="0">
                  <c:v>N. caerulescens</c:v>
                </c:pt>
                <c:pt idx="1">
                  <c:v>B. napus</c:v>
                </c:pt>
              </c:strCache>
            </c:strRef>
          </c:cat>
          <c:val>
            <c:numRef>
              <c:f>shoots!$R$5:$S$5</c:f>
              <c:numCache>
                <c:formatCode>General</c:formatCode>
                <c:ptCount val="2"/>
                <c:pt idx="0">
                  <c:v>3.3394692665162977</c:v>
                </c:pt>
                <c:pt idx="1">
                  <c:v>12.4399404755056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5E-45B4-B5BD-5FC62A2187BA}"/>
            </c:ext>
          </c:extLst>
        </c:ser>
        <c:ser>
          <c:idx val="2"/>
          <c:order val="2"/>
          <c:tx>
            <c:strRef>
              <c:f>shoots!$Q$6</c:f>
              <c:strCache>
                <c:ptCount val="1"/>
                <c:pt idx="0">
                  <c:v>1.5R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R$14:$S$14</c:f>
                <c:numCache>
                  <c:formatCode>General</c:formatCode>
                  <c:ptCount val="2"/>
                  <c:pt idx="0">
                    <c:v>0.43526107095062294</c:v>
                  </c:pt>
                  <c:pt idx="1">
                    <c:v>0.5215644635589427</c:v>
                  </c:pt>
                </c:numCache>
              </c:numRef>
            </c:plus>
            <c:minus>
              <c:numRef>
                <c:f>shoots!$R$14:$S$14</c:f>
                <c:numCache>
                  <c:formatCode>General</c:formatCode>
                  <c:ptCount val="2"/>
                  <c:pt idx="0">
                    <c:v>0.43526107095062294</c:v>
                  </c:pt>
                  <c:pt idx="1">
                    <c:v>0.52156446355894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R$2:$S$2</c:f>
              <c:strCache>
                <c:ptCount val="2"/>
                <c:pt idx="0">
                  <c:v>N. caerulescens</c:v>
                </c:pt>
                <c:pt idx="1">
                  <c:v>B. napus</c:v>
                </c:pt>
              </c:strCache>
            </c:strRef>
          </c:cat>
          <c:val>
            <c:numRef>
              <c:f>shoots!$R$6:$S$6</c:f>
              <c:numCache>
                <c:formatCode>General</c:formatCode>
                <c:ptCount val="2"/>
                <c:pt idx="0">
                  <c:v>3.2608255426626584</c:v>
                </c:pt>
                <c:pt idx="1">
                  <c:v>14.949298566145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85E-45B4-B5BD-5FC62A2187BA}"/>
            </c:ext>
          </c:extLst>
        </c:ser>
        <c:ser>
          <c:idx val="3"/>
          <c:order val="3"/>
          <c:tx>
            <c:strRef>
              <c:f>shoots!$Q$7</c:f>
              <c:strCache>
                <c:ptCount val="1"/>
                <c:pt idx="0">
                  <c:v>SA35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oots!$R$15:$S$15</c:f>
                <c:numCache>
                  <c:formatCode>General</c:formatCode>
                  <c:ptCount val="2"/>
                  <c:pt idx="0">
                    <c:v>0.28970757624093729</c:v>
                  </c:pt>
                  <c:pt idx="1">
                    <c:v>0.31578411142062324</c:v>
                  </c:pt>
                </c:numCache>
              </c:numRef>
            </c:plus>
            <c:minus>
              <c:numRef>
                <c:f>shoots!$R$15:$S$15</c:f>
                <c:numCache>
                  <c:formatCode>General</c:formatCode>
                  <c:ptCount val="2"/>
                  <c:pt idx="0">
                    <c:v>0.28970757624093729</c:v>
                  </c:pt>
                  <c:pt idx="1">
                    <c:v>0.315784111420623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oots!$R$2:$S$2</c:f>
              <c:strCache>
                <c:ptCount val="2"/>
                <c:pt idx="0">
                  <c:v>N. caerulescens</c:v>
                </c:pt>
                <c:pt idx="1">
                  <c:v>B. napus</c:v>
                </c:pt>
              </c:strCache>
            </c:strRef>
          </c:cat>
          <c:val>
            <c:numRef>
              <c:f>shoots!$R$7:$S$7</c:f>
              <c:numCache>
                <c:formatCode>General</c:formatCode>
                <c:ptCount val="2"/>
                <c:pt idx="0">
                  <c:v>1.7813745933339418</c:v>
                </c:pt>
                <c:pt idx="1">
                  <c:v>15.0688828878913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85E-45B4-B5BD-5FC62A2187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0327752"/>
        <c:axId val="570328736"/>
      </c:barChart>
      <c:catAx>
        <c:axId val="570327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70328736"/>
        <c:crosses val="autoZero"/>
        <c:auto val="1"/>
        <c:lblAlgn val="ctr"/>
        <c:lblOffset val="100"/>
        <c:noMultiLvlLbl val="0"/>
      </c:catAx>
      <c:valAx>
        <c:axId val="5703287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Copper 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703277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Brassica roots'!$A$54</c:f>
              <c:strCache>
                <c:ptCount val="1"/>
                <c:pt idx="0">
                  <c:v>NC 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0:$G$60</c15:sqref>
                    </c15:fullRef>
                  </c:ext>
                </c:extLst>
                <c:f>('Brassica roots'!$B$60:$C$60,'Brassica roots'!$E$60:$G$60)</c:f>
                <c:numCache>
                  <c:formatCode>General</c:formatCode>
                  <c:ptCount val="5"/>
                  <c:pt idx="0">
                    <c:v>12.9674168227642</c:v>
                  </c:pt>
                  <c:pt idx="1">
                    <c:v>40.841305167479845</c:v>
                  </c:pt>
                  <c:pt idx="2">
                    <c:v>61.814872467479503</c:v>
                  </c:pt>
                  <c:pt idx="3">
                    <c:v>7.0640286365853617</c:v>
                  </c:pt>
                  <c:pt idx="4">
                    <c:v>137.486024293496</c:v>
                  </c:pt>
                </c:numCache>
              </c:numRef>
            </c:plus>
            <c:min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0:$G$60</c15:sqref>
                    </c15:fullRef>
                  </c:ext>
                </c:extLst>
                <c:f>('Brassica roots'!$B$60:$C$60,'Brassica roots'!$E$60:$G$60)</c:f>
                <c:numCache>
                  <c:formatCode>General</c:formatCode>
                  <c:ptCount val="5"/>
                  <c:pt idx="0">
                    <c:v>12.9674168227642</c:v>
                  </c:pt>
                  <c:pt idx="1">
                    <c:v>40.841305167479845</c:v>
                  </c:pt>
                  <c:pt idx="2">
                    <c:v>61.814872467479503</c:v>
                  </c:pt>
                  <c:pt idx="3">
                    <c:v>7.0640286365853617</c:v>
                  </c:pt>
                  <c:pt idx="4">
                    <c:v>137.4860242934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extLst>
                <c:ext xmlns:c15="http://schemas.microsoft.com/office/drawing/2012/chart" uri="{02D57815-91ED-43cb-92C2-25804820EDAC}">
                  <c15:fullRef>
                    <c15:sqref>'Brassica roots'!$B$53:$G$53</c15:sqref>
                  </c15:fullRef>
                </c:ext>
              </c:extLst>
              <c:f>('Brassica roots'!$B$53:$C$53,'Brassica roots'!$E$53:$G$53)</c:f>
              <c:strCache>
                <c:ptCount val="5"/>
                <c:pt idx="0">
                  <c:v>Mn</c:v>
                </c:pt>
                <c:pt idx="1">
                  <c:v>Fe</c:v>
                </c:pt>
                <c:pt idx="2">
                  <c:v>Zn</c:v>
                </c:pt>
                <c:pt idx="3">
                  <c:v>Cd</c:v>
                </c:pt>
                <c:pt idx="4">
                  <c:v>Pb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'Brassica roots'!$B$54:$G$54</c15:sqref>
                  </c15:fullRef>
                </c:ext>
              </c:extLst>
              <c:f>('Brassica roots'!$B$54:$C$54,'Brassica roots'!$E$54:$G$54)</c:f>
              <c:numCache>
                <c:formatCode>General</c:formatCode>
                <c:ptCount val="5"/>
                <c:pt idx="0">
                  <c:v>487.62297697723591</c:v>
                </c:pt>
                <c:pt idx="1">
                  <c:v>1770.6856302325205</c:v>
                </c:pt>
                <c:pt idx="2">
                  <c:v>451.87028786747976</c:v>
                </c:pt>
                <c:pt idx="3">
                  <c:v>99.545769036585369</c:v>
                </c:pt>
                <c:pt idx="4">
                  <c:v>3064.80671830650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E5-4462-BBC7-E545C6E82C9D}"/>
            </c:ext>
          </c:extLst>
        </c:ser>
        <c:ser>
          <c:idx val="1"/>
          <c:order val="1"/>
          <c:tx>
            <c:strRef>
              <c:f>'Brassica roots'!$A$55</c:f>
              <c:strCache>
                <c:ptCount val="1"/>
                <c:pt idx="0">
                  <c:v>ARN176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5E5-4462-BBC7-E545C6E82C9D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B5E5-4462-BBC7-E545C6E82C9D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5E5-4462-BBC7-E545C6E82C9D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B5E5-4462-BBC7-E545C6E82C9D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B5E5-4462-BBC7-E545C6E82C9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1:$G$61</c15:sqref>
                    </c15:fullRef>
                  </c:ext>
                </c:extLst>
                <c:f>('Brassica roots'!$B$61:$C$61,'Brassica roots'!$E$61:$G$61)</c:f>
                <c:numCache>
                  <c:formatCode>General</c:formatCode>
                  <c:ptCount val="5"/>
                  <c:pt idx="0">
                    <c:v>5.3774938220631157</c:v>
                  </c:pt>
                  <c:pt idx="1">
                    <c:v>135.37369522433721</c:v>
                  </c:pt>
                  <c:pt idx="2">
                    <c:v>22.126341197177169</c:v>
                  </c:pt>
                  <c:pt idx="3">
                    <c:v>2.6757875021503668</c:v>
                  </c:pt>
                  <c:pt idx="4">
                    <c:v>68.343999927041622</c:v>
                  </c:pt>
                </c:numCache>
              </c:numRef>
            </c:plus>
            <c:min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1:$G$61</c15:sqref>
                    </c15:fullRef>
                  </c:ext>
                </c:extLst>
                <c:f>('Brassica roots'!$B$61:$C$61,'Brassica roots'!$E$61:$G$61)</c:f>
                <c:numCache>
                  <c:formatCode>General</c:formatCode>
                  <c:ptCount val="5"/>
                  <c:pt idx="0">
                    <c:v>5.3774938220631157</c:v>
                  </c:pt>
                  <c:pt idx="1">
                    <c:v>135.37369522433721</c:v>
                  </c:pt>
                  <c:pt idx="2">
                    <c:v>22.126341197177169</c:v>
                  </c:pt>
                  <c:pt idx="3">
                    <c:v>2.6757875021503668</c:v>
                  </c:pt>
                  <c:pt idx="4">
                    <c:v>68.3439999270416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extLst>
                <c:ext xmlns:c15="http://schemas.microsoft.com/office/drawing/2012/chart" uri="{02D57815-91ED-43cb-92C2-25804820EDAC}">
                  <c15:fullRef>
                    <c15:sqref>'Brassica roots'!$B$53:$G$53</c15:sqref>
                  </c15:fullRef>
                </c:ext>
              </c:extLst>
              <c:f>('Brassica roots'!$B$53:$C$53,'Brassica roots'!$E$53:$G$53)</c:f>
              <c:strCache>
                <c:ptCount val="5"/>
                <c:pt idx="0">
                  <c:v>Mn</c:v>
                </c:pt>
                <c:pt idx="1">
                  <c:v>Fe</c:v>
                </c:pt>
                <c:pt idx="2">
                  <c:v>Zn</c:v>
                </c:pt>
                <c:pt idx="3">
                  <c:v>Cd</c:v>
                </c:pt>
                <c:pt idx="4">
                  <c:v>Pb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'Brassica roots'!$B$55:$G$55</c15:sqref>
                  </c15:fullRef>
                </c:ext>
              </c:extLst>
              <c:f>('Brassica roots'!$B$55:$C$55,'Brassica roots'!$E$55:$G$55)</c:f>
              <c:numCache>
                <c:formatCode>General</c:formatCode>
                <c:ptCount val="5"/>
                <c:pt idx="0">
                  <c:v>297.88372249988288</c:v>
                </c:pt>
                <c:pt idx="1">
                  <c:v>1686.6480111487181</c:v>
                </c:pt>
                <c:pt idx="2">
                  <c:v>407.93939039115355</c:v>
                </c:pt>
                <c:pt idx="3">
                  <c:v>56.808120895414959</c:v>
                </c:pt>
                <c:pt idx="4">
                  <c:v>1796.5467806209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5E5-4462-BBC7-E545C6E82C9D}"/>
            </c:ext>
          </c:extLst>
        </c:ser>
        <c:ser>
          <c:idx val="2"/>
          <c:order val="2"/>
          <c:tx>
            <c:strRef>
              <c:f>'Brassica roots'!$A$56</c:f>
              <c:strCache>
                <c:ptCount val="1"/>
                <c:pt idx="0">
                  <c:v>1.5R 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2:$G$62</c15:sqref>
                    </c15:fullRef>
                  </c:ext>
                </c:extLst>
                <c:f>('Brassica roots'!$B$62:$C$62,'Brassica roots'!$E$62:$G$62)</c:f>
                <c:numCache>
                  <c:formatCode>General</c:formatCode>
                  <c:ptCount val="5"/>
                  <c:pt idx="0">
                    <c:v>32.860368527703571</c:v>
                  </c:pt>
                  <c:pt idx="1">
                    <c:v>254.80875017947716</c:v>
                  </c:pt>
                  <c:pt idx="2">
                    <c:v>13.397786138059812</c:v>
                  </c:pt>
                  <c:pt idx="3">
                    <c:v>7.085923529694262</c:v>
                  </c:pt>
                  <c:pt idx="4">
                    <c:v>22.715529306154618</c:v>
                  </c:pt>
                </c:numCache>
              </c:numRef>
            </c:plus>
            <c:min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2:$G$62</c15:sqref>
                    </c15:fullRef>
                  </c:ext>
                </c:extLst>
                <c:f>('Brassica roots'!$B$62:$C$62,'Brassica roots'!$E$62:$G$62)</c:f>
                <c:numCache>
                  <c:formatCode>General</c:formatCode>
                  <c:ptCount val="5"/>
                  <c:pt idx="0">
                    <c:v>32.860368527703571</c:v>
                  </c:pt>
                  <c:pt idx="1">
                    <c:v>254.80875017947716</c:v>
                  </c:pt>
                  <c:pt idx="2">
                    <c:v>13.397786138059812</c:v>
                  </c:pt>
                  <c:pt idx="3">
                    <c:v>7.085923529694262</c:v>
                  </c:pt>
                  <c:pt idx="4">
                    <c:v>22.7155293061546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extLst>
                <c:ext xmlns:c15="http://schemas.microsoft.com/office/drawing/2012/chart" uri="{02D57815-91ED-43cb-92C2-25804820EDAC}">
                  <c15:fullRef>
                    <c15:sqref>'Brassica roots'!$B$53:$G$53</c15:sqref>
                  </c15:fullRef>
                </c:ext>
              </c:extLst>
              <c:f>('Brassica roots'!$B$53:$C$53,'Brassica roots'!$E$53:$G$53)</c:f>
              <c:strCache>
                <c:ptCount val="5"/>
                <c:pt idx="0">
                  <c:v>Mn</c:v>
                </c:pt>
                <c:pt idx="1">
                  <c:v>Fe</c:v>
                </c:pt>
                <c:pt idx="2">
                  <c:v>Zn</c:v>
                </c:pt>
                <c:pt idx="3">
                  <c:v>Cd</c:v>
                </c:pt>
                <c:pt idx="4">
                  <c:v>Pb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'Brassica roots'!$B$56:$G$56</c15:sqref>
                  </c15:fullRef>
                </c:ext>
              </c:extLst>
              <c:f>('Brassica roots'!$B$56:$C$56,'Brassica roots'!$E$56:$G$56)</c:f>
              <c:numCache>
                <c:formatCode>General</c:formatCode>
                <c:ptCount val="5"/>
                <c:pt idx="0">
                  <c:v>456.04409560215288</c:v>
                </c:pt>
                <c:pt idx="1">
                  <c:v>1708.0719987089922</c:v>
                </c:pt>
                <c:pt idx="2">
                  <c:v>543.10490533189227</c:v>
                </c:pt>
                <c:pt idx="3">
                  <c:v>103.94500789092774</c:v>
                </c:pt>
                <c:pt idx="4">
                  <c:v>3148.94174758591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5E5-4462-BBC7-E545C6E82C9D}"/>
            </c:ext>
          </c:extLst>
        </c:ser>
        <c:ser>
          <c:idx val="3"/>
          <c:order val="3"/>
          <c:tx>
            <c:strRef>
              <c:f>'Brassica roots'!$A$57</c:f>
              <c:strCache>
                <c:ptCount val="1"/>
                <c:pt idx="0">
                  <c:v>SA35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3:$G$63</c15:sqref>
                    </c15:fullRef>
                  </c:ext>
                </c:extLst>
                <c:f>('Brassica roots'!$B$63:$C$63,'Brassica roots'!$E$63:$G$63)</c:f>
                <c:numCache>
                  <c:formatCode>General</c:formatCode>
                  <c:ptCount val="5"/>
                  <c:pt idx="0">
                    <c:v>2.1153491261357544</c:v>
                  </c:pt>
                  <c:pt idx="1">
                    <c:v>583.20563205068504</c:v>
                  </c:pt>
                  <c:pt idx="2">
                    <c:v>34.533628375181479</c:v>
                  </c:pt>
                  <c:pt idx="3">
                    <c:v>7.8360138427217692</c:v>
                  </c:pt>
                  <c:pt idx="4">
                    <c:v>241.97395757106207</c:v>
                  </c:pt>
                </c:numCache>
              </c:numRef>
            </c:plus>
            <c:minus>
              <c:numRef>
                <c:extLst>
                  <c:ext xmlns:c15="http://schemas.microsoft.com/office/drawing/2012/chart" uri="{02D57815-91ED-43cb-92C2-25804820EDAC}">
                    <c15:fullRef>
                      <c15:sqref>'Brassica roots'!$B$63:$G$63</c15:sqref>
                    </c15:fullRef>
                  </c:ext>
                </c:extLst>
                <c:f>('Brassica roots'!$B$63:$C$63,'Brassica roots'!$E$63:$G$63)</c:f>
                <c:numCache>
                  <c:formatCode>General</c:formatCode>
                  <c:ptCount val="5"/>
                  <c:pt idx="0">
                    <c:v>2.1153491261357544</c:v>
                  </c:pt>
                  <c:pt idx="1">
                    <c:v>583.20563205068504</c:v>
                  </c:pt>
                  <c:pt idx="2">
                    <c:v>34.533628375181479</c:v>
                  </c:pt>
                  <c:pt idx="3">
                    <c:v>7.8360138427217692</c:v>
                  </c:pt>
                  <c:pt idx="4">
                    <c:v>241.973957571062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extLst>
                <c:ext xmlns:c15="http://schemas.microsoft.com/office/drawing/2012/chart" uri="{02D57815-91ED-43cb-92C2-25804820EDAC}">
                  <c15:fullRef>
                    <c15:sqref>'Brassica roots'!$B$53:$G$53</c15:sqref>
                  </c15:fullRef>
                </c:ext>
              </c:extLst>
              <c:f>('Brassica roots'!$B$53:$C$53,'Brassica roots'!$E$53:$G$53)</c:f>
              <c:strCache>
                <c:ptCount val="5"/>
                <c:pt idx="0">
                  <c:v>Mn</c:v>
                </c:pt>
                <c:pt idx="1">
                  <c:v>Fe</c:v>
                </c:pt>
                <c:pt idx="2">
                  <c:v>Zn</c:v>
                </c:pt>
                <c:pt idx="3">
                  <c:v>Cd</c:v>
                </c:pt>
                <c:pt idx="4">
                  <c:v>Pb</c:v>
                </c:pt>
              </c:strCache>
            </c:strRef>
          </c:cat>
          <c:val>
            <c:numRef>
              <c:extLst>
                <c:ext xmlns:c15="http://schemas.microsoft.com/office/drawing/2012/chart" uri="{02D57815-91ED-43cb-92C2-25804820EDAC}">
                  <c15:fullRef>
                    <c15:sqref>'Brassica roots'!$B$57:$G$57</c15:sqref>
                  </c15:fullRef>
                </c:ext>
              </c:extLst>
              <c:f>('Brassica roots'!$B$57:$C$57,'Brassica roots'!$E$57:$G$57)</c:f>
              <c:numCache>
                <c:formatCode>General</c:formatCode>
                <c:ptCount val="5"/>
                <c:pt idx="0">
                  <c:v>499.83663414011426</c:v>
                </c:pt>
                <c:pt idx="1">
                  <c:v>2166.0860347968146</c:v>
                </c:pt>
                <c:pt idx="2">
                  <c:v>553.84616188356858</c:v>
                </c:pt>
                <c:pt idx="3">
                  <c:v>105.56155540147178</c:v>
                </c:pt>
                <c:pt idx="4">
                  <c:v>2745.26341157643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5E5-4462-BBC7-E545C6E82C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501008952"/>
        <c:axId val="501014528"/>
      </c:barChart>
      <c:catAx>
        <c:axId val="5010089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1014528"/>
        <c:crosses val="autoZero"/>
        <c:auto val="1"/>
        <c:lblAlgn val="ctr"/>
        <c:lblOffset val="100"/>
        <c:noMultiLvlLbl val="0"/>
      </c:catAx>
      <c:valAx>
        <c:axId val="5010145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mg kg-1</a:t>
                </a:r>
              </a:p>
            </c:rich>
          </c:tx>
          <c:layout>
            <c:manualLayout>
              <c:xMode val="edge"/>
              <c:yMode val="edge"/>
              <c:x val="7.7080283819315927E-3"/>
              <c:y val="0.374690951171039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10089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M mob'!$O$1</c:f>
              <c:strCache>
                <c:ptCount val="1"/>
                <c:pt idx="0">
                  <c:v>Mn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ABD9-4003-8AEE-E51331B88CFA}"/>
              </c:ext>
            </c:extLst>
          </c:dPt>
          <c:dPt>
            <c:idx val="1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BD9-4003-8AEE-E51331B88CFA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ABD9-4003-8AEE-E51331B88CFA}"/>
              </c:ext>
            </c:extLst>
          </c:dPt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BD9-4003-8AEE-E51331B88CFA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ABD9-4003-8AEE-E51331B88CFA}"/>
              </c:ext>
            </c:extLst>
          </c:dPt>
          <c:dPt>
            <c:idx val="5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BD9-4003-8AEE-E51331B88CFA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ABD9-4003-8AEE-E51331B88CFA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BD9-4003-8AEE-E51331B88CFA}"/>
              </c:ext>
            </c:extLst>
          </c:dPt>
          <c:dPt>
            <c:idx val="8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ABD9-4003-8AEE-E51331B88CFA}"/>
              </c:ext>
            </c:extLst>
          </c:dPt>
          <c:dPt>
            <c:idx val="9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BD9-4003-8AEE-E51331B88CFA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ABD9-4003-8AEE-E51331B88CFA}"/>
              </c:ext>
            </c:extLst>
          </c:dPt>
          <c:dPt>
            <c:idx val="11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ABD9-4003-8AEE-E51331B88CFA}"/>
              </c:ext>
            </c:extLst>
          </c:dPt>
          <c:dPt>
            <c:idx val="12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ABD9-4003-8AEE-E51331B88CFA}"/>
              </c:ext>
            </c:extLst>
          </c:dPt>
          <c:dPt>
            <c:idx val="13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ABD9-4003-8AEE-E51331B88CFA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ABD9-4003-8AEE-E51331B88CFA}"/>
              </c:ext>
            </c:extLst>
          </c:dPt>
          <c:dPt>
            <c:idx val="15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ABD9-4003-8AEE-E51331B88CFA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ABD9-4003-8AEE-E51331B88CFA}"/>
              </c:ext>
            </c:extLst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ABD9-4003-8AEE-E51331B88CFA}"/>
              </c:ext>
            </c:extLst>
          </c:dPt>
          <c:dPt>
            <c:idx val="1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ABD9-4003-8AEE-E51331B88CFA}"/>
              </c:ext>
            </c:extLst>
          </c:dPt>
          <c:dPt>
            <c:idx val="19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ABD9-4003-8AEE-E51331B88CFA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6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ABD9-4003-8AEE-E51331B88CFA}"/>
              </c:ext>
            </c:extLst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ABD9-4003-8AEE-E51331B88CFA}"/>
              </c:ext>
            </c:extLst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ABD9-4003-8AEE-E51331B88CFA}"/>
              </c:ext>
            </c:extLst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ABD9-4003-8AEE-E51331B88CFA}"/>
              </c:ext>
            </c:extLst>
          </c:dPt>
          <c:dPt>
            <c:idx val="24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ABD9-4003-8AEE-E51331B88CFA}"/>
              </c:ext>
            </c:extLst>
          </c:dPt>
          <c:dPt>
            <c:idx val="25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ABD9-4003-8AEE-E51331B88CFA}"/>
              </c:ext>
            </c:extLst>
          </c:dPt>
          <c:dPt>
            <c:idx val="26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ABD9-4003-8AEE-E51331B88CFA}"/>
              </c:ext>
            </c:extLst>
          </c:dPt>
          <c:dPt>
            <c:idx val="27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ABD9-4003-8AEE-E51331B88CFA}"/>
              </c:ext>
            </c:extLst>
          </c:dPt>
          <c:dPt>
            <c:idx val="28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ABD9-4003-8AEE-E51331B88CFA}"/>
              </c:ext>
            </c:extLst>
          </c:dPt>
          <c:dPt>
            <c:idx val="29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BD9-4003-8AEE-E51331B88CFA}"/>
              </c:ext>
            </c:extLst>
          </c:dPt>
          <c:errBars>
            <c:errBarType val="both"/>
            <c:errValType val="cust"/>
            <c:noEndCap val="0"/>
            <c:plus>
              <c:numRef>
                <c:f>'HM mob'!$AE$3:$AE$32</c:f>
                <c:numCache>
                  <c:formatCode>General</c:formatCode>
                  <c:ptCount val="30"/>
                  <c:pt idx="0">
                    <c:v>0.1026310853322132</c:v>
                  </c:pt>
                  <c:pt idx="1">
                    <c:v>0.60282165256997611</c:v>
                  </c:pt>
                  <c:pt idx="2">
                    <c:v>0.18030010446767239</c:v>
                  </c:pt>
                  <c:pt idx="3">
                    <c:v>0.21428082545563301</c:v>
                  </c:pt>
                  <c:pt idx="4">
                    <c:v>6.729438231320109E-2</c:v>
                  </c:pt>
                  <c:pt idx="5">
                    <c:v>3.0252581474082614E-2</c:v>
                  </c:pt>
                  <c:pt idx="6">
                    <c:v>0.91871177196252618</c:v>
                  </c:pt>
                  <c:pt idx="7">
                    <c:v>0.45166091264236613</c:v>
                  </c:pt>
                  <c:pt idx="8">
                    <c:v>2.8308856245886158</c:v>
                  </c:pt>
                  <c:pt idx="9">
                    <c:v>0.18225993228101092</c:v>
                  </c:pt>
                  <c:pt idx="10">
                    <c:v>0.24854136343440306</c:v>
                  </c:pt>
                  <c:pt idx="11">
                    <c:v>1.7539121483050388</c:v>
                  </c:pt>
                  <c:pt idx="12">
                    <c:v>1.0721324528884253</c:v>
                  </c:pt>
                  <c:pt idx="13">
                    <c:v>0.15172826710234044</c:v>
                  </c:pt>
                  <c:pt idx="14">
                    <c:v>0.10455920218611489</c:v>
                  </c:pt>
                  <c:pt idx="15">
                    <c:v>0.12142488401754443</c:v>
                  </c:pt>
                  <c:pt idx="16">
                    <c:v>0.29349641490776918</c:v>
                  </c:pt>
                  <c:pt idx="17">
                    <c:v>1.1917748628320446</c:v>
                  </c:pt>
                  <c:pt idx="18">
                    <c:v>0.49123537676336887</c:v>
                  </c:pt>
                  <c:pt idx="19">
                    <c:v>6.5008055966331024E-2</c:v>
                  </c:pt>
                  <c:pt idx="21">
                    <c:v>0.15182260754697582</c:v>
                  </c:pt>
                  <c:pt idx="22">
                    <c:v>0.24187885131403944</c:v>
                  </c:pt>
                  <c:pt idx="23">
                    <c:v>9.2523036182808549E-2</c:v>
                  </c:pt>
                  <c:pt idx="24">
                    <c:v>8.4088989982555998E-2</c:v>
                  </c:pt>
                  <c:pt idx="25">
                    <c:v>0.25826148751804617</c:v>
                  </c:pt>
                  <c:pt idx="26">
                    <c:v>5.4836865916498008E-2</c:v>
                  </c:pt>
                  <c:pt idx="27">
                    <c:v>0.52198324631992044</c:v>
                  </c:pt>
                  <c:pt idx="28">
                    <c:v>1.5902977840135479</c:v>
                  </c:pt>
                  <c:pt idx="29">
                    <c:v>2.851313670150947E-2</c:v>
                  </c:pt>
                </c:numCache>
              </c:numRef>
            </c:plus>
            <c:minus>
              <c:numRef>
                <c:f>'HM mob'!$AE$3:$AE$32</c:f>
                <c:numCache>
                  <c:formatCode>General</c:formatCode>
                  <c:ptCount val="30"/>
                  <c:pt idx="0">
                    <c:v>0.1026310853322132</c:v>
                  </c:pt>
                  <c:pt idx="1">
                    <c:v>0.60282165256997611</c:v>
                  </c:pt>
                  <c:pt idx="2">
                    <c:v>0.18030010446767239</c:v>
                  </c:pt>
                  <c:pt idx="3">
                    <c:v>0.21428082545563301</c:v>
                  </c:pt>
                  <c:pt idx="4">
                    <c:v>6.729438231320109E-2</c:v>
                  </c:pt>
                  <c:pt idx="5">
                    <c:v>3.0252581474082614E-2</c:v>
                  </c:pt>
                  <c:pt idx="6">
                    <c:v>0.91871177196252618</c:v>
                  </c:pt>
                  <c:pt idx="7">
                    <c:v>0.45166091264236613</c:v>
                  </c:pt>
                  <c:pt idx="8">
                    <c:v>2.8308856245886158</c:v>
                  </c:pt>
                  <c:pt idx="9">
                    <c:v>0.18225993228101092</c:v>
                  </c:pt>
                  <c:pt idx="10">
                    <c:v>0.24854136343440306</c:v>
                  </c:pt>
                  <c:pt idx="11">
                    <c:v>1.7539121483050388</c:v>
                  </c:pt>
                  <c:pt idx="12">
                    <c:v>1.0721324528884253</c:v>
                  </c:pt>
                  <c:pt idx="13">
                    <c:v>0.15172826710234044</c:v>
                  </c:pt>
                  <c:pt idx="14">
                    <c:v>0.10455920218611489</c:v>
                  </c:pt>
                  <c:pt idx="15">
                    <c:v>0.12142488401754443</c:v>
                  </c:pt>
                  <c:pt idx="16">
                    <c:v>0.29349641490776918</c:v>
                  </c:pt>
                  <c:pt idx="17">
                    <c:v>1.1917748628320446</c:v>
                  </c:pt>
                  <c:pt idx="18">
                    <c:v>0.49123537676336887</c:v>
                  </c:pt>
                  <c:pt idx="19">
                    <c:v>6.5008055966331024E-2</c:v>
                  </c:pt>
                  <c:pt idx="21">
                    <c:v>0.15182260754697582</c:v>
                  </c:pt>
                  <c:pt idx="22">
                    <c:v>0.24187885131403944</c:v>
                  </c:pt>
                  <c:pt idx="23">
                    <c:v>9.2523036182808549E-2</c:v>
                  </c:pt>
                  <c:pt idx="24">
                    <c:v>8.4088989982555998E-2</c:v>
                  </c:pt>
                  <c:pt idx="25">
                    <c:v>0.25826148751804617</c:v>
                  </c:pt>
                  <c:pt idx="26">
                    <c:v>5.4836865916498008E-2</c:v>
                  </c:pt>
                  <c:pt idx="27">
                    <c:v>0.52198324631992044</c:v>
                  </c:pt>
                  <c:pt idx="28">
                    <c:v>1.5902977840135479</c:v>
                  </c:pt>
                  <c:pt idx="29">
                    <c:v>2.8513136701509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M mob'!$I$3:$I$32</c:f>
              <c:strCache>
                <c:ptCount val="30"/>
                <c:pt idx="0">
                  <c:v>ARN176</c:v>
                </c:pt>
                <c:pt idx="1">
                  <c:v> SA35</c:v>
                </c:pt>
                <c:pt idx="2">
                  <c:v> BEL4b</c:v>
                </c:pt>
                <c:pt idx="3">
                  <c:v>BEL156</c:v>
                </c:pt>
                <c:pt idx="4">
                  <c:v>BEL163</c:v>
                </c:pt>
                <c:pt idx="5">
                  <c:v>BEL125bM</c:v>
                </c:pt>
                <c:pt idx="6">
                  <c:v>EX104</c:v>
                </c:pt>
                <c:pt idx="7">
                  <c:v>EX72</c:v>
                </c:pt>
                <c:pt idx="8">
                  <c:v>SA5b</c:v>
                </c:pt>
                <c:pt idx="9">
                  <c:v>SA39</c:v>
                </c:pt>
                <c:pt idx="10">
                  <c:v>8.11S</c:v>
                </c:pt>
                <c:pt idx="11">
                  <c:v>444</c:v>
                </c:pt>
                <c:pt idx="12">
                  <c:v>DSM 23848</c:v>
                </c:pt>
                <c:pt idx="13">
                  <c:v>DSM 12966</c:v>
                </c:pt>
                <c:pt idx="14">
                  <c:v>DSM 18659</c:v>
                </c:pt>
                <c:pt idx="15">
                  <c:v>138</c:v>
                </c:pt>
                <c:pt idx="16">
                  <c:v>DSM 12510</c:v>
                </c:pt>
                <c:pt idx="17">
                  <c:v>280</c:v>
                </c:pt>
                <c:pt idx="18">
                  <c:v>DSM 13468</c:v>
                </c:pt>
                <c:pt idx="19">
                  <c:v>228</c:v>
                </c:pt>
                <c:pt idx="20">
                  <c:v>DSM 8608</c:v>
                </c:pt>
                <c:pt idx="21">
                  <c:v>P1-3</c:v>
                </c:pt>
                <c:pt idx="22">
                  <c:v>1.5R</c:v>
                </c:pt>
                <c:pt idx="23">
                  <c:v>8</c:v>
                </c:pt>
                <c:pt idx="24">
                  <c:v>8.4Sa</c:v>
                </c:pt>
                <c:pt idx="25">
                  <c:v>507</c:v>
                </c:pt>
                <c:pt idx="26">
                  <c:v>625</c:v>
                </c:pt>
                <c:pt idx="27">
                  <c:v>KO1</c:v>
                </c:pt>
                <c:pt idx="28">
                  <c:v>KO2</c:v>
                </c:pt>
                <c:pt idx="29">
                  <c:v>NC</c:v>
                </c:pt>
              </c:strCache>
            </c:strRef>
          </c:cat>
          <c:val>
            <c:numRef>
              <c:f>'HM mob'!$O$3:$O$32</c:f>
              <c:numCache>
                <c:formatCode>General</c:formatCode>
                <c:ptCount val="30"/>
                <c:pt idx="0">
                  <c:v>2.8811652245257924</c:v>
                </c:pt>
                <c:pt idx="1">
                  <c:v>22.85925914457636</c:v>
                </c:pt>
                <c:pt idx="2">
                  <c:v>10.214372624577594</c:v>
                </c:pt>
                <c:pt idx="3">
                  <c:v>3.8695834445531632</c:v>
                </c:pt>
                <c:pt idx="4">
                  <c:v>3.2179018444863341</c:v>
                </c:pt>
                <c:pt idx="5">
                  <c:v>8.021592763576324</c:v>
                </c:pt>
                <c:pt idx="6">
                  <c:v>11.955323540647468</c:v>
                </c:pt>
                <c:pt idx="7">
                  <c:v>15.904226627236048</c:v>
                </c:pt>
                <c:pt idx="8">
                  <c:v>12.726378698810478</c:v>
                </c:pt>
                <c:pt idx="9">
                  <c:v>5.5141262546236414</c:v>
                </c:pt>
                <c:pt idx="10">
                  <c:v>16.978022151832679</c:v>
                </c:pt>
                <c:pt idx="11">
                  <c:v>22.849025826317103</c:v>
                </c:pt>
                <c:pt idx="12">
                  <c:v>9.692626190051902</c:v>
                </c:pt>
                <c:pt idx="13">
                  <c:v>10.997664463081486</c:v>
                </c:pt>
                <c:pt idx="14">
                  <c:v>16.315189606414972</c:v>
                </c:pt>
                <c:pt idx="15">
                  <c:v>16.862270722260249</c:v>
                </c:pt>
                <c:pt idx="16">
                  <c:v>16.419702751088643</c:v>
                </c:pt>
                <c:pt idx="17">
                  <c:v>15.154413987924624</c:v>
                </c:pt>
                <c:pt idx="18">
                  <c:v>8.580809702190539</c:v>
                </c:pt>
                <c:pt idx="19">
                  <c:v>5.7686018785113129</c:v>
                </c:pt>
                <c:pt idx="20">
                  <c:v>4.1886992284313731</c:v>
                </c:pt>
                <c:pt idx="21">
                  <c:v>5.8612641288588314</c:v>
                </c:pt>
                <c:pt idx="22">
                  <c:v>22.41327028689469</c:v>
                </c:pt>
                <c:pt idx="23">
                  <c:v>10.27049428133874</c:v>
                </c:pt>
                <c:pt idx="24">
                  <c:v>17.963859462818007</c:v>
                </c:pt>
                <c:pt idx="25">
                  <c:v>7.0941178046388691</c:v>
                </c:pt>
                <c:pt idx="26">
                  <c:v>1.9494220890040397</c:v>
                </c:pt>
                <c:pt idx="27">
                  <c:v>10.330931237487736</c:v>
                </c:pt>
                <c:pt idx="28">
                  <c:v>6.5500510069548374</c:v>
                </c:pt>
                <c:pt idx="29">
                  <c:v>4.49390241613969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D9-4003-8AEE-E51331B88C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7251024"/>
        <c:axId val="337252992"/>
      </c:barChart>
      <c:catAx>
        <c:axId val="337251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7252992"/>
        <c:crosses val="autoZero"/>
        <c:auto val="1"/>
        <c:lblAlgn val="ctr"/>
        <c:lblOffset val="100"/>
        <c:noMultiLvlLbl val="0"/>
      </c:catAx>
      <c:valAx>
        <c:axId val="337252992"/>
        <c:scaling>
          <c:orientation val="minMax"/>
          <c:max val="2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Manganese 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7251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pH adjusted mediu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K$11:$K$17</c:f>
                <c:numCache>
                  <c:formatCode>General</c:formatCode>
                  <c:ptCount val="7"/>
                  <c:pt idx="0">
                    <c:v>6.481906000177573E-2</c:v>
                  </c:pt>
                  <c:pt idx="1">
                    <c:v>0.25303431327641429</c:v>
                  </c:pt>
                  <c:pt idx="2">
                    <c:v>0.12928799681476033</c:v>
                  </c:pt>
                  <c:pt idx="3">
                    <c:v>0.16846134253953488</c:v>
                  </c:pt>
                  <c:pt idx="4">
                    <c:v>0.24973997744486515</c:v>
                  </c:pt>
                  <c:pt idx="5">
                    <c:v>0.63645073401059238</c:v>
                  </c:pt>
                  <c:pt idx="6">
                    <c:v>3.0787932776718083</c:v>
                  </c:pt>
                </c:numCache>
              </c:numRef>
            </c:plus>
            <c:minus>
              <c:numRef>
                <c:f>pH!$K$11:$K$17</c:f>
                <c:numCache>
                  <c:formatCode>General</c:formatCode>
                  <c:ptCount val="7"/>
                  <c:pt idx="0">
                    <c:v>6.481906000177573E-2</c:v>
                  </c:pt>
                  <c:pt idx="1">
                    <c:v>0.25303431327641429</c:v>
                  </c:pt>
                  <c:pt idx="2">
                    <c:v>0.12928799681476033</c:v>
                  </c:pt>
                  <c:pt idx="3">
                    <c:v>0.16846134253953488</c:v>
                  </c:pt>
                  <c:pt idx="4">
                    <c:v>0.24973997744486515</c:v>
                  </c:pt>
                  <c:pt idx="5">
                    <c:v>0.63645073401059238</c:v>
                  </c:pt>
                  <c:pt idx="6">
                    <c:v>3.07879327767180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Q$2:$Q$8</c:f>
              <c:numCache>
                <c:formatCode>General</c:formatCode>
                <c:ptCount val="7"/>
                <c:pt idx="0">
                  <c:v>6.22</c:v>
                </c:pt>
                <c:pt idx="1">
                  <c:v>6.45</c:v>
                </c:pt>
                <c:pt idx="2">
                  <c:v>5.96</c:v>
                </c:pt>
                <c:pt idx="3">
                  <c:v>5.53</c:v>
                </c:pt>
                <c:pt idx="4">
                  <c:v>5.12</c:v>
                </c:pt>
                <c:pt idx="5">
                  <c:v>4.6500000000000004</c:v>
                </c:pt>
                <c:pt idx="6">
                  <c:v>4.09</c:v>
                </c:pt>
              </c:numCache>
            </c:numRef>
          </c:xVal>
          <c:yVal>
            <c:numRef>
              <c:f>pH!$K$2:$K$8</c:f>
              <c:numCache>
                <c:formatCode>General</c:formatCode>
                <c:ptCount val="7"/>
                <c:pt idx="0">
                  <c:v>3.2795263629791651</c:v>
                </c:pt>
                <c:pt idx="1">
                  <c:v>5.9971256735450433</c:v>
                </c:pt>
                <c:pt idx="2">
                  <c:v>6.3356280976356798</c:v>
                </c:pt>
                <c:pt idx="3">
                  <c:v>6.8632844708932348</c:v>
                </c:pt>
                <c:pt idx="4">
                  <c:v>12.348604411541148</c:v>
                </c:pt>
                <c:pt idx="5">
                  <c:v>19.039234843560077</c:v>
                </c:pt>
                <c:pt idx="6">
                  <c:v>41.2968465936088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295-4373-B1C2-40212C1B459B}"/>
            </c:ext>
          </c:extLst>
        </c:ser>
        <c:ser>
          <c:idx val="1"/>
          <c:order val="1"/>
          <c:tx>
            <c:v>isolate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B$35:$B$63</c:f>
                <c:numCache>
                  <c:formatCode>General</c:formatCode>
                  <c:ptCount val="29"/>
                  <c:pt idx="0">
                    <c:v>0.25037338486266486</c:v>
                  </c:pt>
                  <c:pt idx="1">
                    <c:v>1.6345634961888791</c:v>
                  </c:pt>
                  <c:pt idx="2">
                    <c:v>0.37982095316477049</c:v>
                  </c:pt>
                  <c:pt idx="3">
                    <c:v>0.34734054647030743</c:v>
                  </c:pt>
                  <c:pt idx="4">
                    <c:v>0.17410813366886127</c:v>
                  </c:pt>
                  <c:pt idx="5">
                    <c:v>0.12371196314694728</c:v>
                  </c:pt>
                  <c:pt idx="6">
                    <c:v>1.3276982259747712</c:v>
                  </c:pt>
                  <c:pt idx="7">
                    <c:v>0.32037480398709711</c:v>
                  </c:pt>
                  <c:pt idx="8">
                    <c:v>4.4084356852246147</c:v>
                  </c:pt>
                  <c:pt idx="9">
                    <c:v>9.1303721516707279E-2</c:v>
                  </c:pt>
                  <c:pt idx="10">
                    <c:v>0.29881384538738126</c:v>
                  </c:pt>
                  <c:pt idx="11">
                    <c:v>3.3858627367418559</c:v>
                  </c:pt>
                  <c:pt idx="12">
                    <c:v>1.9311782613075861</c:v>
                  </c:pt>
                  <c:pt idx="13">
                    <c:v>0.35710026846277249</c:v>
                  </c:pt>
                  <c:pt idx="14">
                    <c:v>0.22944850877244943</c:v>
                  </c:pt>
                  <c:pt idx="15">
                    <c:v>0.33181902800285473</c:v>
                  </c:pt>
                  <c:pt idx="16">
                    <c:v>0.77403754276838033</c:v>
                  </c:pt>
                  <c:pt idx="17">
                    <c:v>1.8018050002681616</c:v>
                  </c:pt>
                  <c:pt idx="18">
                    <c:v>0.55399381402230097</c:v>
                  </c:pt>
                  <c:pt idx="19">
                    <c:v>0.55898075719076856</c:v>
                  </c:pt>
                  <c:pt idx="21">
                    <c:v>0.29582379311497842</c:v>
                  </c:pt>
                  <c:pt idx="22">
                    <c:v>0.26745844599067747</c:v>
                  </c:pt>
                  <c:pt idx="23">
                    <c:v>8.3640837982243074E-2</c:v>
                  </c:pt>
                  <c:pt idx="24">
                    <c:v>0.64324367374446245</c:v>
                  </c:pt>
                  <c:pt idx="25">
                    <c:v>0.14808773201850761</c:v>
                  </c:pt>
                  <c:pt idx="26">
                    <c:v>5.8784124857207E-2</c:v>
                  </c:pt>
                  <c:pt idx="27">
                    <c:v>0.37701140480863499</c:v>
                  </c:pt>
                  <c:pt idx="28">
                    <c:v>0.64060625766635559</c:v>
                  </c:pt>
                </c:numCache>
              </c:numRef>
            </c:plus>
            <c:minus>
              <c:numRef>
                <c:f>pH!$B$35:$B$63</c:f>
                <c:numCache>
                  <c:formatCode>General</c:formatCode>
                  <c:ptCount val="29"/>
                  <c:pt idx="0">
                    <c:v>0.25037338486266486</c:v>
                  </c:pt>
                  <c:pt idx="1">
                    <c:v>1.6345634961888791</c:v>
                  </c:pt>
                  <c:pt idx="2">
                    <c:v>0.37982095316477049</c:v>
                  </c:pt>
                  <c:pt idx="3">
                    <c:v>0.34734054647030743</c:v>
                  </c:pt>
                  <c:pt idx="4">
                    <c:v>0.17410813366886127</c:v>
                  </c:pt>
                  <c:pt idx="5">
                    <c:v>0.12371196314694728</c:v>
                  </c:pt>
                  <c:pt idx="6">
                    <c:v>1.3276982259747712</c:v>
                  </c:pt>
                  <c:pt idx="7">
                    <c:v>0.32037480398709711</c:v>
                  </c:pt>
                  <c:pt idx="8">
                    <c:v>4.4084356852246147</c:v>
                  </c:pt>
                  <c:pt idx="9">
                    <c:v>9.1303721516707279E-2</c:v>
                  </c:pt>
                  <c:pt idx="10">
                    <c:v>0.29881384538738126</c:v>
                  </c:pt>
                  <c:pt idx="11">
                    <c:v>3.3858627367418559</c:v>
                  </c:pt>
                  <c:pt idx="12">
                    <c:v>1.9311782613075861</c:v>
                  </c:pt>
                  <c:pt idx="13">
                    <c:v>0.35710026846277249</c:v>
                  </c:pt>
                  <c:pt idx="14">
                    <c:v>0.22944850877244943</c:v>
                  </c:pt>
                  <c:pt idx="15">
                    <c:v>0.33181902800285473</c:v>
                  </c:pt>
                  <c:pt idx="16">
                    <c:v>0.77403754276838033</c:v>
                  </c:pt>
                  <c:pt idx="17">
                    <c:v>1.8018050002681616</c:v>
                  </c:pt>
                  <c:pt idx="18">
                    <c:v>0.55399381402230097</c:v>
                  </c:pt>
                  <c:pt idx="19">
                    <c:v>0.55898075719076856</c:v>
                  </c:pt>
                  <c:pt idx="21">
                    <c:v>0.29582379311497842</c:v>
                  </c:pt>
                  <c:pt idx="22">
                    <c:v>0.26745844599067747</c:v>
                  </c:pt>
                  <c:pt idx="23">
                    <c:v>8.3640837982243074E-2</c:v>
                  </c:pt>
                  <c:pt idx="24">
                    <c:v>0.64324367374446245</c:v>
                  </c:pt>
                  <c:pt idx="25">
                    <c:v>0.14808773201850761</c:v>
                  </c:pt>
                  <c:pt idx="26">
                    <c:v>5.8784124857207E-2</c:v>
                  </c:pt>
                  <c:pt idx="27">
                    <c:v>0.37701140480863499</c:v>
                  </c:pt>
                  <c:pt idx="28">
                    <c:v>0.640606257666355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H$3:$H$31</c:f>
              <c:numCache>
                <c:formatCode>General</c:formatCode>
                <c:ptCount val="29"/>
                <c:pt idx="0">
                  <c:v>7.9950000000000001</c:v>
                </c:pt>
                <c:pt idx="1">
                  <c:v>5.47</c:v>
                </c:pt>
                <c:pt idx="2">
                  <c:v>5.2149999999999999</c:v>
                </c:pt>
                <c:pt idx="3">
                  <c:v>7.9050000000000002</c:v>
                </c:pt>
                <c:pt idx="4">
                  <c:v>6.7649999999999997</c:v>
                </c:pt>
                <c:pt idx="5">
                  <c:v>5.5549999999999997</c:v>
                </c:pt>
                <c:pt idx="6">
                  <c:v>5.0199999999999996</c:v>
                </c:pt>
                <c:pt idx="7">
                  <c:v>4.6500000000000004</c:v>
                </c:pt>
                <c:pt idx="8">
                  <c:v>5.93</c:v>
                </c:pt>
                <c:pt idx="9">
                  <c:v>6.91</c:v>
                </c:pt>
                <c:pt idx="10">
                  <c:v>4.8250000000000002</c:v>
                </c:pt>
                <c:pt idx="11">
                  <c:v>5.49</c:v>
                </c:pt>
                <c:pt idx="12">
                  <c:v>5.3599999999999994</c:v>
                </c:pt>
                <c:pt idx="13">
                  <c:v>4.9550000000000001</c:v>
                </c:pt>
                <c:pt idx="14">
                  <c:v>4.5149999999999997</c:v>
                </c:pt>
                <c:pt idx="15">
                  <c:v>4.7450000000000001</c:v>
                </c:pt>
                <c:pt idx="16">
                  <c:v>4.38</c:v>
                </c:pt>
                <c:pt idx="17">
                  <c:v>4.51</c:v>
                </c:pt>
                <c:pt idx="18">
                  <c:v>6.0350000000000001</c:v>
                </c:pt>
                <c:pt idx="19">
                  <c:v>5.48</c:v>
                </c:pt>
                <c:pt idx="20">
                  <c:v>6.16</c:v>
                </c:pt>
                <c:pt idx="21">
                  <c:v>5.7249999999999996</c:v>
                </c:pt>
                <c:pt idx="22">
                  <c:v>4.7750000000000004</c:v>
                </c:pt>
                <c:pt idx="23">
                  <c:v>4.9749999999999996</c:v>
                </c:pt>
                <c:pt idx="24">
                  <c:v>4.68</c:v>
                </c:pt>
                <c:pt idx="25">
                  <c:v>7.08</c:v>
                </c:pt>
                <c:pt idx="26">
                  <c:v>6.0600000000000005</c:v>
                </c:pt>
                <c:pt idx="27">
                  <c:v>5.71</c:v>
                </c:pt>
                <c:pt idx="28">
                  <c:v>6.69</c:v>
                </c:pt>
              </c:numCache>
            </c:numRef>
          </c:xVal>
          <c:yVal>
            <c:numRef>
              <c:f>pH!$B$3:$B$31</c:f>
              <c:numCache>
                <c:formatCode>General</c:formatCode>
                <c:ptCount val="29"/>
                <c:pt idx="0">
                  <c:v>4.22081238836192</c:v>
                </c:pt>
                <c:pt idx="1">
                  <c:v>32.517777614926104</c:v>
                </c:pt>
                <c:pt idx="2">
                  <c:v>8.3518146628471026</c:v>
                </c:pt>
                <c:pt idx="3">
                  <c:v>3.5264519977168951</c:v>
                </c:pt>
                <c:pt idx="4">
                  <c:v>2.6120017939520102</c:v>
                </c:pt>
                <c:pt idx="5">
                  <c:v>9.0914300758924274</c:v>
                </c:pt>
                <c:pt idx="6">
                  <c:v>16.113009832887148</c:v>
                </c:pt>
                <c:pt idx="7">
                  <c:v>20.20170887818399</c:v>
                </c:pt>
                <c:pt idx="8">
                  <c:v>15.565488572723815</c:v>
                </c:pt>
                <c:pt idx="9">
                  <c:v>3.8541786877612041</c:v>
                </c:pt>
                <c:pt idx="10">
                  <c:v>17.700565980260677</c:v>
                </c:pt>
                <c:pt idx="11">
                  <c:v>15.696039183852946</c:v>
                </c:pt>
                <c:pt idx="12">
                  <c:v>11.065916826582052</c:v>
                </c:pt>
                <c:pt idx="13">
                  <c:v>13.313466437405509</c:v>
                </c:pt>
                <c:pt idx="14">
                  <c:v>19.487222180749676</c:v>
                </c:pt>
                <c:pt idx="15">
                  <c:v>24.305193775052786</c:v>
                </c:pt>
                <c:pt idx="16">
                  <c:v>20.504214643554505</c:v>
                </c:pt>
                <c:pt idx="17">
                  <c:v>17.196665447937729</c:v>
                </c:pt>
                <c:pt idx="18">
                  <c:v>9.4525954277640913</c:v>
                </c:pt>
                <c:pt idx="19">
                  <c:v>3.8922483377328834</c:v>
                </c:pt>
                <c:pt idx="20">
                  <c:v>2.774249108823529</c:v>
                </c:pt>
                <c:pt idx="21">
                  <c:v>4.8740958953800702</c:v>
                </c:pt>
                <c:pt idx="22">
                  <c:v>43.022040028649435</c:v>
                </c:pt>
                <c:pt idx="23">
                  <c:v>9.1735701076503293</c:v>
                </c:pt>
                <c:pt idx="24">
                  <c:v>18.171459512557082</c:v>
                </c:pt>
                <c:pt idx="25">
                  <c:v>5.0800069092336733</c:v>
                </c:pt>
                <c:pt idx="26">
                  <c:v>2.7231860100850827</c:v>
                </c:pt>
                <c:pt idx="27">
                  <c:v>8.4514597266928355</c:v>
                </c:pt>
                <c:pt idx="28">
                  <c:v>7.39973036836972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295-4373-B1C2-40212C1B45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2493464"/>
        <c:axId val="342487232"/>
      </c:scatterChart>
      <c:valAx>
        <c:axId val="342493464"/>
        <c:scaling>
          <c:orientation val="minMax"/>
          <c:max val="8.5"/>
          <c:min val="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87232"/>
        <c:crosses val="autoZero"/>
        <c:crossBetween val="midCat"/>
      </c:valAx>
      <c:valAx>
        <c:axId val="342487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Zinc 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934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pH adjusted mediu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L$11:$L$17</c:f>
                <c:numCache>
                  <c:formatCode>General</c:formatCode>
                  <c:ptCount val="7"/>
                  <c:pt idx="0">
                    <c:v>5.4860198932569866E-3</c:v>
                  </c:pt>
                  <c:pt idx="1">
                    <c:v>1.9787959366205598E-2</c:v>
                  </c:pt>
                  <c:pt idx="2">
                    <c:v>7.251082099136991E-3</c:v>
                  </c:pt>
                  <c:pt idx="3">
                    <c:v>8.6295756569333817E-2</c:v>
                  </c:pt>
                  <c:pt idx="4">
                    <c:v>2.8685707395510331E-2</c:v>
                  </c:pt>
                  <c:pt idx="5">
                    <c:v>6.7220082910808887E-2</c:v>
                  </c:pt>
                  <c:pt idx="6">
                    <c:v>0.34991477755436284</c:v>
                  </c:pt>
                </c:numCache>
              </c:numRef>
            </c:plus>
            <c:minus>
              <c:numRef>
                <c:f>pH!$L$11:$L$17</c:f>
                <c:numCache>
                  <c:formatCode>General</c:formatCode>
                  <c:ptCount val="7"/>
                  <c:pt idx="0">
                    <c:v>5.4860198932569866E-3</c:v>
                  </c:pt>
                  <c:pt idx="1">
                    <c:v>1.9787959366205598E-2</c:v>
                  </c:pt>
                  <c:pt idx="2">
                    <c:v>7.251082099136991E-3</c:v>
                  </c:pt>
                  <c:pt idx="3">
                    <c:v>8.6295756569333817E-2</c:v>
                  </c:pt>
                  <c:pt idx="4">
                    <c:v>2.8685707395510331E-2</c:v>
                  </c:pt>
                  <c:pt idx="5">
                    <c:v>6.7220082910808887E-2</c:v>
                  </c:pt>
                  <c:pt idx="6">
                    <c:v>0.349914777554362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Q$2:$Q$8</c:f>
              <c:numCache>
                <c:formatCode>General</c:formatCode>
                <c:ptCount val="7"/>
                <c:pt idx="0">
                  <c:v>6.22</c:v>
                </c:pt>
                <c:pt idx="1">
                  <c:v>6.45</c:v>
                </c:pt>
                <c:pt idx="2">
                  <c:v>5.96</c:v>
                </c:pt>
                <c:pt idx="3">
                  <c:v>5.53</c:v>
                </c:pt>
                <c:pt idx="4">
                  <c:v>5.12</c:v>
                </c:pt>
                <c:pt idx="5">
                  <c:v>4.6500000000000004</c:v>
                </c:pt>
                <c:pt idx="6">
                  <c:v>4.09</c:v>
                </c:pt>
              </c:numCache>
            </c:numRef>
          </c:xVal>
          <c:yVal>
            <c:numRef>
              <c:f>pH!$L$2:$L$8</c:f>
              <c:numCache>
                <c:formatCode>General</c:formatCode>
                <c:ptCount val="7"/>
                <c:pt idx="0">
                  <c:v>0.2622406547881253</c:v>
                </c:pt>
                <c:pt idx="1">
                  <c:v>0.66456402550763516</c:v>
                </c:pt>
                <c:pt idx="2">
                  <c:v>0.72900867738909281</c:v>
                </c:pt>
                <c:pt idx="3">
                  <c:v>3.528487693522484</c:v>
                </c:pt>
                <c:pt idx="4">
                  <c:v>1.4235954940534279</c:v>
                </c:pt>
                <c:pt idx="5">
                  <c:v>2.3370252994821006</c:v>
                </c:pt>
                <c:pt idx="6">
                  <c:v>5.06582583709528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86A-47E3-82D6-96116D374C19}"/>
            </c:ext>
          </c:extLst>
        </c:ser>
        <c:ser>
          <c:idx val="1"/>
          <c:order val="1"/>
          <c:tx>
            <c:v>isolate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C$35:$C$63</c:f>
                <c:numCache>
                  <c:formatCode>General</c:formatCode>
                  <c:ptCount val="29"/>
                  <c:pt idx="0">
                    <c:v>1.0953844766489747E-2</c:v>
                  </c:pt>
                  <c:pt idx="1">
                    <c:v>7.603397243775975E-2</c:v>
                  </c:pt>
                  <c:pt idx="2">
                    <c:v>1.5729105827457606E-2</c:v>
                  </c:pt>
                  <c:pt idx="3">
                    <c:v>4.2087090247043449E-2</c:v>
                  </c:pt>
                  <c:pt idx="4">
                    <c:v>1.4511027627947527E-2</c:v>
                  </c:pt>
                  <c:pt idx="5">
                    <c:v>5.4175594587318873E-3</c:v>
                  </c:pt>
                  <c:pt idx="6">
                    <c:v>2.36037616295963E-2</c:v>
                  </c:pt>
                  <c:pt idx="7">
                    <c:v>1.7031116571270204E-2</c:v>
                  </c:pt>
                  <c:pt idx="8">
                    <c:v>0.300108212203956</c:v>
                  </c:pt>
                  <c:pt idx="9">
                    <c:v>7.8484418269209513E-3</c:v>
                  </c:pt>
                  <c:pt idx="10">
                    <c:v>1.5546446093876455E-2</c:v>
                  </c:pt>
                  <c:pt idx="11">
                    <c:v>0.17777310326119306</c:v>
                  </c:pt>
                  <c:pt idx="12">
                    <c:v>0.14153094305718772</c:v>
                  </c:pt>
                  <c:pt idx="13">
                    <c:v>1.4381510185051948E-2</c:v>
                  </c:pt>
                  <c:pt idx="14">
                    <c:v>1.5120572662673077E-2</c:v>
                  </c:pt>
                  <c:pt idx="15">
                    <c:v>2.4823786859635974E-2</c:v>
                  </c:pt>
                  <c:pt idx="16">
                    <c:v>2.2503538916578497E-2</c:v>
                  </c:pt>
                  <c:pt idx="17">
                    <c:v>0.1173722714797934</c:v>
                  </c:pt>
                  <c:pt idx="18">
                    <c:v>6.9985629715452261E-2</c:v>
                  </c:pt>
                  <c:pt idx="19">
                    <c:v>3.6167820428512756E-2</c:v>
                  </c:pt>
                  <c:pt idx="21">
                    <c:v>2.3469836376913435E-2</c:v>
                  </c:pt>
                  <c:pt idx="22">
                    <c:v>1.6203581309169556E-2</c:v>
                  </c:pt>
                  <c:pt idx="23">
                    <c:v>1.1878915415605573E-2</c:v>
                  </c:pt>
                  <c:pt idx="24">
                    <c:v>1.0641234118080123E-2</c:v>
                  </c:pt>
                  <c:pt idx="25">
                    <c:v>5.7559768985693425E-3</c:v>
                  </c:pt>
                  <c:pt idx="26">
                    <c:v>5.0863764710565879E-3</c:v>
                  </c:pt>
                  <c:pt idx="27">
                    <c:v>3.2141177134445531E-2</c:v>
                  </c:pt>
                  <c:pt idx="28">
                    <c:v>9.8177713655196702E-2</c:v>
                  </c:pt>
                </c:numCache>
              </c:numRef>
            </c:plus>
            <c:minus>
              <c:numRef>
                <c:f>pH!$C$35:$C$63</c:f>
                <c:numCache>
                  <c:formatCode>General</c:formatCode>
                  <c:ptCount val="29"/>
                  <c:pt idx="0">
                    <c:v>1.0953844766489747E-2</c:v>
                  </c:pt>
                  <c:pt idx="1">
                    <c:v>7.603397243775975E-2</c:v>
                  </c:pt>
                  <c:pt idx="2">
                    <c:v>1.5729105827457606E-2</c:v>
                  </c:pt>
                  <c:pt idx="3">
                    <c:v>4.2087090247043449E-2</c:v>
                  </c:pt>
                  <c:pt idx="4">
                    <c:v>1.4511027627947527E-2</c:v>
                  </c:pt>
                  <c:pt idx="5">
                    <c:v>5.4175594587318873E-3</c:v>
                  </c:pt>
                  <c:pt idx="6">
                    <c:v>2.36037616295963E-2</c:v>
                  </c:pt>
                  <c:pt idx="7">
                    <c:v>1.7031116571270204E-2</c:v>
                  </c:pt>
                  <c:pt idx="8">
                    <c:v>0.300108212203956</c:v>
                  </c:pt>
                  <c:pt idx="9">
                    <c:v>7.8484418269209513E-3</c:v>
                  </c:pt>
                  <c:pt idx="10">
                    <c:v>1.5546446093876455E-2</c:v>
                  </c:pt>
                  <c:pt idx="11">
                    <c:v>0.17777310326119306</c:v>
                  </c:pt>
                  <c:pt idx="12">
                    <c:v>0.14153094305718772</c:v>
                  </c:pt>
                  <c:pt idx="13">
                    <c:v>1.4381510185051948E-2</c:v>
                  </c:pt>
                  <c:pt idx="14">
                    <c:v>1.5120572662673077E-2</c:v>
                  </c:pt>
                  <c:pt idx="15">
                    <c:v>2.4823786859635974E-2</c:v>
                  </c:pt>
                  <c:pt idx="16">
                    <c:v>2.2503538916578497E-2</c:v>
                  </c:pt>
                  <c:pt idx="17">
                    <c:v>0.1173722714797934</c:v>
                  </c:pt>
                  <c:pt idx="18">
                    <c:v>6.9985629715452261E-2</c:v>
                  </c:pt>
                  <c:pt idx="19">
                    <c:v>3.6167820428512756E-2</c:v>
                  </c:pt>
                  <c:pt idx="21">
                    <c:v>2.3469836376913435E-2</c:v>
                  </c:pt>
                  <c:pt idx="22">
                    <c:v>1.6203581309169556E-2</c:v>
                  </c:pt>
                  <c:pt idx="23">
                    <c:v>1.1878915415605573E-2</c:v>
                  </c:pt>
                  <c:pt idx="24">
                    <c:v>1.0641234118080123E-2</c:v>
                  </c:pt>
                  <c:pt idx="25">
                    <c:v>5.7559768985693425E-3</c:v>
                  </c:pt>
                  <c:pt idx="26">
                    <c:v>5.0863764710565879E-3</c:v>
                  </c:pt>
                  <c:pt idx="27">
                    <c:v>3.2141177134445531E-2</c:v>
                  </c:pt>
                  <c:pt idx="28">
                    <c:v>9.81777136551967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H$3:$H$31</c:f>
              <c:numCache>
                <c:formatCode>General</c:formatCode>
                <c:ptCount val="29"/>
                <c:pt idx="0">
                  <c:v>7.9950000000000001</c:v>
                </c:pt>
                <c:pt idx="1">
                  <c:v>5.47</c:v>
                </c:pt>
                <c:pt idx="2">
                  <c:v>5.2149999999999999</c:v>
                </c:pt>
                <c:pt idx="3">
                  <c:v>7.9050000000000002</c:v>
                </c:pt>
                <c:pt idx="4">
                  <c:v>6.7649999999999997</c:v>
                </c:pt>
                <c:pt idx="5">
                  <c:v>5.5549999999999997</c:v>
                </c:pt>
                <c:pt idx="6">
                  <c:v>5.0199999999999996</c:v>
                </c:pt>
                <c:pt idx="7">
                  <c:v>4.6500000000000004</c:v>
                </c:pt>
                <c:pt idx="8">
                  <c:v>5.93</c:v>
                </c:pt>
                <c:pt idx="9">
                  <c:v>6.91</c:v>
                </c:pt>
                <c:pt idx="10">
                  <c:v>4.8250000000000002</c:v>
                </c:pt>
                <c:pt idx="11">
                  <c:v>5.49</c:v>
                </c:pt>
                <c:pt idx="12">
                  <c:v>5.3599999999999994</c:v>
                </c:pt>
                <c:pt idx="13">
                  <c:v>4.9550000000000001</c:v>
                </c:pt>
                <c:pt idx="14">
                  <c:v>4.5149999999999997</c:v>
                </c:pt>
                <c:pt idx="15">
                  <c:v>4.7450000000000001</c:v>
                </c:pt>
                <c:pt idx="16">
                  <c:v>4.38</c:v>
                </c:pt>
                <c:pt idx="17">
                  <c:v>4.51</c:v>
                </c:pt>
                <c:pt idx="18">
                  <c:v>6.0350000000000001</c:v>
                </c:pt>
                <c:pt idx="19">
                  <c:v>5.48</c:v>
                </c:pt>
                <c:pt idx="20">
                  <c:v>6.16</c:v>
                </c:pt>
                <c:pt idx="21">
                  <c:v>5.7249999999999996</c:v>
                </c:pt>
                <c:pt idx="22">
                  <c:v>4.7750000000000004</c:v>
                </c:pt>
                <c:pt idx="23">
                  <c:v>4.9749999999999996</c:v>
                </c:pt>
                <c:pt idx="24">
                  <c:v>4.68</c:v>
                </c:pt>
                <c:pt idx="25">
                  <c:v>7.08</c:v>
                </c:pt>
                <c:pt idx="26">
                  <c:v>6.0600000000000005</c:v>
                </c:pt>
                <c:pt idx="27">
                  <c:v>5.71</c:v>
                </c:pt>
                <c:pt idx="28">
                  <c:v>6.69</c:v>
                </c:pt>
              </c:numCache>
            </c:numRef>
          </c:xVal>
          <c:yVal>
            <c:numRef>
              <c:f>pH!$C$3:$C$31</c:f>
              <c:numCache>
                <c:formatCode>General</c:formatCode>
                <c:ptCount val="29"/>
                <c:pt idx="0">
                  <c:v>0.16259521144590255</c:v>
                </c:pt>
                <c:pt idx="1">
                  <c:v>2.1403291909580653</c:v>
                </c:pt>
                <c:pt idx="2">
                  <c:v>0.67190962259282705</c:v>
                </c:pt>
                <c:pt idx="3">
                  <c:v>0.48539898532289633</c:v>
                </c:pt>
                <c:pt idx="4">
                  <c:v>0.53501240007770223</c:v>
                </c:pt>
                <c:pt idx="5">
                  <c:v>0.57506998483714178</c:v>
                </c:pt>
                <c:pt idx="6">
                  <c:v>0.87188696184501802</c:v>
                </c:pt>
                <c:pt idx="7">
                  <c:v>1.098039333332</c:v>
                </c:pt>
                <c:pt idx="8">
                  <c:v>1.0735752186649157</c:v>
                </c:pt>
                <c:pt idx="9">
                  <c:v>0.25288853203232414</c:v>
                </c:pt>
                <c:pt idx="10">
                  <c:v>1.32218691930771</c:v>
                </c:pt>
                <c:pt idx="11">
                  <c:v>1.7895967964202579</c:v>
                </c:pt>
                <c:pt idx="12">
                  <c:v>0.81037149562952138</c:v>
                </c:pt>
                <c:pt idx="13">
                  <c:v>1.0132178007079544</c:v>
                </c:pt>
                <c:pt idx="14">
                  <c:v>1.2287328935417443</c:v>
                </c:pt>
                <c:pt idx="15">
                  <c:v>1.8135549762882042</c:v>
                </c:pt>
                <c:pt idx="16">
                  <c:v>1.1728085107785018</c:v>
                </c:pt>
                <c:pt idx="17">
                  <c:v>1.5224416270493799</c:v>
                </c:pt>
                <c:pt idx="18">
                  <c:v>0.83628041927472063</c:v>
                </c:pt>
                <c:pt idx="19">
                  <c:v>0.60866924977168957</c:v>
                </c:pt>
                <c:pt idx="20">
                  <c:v>0.52100790882352943</c:v>
                </c:pt>
                <c:pt idx="21">
                  <c:v>0.35129094546256862</c:v>
                </c:pt>
                <c:pt idx="22">
                  <c:v>2.7630678475620343</c:v>
                </c:pt>
                <c:pt idx="23">
                  <c:v>0.66478534361168229</c:v>
                </c:pt>
                <c:pt idx="24">
                  <c:v>1.3002227653294198</c:v>
                </c:pt>
                <c:pt idx="25">
                  <c:v>0.29289778176310538</c:v>
                </c:pt>
                <c:pt idx="26">
                  <c:v>0.3837356054636713</c:v>
                </c:pt>
                <c:pt idx="27">
                  <c:v>0.92459150686948</c:v>
                </c:pt>
                <c:pt idx="28">
                  <c:v>0.732768833172812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86A-47E3-82D6-96116D374C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2493464"/>
        <c:axId val="342487232"/>
      </c:scatterChart>
      <c:valAx>
        <c:axId val="342493464"/>
        <c:scaling>
          <c:orientation val="minMax"/>
          <c:max val="8.5"/>
          <c:min val="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87232"/>
        <c:crosses val="autoZero"/>
        <c:crossBetween val="midCat"/>
      </c:valAx>
      <c:valAx>
        <c:axId val="342487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Cadmium 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934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pH adjusted mediu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M$11:$M$17</c:f>
                <c:numCache>
                  <c:formatCode>General</c:formatCode>
                  <c:ptCount val="7"/>
                  <c:pt idx="0">
                    <c:v>0.10516618876003986</c:v>
                  </c:pt>
                  <c:pt idx="1">
                    <c:v>1.7399027126596478</c:v>
                  </c:pt>
                  <c:pt idx="2">
                    <c:v>1.2790057114394102</c:v>
                  </c:pt>
                  <c:pt idx="3">
                    <c:v>2.5322577800131199</c:v>
                  </c:pt>
                  <c:pt idx="4">
                    <c:v>1.1166983647806679</c:v>
                  </c:pt>
                  <c:pt idx="5">
                    <c:v>1.7038252673630665</c:v>
                  </c:pt>
                  <c:pt idx="6">
                    <c:v>4.5182109809207542</c:v>
                  </c:pt>
                </c:numCache>
              </c:numRef>
            </c:plus>
            <c:minus>
              <c:numRef>
                <c:f>pH!$M$11:$M$17</c:f>
                <c:numCache>
                  <c:formatCode>General</c:formatCode>
                  <c:ptCount val="7"/>
                  <c:pt idx="0">
                    <c:v>0.10516618876003986</c:v>
                  </c:pt>
                  <c:pt idx="1">
                    <c:v>1.7399027126596478</c:v>
                  </c:pt>
                  <c:pt idx="2">
                    <c:v>1.2790057114394102</c:v>
                  </c:pt>
                  <c:pt idx="3">
                    <c:v>2.5322577800131199</c:v>
                  </c:pt>
                  <c:pt idx="4">
                    <c:v>1.1166983647806679</c:v>
                  </c:pt>
                  <c:pt idx="5">
                    <c:v>1.7038252673630665</c:v>
                  </c:pt>
                  <c:pt idx="6">
                    <c:v>4.51821098092075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Q$2:$Q$8</c:f>
              <c:numCache>
                <c:formatCode>General</c:formatCode>
                <c:ptCount val="7"/>
                <c:pt idx="0">
                  <c:v>6.22</c:v>
                </c:pt>
                <c:pt idx="1">
                  <c:v>6.45</c:v>
                </c:pt>
                <c:pt idx="2">
                  <c:v>5.96</c:v>
                </c:pt>
                <c:pt idx="3">
                  <c:v>5.53</c:v>
                </c:pt>
                <c:pt idx="4">
                  <c:v>5.12</c:v>
                </c:pt>
                <c:pt idx="5">
                  <c:v>4.6500000000000004</c:v>
                </c:pt>
                <c:pt idx="6">
                  <c:v>4.09</c:v>
                </c:pt>
              </c:numCache>
            </c:numRef>
          </c:xVal>
          <c:yVal>
            <c:numRef>
              <c:f>pH!$M$2:$M$8</c:f>
              <c:numCache>
                <c:formatCode>General</c:formatCode>
                <c:ptCount val="7"/>
                <c:pt idx="0">
                  <c:v>7.8429110378790803</c:v>
                </c:pt>
                <c:pt idx="1">
                  <c:v>24.124127642110675</c:v>
                </c:pt>
                <c:pt idx="2">
                  <c:v>22.132904410139901</c:v>
                </c:pt>
                <c:pt idx="3">
                  <c:v>8.8183330131784121</c:v>
                </c:pt>
                <c:pt idx="4">
                  <c:v>37.258724653024672</c:v>
                </c:pt>
                <c:pt idx="5">
                  <c:v>44.941479085316502</c:v>
                </c:pt>
                <c:pt idx="6">
                  <c:v>66.1747288101989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3C7-4ADA-AEC6-8E64C3FD90EF}"/>
            </c:ext>
          </c:extLst>
        </c:ser>
        <c:ser>
          <c:idx val="1"/>
          <c:order val="1"/>
          <c:tx>
            <c:v>isolate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D$35:$D$63</c:f>
                <c:numCache>
                  <c:formatCode>General</c:formatCode>
                  <c:ptCount val="29"/>
                  <c:pt idx="0">
                    <c:v>1.3537223658592139</c:v>
                  </c:pt>
                  <c:pt idx="1">
                    <c:v>4.9998289217257854</c:v>
                  </c:pt>
                  <c:pt idx="2">
                    <c:v>0.39500847585372556</c:v>
                  </c:pt>
                  <c:pt idx="3">
                    <c:v>0.41200753400812939</c:v>
                  </c:pt>
                  <c:pt idx="4">
                    <c:v>1.1630571658658151</c:v>
                  </c:pt>
                  <c:pt idx="5">
                    <c:v>0.15311903242306296</c:v>
                  </c:pt>
                  <c:pt idx="6">
                    <c:v>1.0501954530548019</c:v>
                  </c:pt>
                  <c:pt idx="7">
                    <c:v>0.40996709913605706</c:v>
                  </c:pt>
                  <c:pt idx="8">
                    <c:v>10.802989361845169</c:v>
                  </c:pt>
                  <c:pt idx="9">
                    <c:v>0.25037651238343867</c:v>
                  </c:pt>
                  <c:pt idx="10">
                    <c:v>0.2806722187904111</c:v>
                  </c:pt>
                  <c:pt idx="11">
                    <c:v>3.0900799910249024</c:v>
                  </c:pt>
                  <c:pt idx="12">
                    <c:v>4.0439625193339053</c:v>
                  </c:pt>
                  <c:pt idx="13">
                    <c:v>0.52872485273768599</c:v>
                  </c:pt>
                  <c:pt idx="14">
                    <c:v>0.47614927097242227</c:v>
                  </c:pt>
                  <c:pt idx="15">
                    <c:v>0.67315662660055831</c:v>
                  </c:pt>
                  <c:pt idx="16">
                    <c:v>0.42373411561925906</c:v>
                  </c:pt>
                  <c:pt idx="17">
                    <c:v>2.6986448776018848</c:v>
                  </c:pt>
                  <c:pt idx="18">
                    <c:v>2.2739334691515238</c:v>
                  </c:pt>
                  <c:pt idx="19">
                    <c:v>4.1921951804402044E-2</c:v>
                  </c:pt>
                  <c:pt idx="21">
                    <c:v>0.54755644482651489</c:v>
                  </c:pt>
                  <c:pt idx="22">
                    <c:v>0.61997068945377731</c:v>
                  </c:pt>
                  <c:pt idx="23">
                    <c:v>0.26906124696086359</c:v>
                  </c:pt>
                  <c:pt idx="24">
                    <c:v>0.18252589374596337</c:v>
                  </c:pt>
                  <c:pt idx="25">
                    <c:v>2.8565556865507578</c:v>
                  </c:pt>
                  <c:pt idx="26">
                    <c:v>0.28090853016793998</c:v>
                  </c:pt>
                  <c:pt idx="27">
                    <c:v>0.86167256329735042</c:v>
                  </c:pt>
                  <c:pt idx="28">
                    <c:v>0.99778091358600962</c:v>
                  </c:pt>
                </c:numCache>
              </c:numRef>
            </c:plus>
            <c:minus>
              <c:numRef>
                <c:f>pH!$D$35:$D$63</c:f>
                <c:numCache>
                  <c:formatCode>General</c:formatCode>
                  <c:ptCount val="29"/>
                  <c:pt idx="0">
                    <c:v>1.3537223658592139</c:v>
                  </c:pt>
                  <c:pt idx="1">
                    <c:v>4.9998289217257854</c:v>
                  </c:pt>
                  <c:pt idx="2">
                    <c:v>0.39500847585372556</c:v>
                  </c:pt>
                  <c:pt idx="3">
                    <c:v>0.41200753400812939</c:v>
                  </c:pt>
                  <c:pt idx="4">
                    <c:v>1.1630571658658151</c:v>
                  </c:pt>
                  <c:pt idx="5">
                    <c:v>0.15311903242306296</c:v>
                  </c:pt>
                  <c:pt idx="6">
                    <c:v>1.0501954530548019</c:v>
                  </c:pt>
                  <c:pt idx="7">
                    <c:v>0.40996709913605706</c:v>
                  </c:pt>
                  <c:pt idx="8">
                    <c:v>10.802989361845169</c:v>
                  </c:pt>
                  <c:pt idx="9">
                    <c:v>0.25037651238343867</c:v>
                  </c:pt>
                  <c:pt idx="10">
                    <c:v>0.2806722187904111</c:v>
                  </c:pt>
                  <c:pt idx="11">
                    <c:v>3.0900799910249024</c:v>
                  </c:pt>
                  <c:pt idx="12">
                    <c:v>4.0439625193339053</c:v>
                  </c:pt>
                  <c:pt idx="13">
                    <c:v>0.52872485273768599</c:v>
                  </c:pt>
                  <c:pt idx="14">
                    <c:v>0.47614927097242227</c:v>
                  </c:pt>
                  <c:pt idx="15">
                    <c:v>0.67315662660055831</c:v>
                  </c:pt>
                  <c:pt idx="16">
                    <c:v>0.42373411561925906</c:v>
                  </c:pt>
                  <c:pt idx="17">
                    <c:v>2.6986448776018848</c:v>
                  </c:pt>
                  <c:pt idx="18">
                    <c:v>2.2739334691515238</c:v>
                  </c:pt>
                  <c:pt idx="19">
                    <c:v>4.1921951804402044E-2</c:v>
                  </c:pt>
                  <c:pt idx="21">
                    <c:v>0.54755644482651489</c:v>
                  </c:pt>
                  <c:pt idx="22">
                    <c:v>0.61997068945377731</c:v>
                  </c:pt>
                  <c:pt idx="23">
                    <c:v>0.26906124696086359</c:v>
                  </c:pt>
                  <c:pt idx="24">
                    <c:v>0.18252589374596337</c:v>
                  </c:pt>
                  <c:pt idx="25">
                    <c:v>2.8565556865507578</c:v>
                  </c:pt>
                  <c:pt idx="26">
                    <c:v>0.28090853016793998</c:v>
                  </c:pt>
                  <c:pt idx="27">
                    <c:v>0.86167256329735042</c:v>
                  </c:pt>
                  <c:pt idx="28">
                    <c:v>0.997780913586009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H$3:$H$31</c:f>
              <c:numCache>
                <c:formatCode>General</c:formatCode>
                <c:ptCount val="29"/>
                <c:pt idx="0">
                  <c:v>7.9950000000000001</c:v>
                </c:pt>
                <c:pt idx="1">
                  <c:v>5.47</c:v>
                </c:pt>
                <c:pt idx="2">
                  <c:v>5.2149999999999999</c:v>
                </c:pt>
                <c:pt idx="3">
                  <c:v>7.9050000000000002</c:v>
                </c:pt>
                <c:pt idx="4">
                  <c:v>6.7649999999999997</c:v>
                </c:pt>
                <c:pt idx="5">
                  <c:v>5.5549999999999997</c:v>
                </c:pt>
                <c:pt idx="6">
                  <c:v>5.0199999999999996</c:v>
                </c:pt>
                <c:pt idx="7">
                  <c:v>4.6500000000000004</c:v>
                </c:pt>
                <c:pt idx="8">
                  <c:v>5.93</c:v>
                </c:pt>
                <c:pt idx="9">
                  <c:v>6.91</c:v>
                </c:pt>
                <c:pt idx="10">
                  <c:v>4.8250000000000002</c:v>
                </c:pt>
                <c:pt idx="11">
                  <c:v>5.49</c:v>
                </c:pt>
                <c:pt idx="12">
                  <c:v>5.3599999999999994</c:v>
                </c:pt>
                <c:pt idx="13">
                  <c:v>4.9550000000000001</c:v>
                </c:pt>
                <c:pt idx="14">
                  <c:v>4.5149999999999997</c:v>
                </c:pt>
                <c:pt idx="15">
                  <c:v>4.7450000000000001</c:v>
                </c:pt>
                <c:pt idx="16">
                  <c:v>4.38</c:v>
                </c:pt>
                <c:pt idx="17">
                  <c:v>4.51</c:v>
                </c:pt>
                <c:pt idx="18">
                  <c:v>6.0350000000000001</c:v>
                </c:pt>
                <c:pt idx="19">
                  <c:v>5.48</c:v>
                </c:pt>
                <c:pt idx="20">
                  <c:v>6.16</c:v>
                </c:pt>
                <c:pt idx="21">
                  <c:v>5.7249999999999996</c:v>
                </c:pt>
                <c:pt idx="22">
                  <c:v>4.7750000000000004</c:v>
                </c:pt>
                <c:pt idx="23">
                  <c:v>4.9749999999999996</c:v>
                </c:pt>
                <c:pt idx="24">
                  <c:v>4.68</c:v>
                </c:pt>
                <c:pt idx="25">
                  <c:v>7.08</c:v>
                </c:pt>
                <c:pt idx="26">
                  <c:v>6.0600000000000005</c:v>
                </c:pt>
                <c:pt idx="27">
                  <c:v>5.71</c:v>
                </c:pt>
                <c:pt idx="28">
                  <c:v>6.69</c:v>
                </c:pt>
              </c:numCache>
            </c:numRef>
          </c:xVal>
          <c:yVal>
            <c:numRef>
              <c:f>pH!$D$3:$D$31</c:f>
              <c:numCache>
                <c:formatCode>General</c:formatCode>
                <c:ptCount val="29"/>
                <c:pt idx="0">
                  <c:v>21.899809166242662</c:v>
                </c:pt>
                <c:pt idx="1">
                  <c:v>99.250715089259742</c:v>
                </c:pt>
                <c:pt idx="2">
                  <c:v>19.102417606273747</c:v>
                </c:pt>
                <c:pt idx="3">
                  <c:v>28.966760524461844</c:v>
                </c:pt>
                <c:pt idx="4">
                  <c:v>26.827404751362192</c:v>
                </c:pt>
                <c:pt idx="5">
                  <c:v>29.130139612913016</c:v>
                </c:pt>
                <c:pt idx="6">
                  <c:v>30.973368220101605</c:v>
                </c:pt>
                <c:pt idx="7">
                  <c:v>27.93102387063966</c:v>
                </c:pt>
                <c:pt idx="8">
                  <c:v>51.542641580605192</c:v>
                </c:pt>
                <c:pt idx="9">
                  <c:v>20.876909082787353</c:v>
                </c:pt>
                <c:pt idx="10">
                  <c:v>27.703819956473662</c:v>
                </c:pt>
                <c:pt idx="11">
                  <c:v>36.063707226808255</c:v>
                </c:pt>
                <c:pt idx="12">
                  <c:v>30.21486986822136</c:v>
                </c:pt>
                <c:pt idx="13">
                  <c:v>30.937726339082989</c:v>
                </c:pt>
                <c:pt idx="14">
                  <c:v>33.46253944433407</c:v>
                </c:pt>
                <c:pt idx="15">
                  <c:v>63.290884490274863</c:v>
                </c:pt>
                <c:pt idx="16">
                  <c:v>32.216244854633054</c:v>
                </c:pt>
                <c:pt idx="17">
                  <c:v>33.15897179701129</c:v>
                </c:pt>
                <c:pt idx="18">
                  <c:v>35.0571921304184</c:v>
                </c:pt>
                <c:pt idx="19">
                  <c:v>10.656082997591549</c:v>
                </c:pt>
                <c:pt idx="20">
                  <c:v>19.638687117647059</c:v>
                </c:pt>
                <c:pt idx="21">
                  <c:v>25.233736599332719</c:v>
                </c:pt>
                <c:pt idx="22">
                  <c:v>113.39611950971414</c:v>
                </c:pt>
                <c:pt idx="23">
                  <c:v>18.243566224387322</c:v>
                </c:pt>
                <c:pt idx="24">
                  <c:v>27.820675721135032</c:v>
                </c:pt>
                <c:pt idx="25">
                  <c:v>29.06884918844672</c:v>
                </c:pt>
                <c:pt idx="26">
                  <c:v>11.239986701584245</c:v>
                </c:pt>
                <c:pt idx="27">
                  <c:v>29.651678614327775</c:v>
                </c:pt>
                <c:pt idx="28">
                  <c:v>29.0895531563185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3C7-4ADA-AEC6-8E64C3FD90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2493464"/>
        <c:axId val="342487232"/>
      </c:scatterChart>
      <c:valAx>
        <c:axId val="342493464"/>
        <c:scaling>
          <c:orientation val="minMax"/>
          <c:max val="8.5"/>
          <c:min val="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87232"/>
        <c:crosses val="autoZero"/>
        <c:crossBetween val="midCat"/>
      </c:valAx>
      <c:valAx>
        <c:axId val="342487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Lead 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934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pH adjusted mediu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N$11:$N$17</c:f>
                <c:numCache>
                  <c:formatCode>General</c:formatCode>
                  <c:ptCount val="7"/>
                  <c:pt idx="0">
                    <c:v>2.7736929085550397E-2</c:v>
                  </c:pt>
                  <c:pt idx="1">
                    <c:v>0.1639617237595743</c:v>
                  </c:pt>
                  <c:pt idx="2">
                    <c:v>0.12835077834805664</c:v>
                  </c:pt>
                  <c:pt idx="3">
                    <c:v>1.008884484063209</c:v>
                  </c:pt>
                  <c:pt idx="4">
                    <c:v>4.8972617422774284E-2</c:v>
                  </c:pt>
                  <c:pt idx="5">
                    <c:v>0.14046919764721011</c:v>
                  </c:pt>
                  <c:pt idx="6">
                    <c:v>0.36666434814325949</c:v>
                  </c:pt>
                </c:numCache>
              </c:numRef>
            </c:plus>
            <c:minus>
              <c:numRef>
                <c:f>pH!$N$11:$N$17</c:f>
                <c:numCache>
                  <c:formatCode>General</c:formatCode>
                  <c:ptCount val="7"/>
                  <c:pt idx="0">
                    <c:v>2.7736929085550397E-2</c:v>
                  </c:pt>
                  <c:pt idx="1">
                    <c:v>0.1639617237595743</c:v>
                  </c:pt>
                  <c:pt idx="2">
                    <c:v>0.12835077834805664</c:v>
                  </c:pt>
                  <c:pt idx="3">
                    <c:v>1.008884484063209</c:v>
                  </c:pt>
                  <c:pt idx="4">
                    <c:v>4.8972617422774284E-2</c:v>
                  </c:pt>
                  <c:pt idx="5">
                    <c:v>0.14046919764721011</c:v>
                  </c:pt>
                  <c:pt idx="6">
                    <c:v>0.366664348143259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Q$2:$Q$8</c:f>
              <c:numCache>
                <c:formatCode>General</c:formatCode>
                <c:ptCount val="7"/>
                <c:pt idx="0">
                  <c:v>6.22</c:v>
                </c:pt>
                <c:pt idx="1">
                  <c:v>6.45</c:v>
                </c:pt>
                <c:pt idx="2">
                  <c:v>5.96</c:v>
                </c:pt>
                <c:pt idx="3">
                  <c:v>5.53</c:v>
                </c:pt>
                <c:pt idx="4">
                  <c:v>5.12</c:v>
                </c:pt>
                <c:pt idx="5">
                  <c:v>4.6500000000000004</c:v>
                </c:pt>
                <c:pt idx="6">
                  <c:v>4.09</c:v>
                </c:pt>
              </c:numCache>
            </c:numRef>
          </c:xVal>
          <c:yVal>
            <c:numRef>
              <c:f>pH!$N$2:$N$8</c:f>
              <c:numCache>
                <c:formatCode>General</c:formatCode>
                <c:ptCount val="7"/>
                <c:pt idx="0">
                  <c:v>2.8468834387712199</c:v>
                </c:pt>
                <c:pt idx="1">
                  <c:v>2.158776472243396</c:v>
                </c:pt>
                <c:pt idx="2">
                  <c:v>2.2451755383923362</c:v>
                </c:pt>
                <c:pt idx="3">
                  <c:v>2.7481142688393643</c:v>
                </c:pt>
                <c:pt idx="4">
                  <c:v>3.8753020670471887</c:v>
                </c:pt>
                <c:pt idx="5">
                  <c:v>4.1578058335158659</c:v>
                </c:pt>
                <c:pt idx="6">
                  <c:v>5.04148145767308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D06-4B0A-9E11-196F5097DDE2}"/>
            </c:ext>
          </c:extLst>
        </c:ser>
        <c:ser>
          <c:idx val="1"/>
          <c:order val="1"/>
          <c:tx>
            <c:v>isolate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E$35:$E$63</c:f>
                <c:numCache>
                  <c:formatCode>General</c:formatCode>
                  <c:ptCount val="29"/>
                  <c:pt idx="0">
                    <c:v>3.3880367215431555</c:v>
                  </c:pt>
                  <c:pt idx="1">
                    <c:v>1.417585272834917</c:v>
                  </c:pt>
                  <c:pt idx="2">
                    <c:v>0.75788005677288772</c:v>
                  </c:pt>
                  <c:pt idx="3">
                    <c:v>0.93631602827791349</c:v>
                  </c:pt>
                  <c:pt idx="4">
                    <c:v>0.45681825763849715</c:v>
                  </c:pt>
                  <c:pt idx="5">
                    <c:v>0.28877005615462464</c:v>
                  </c:pt>
                  <c:pt idx="6">
                    <c:v>0.16822786272058099</c:v>
                  </c:pt>
                  <c:pt idx="7">
                    <c:v>0.32044296226424496</c:v>
                  </c:pt>
                  <c:pt idx="8">
                    <c:v>1.3447200004058946</c:v>
                  </c:pt>
                  <c:pt idx="9">
                    <c:v>0.44608081018982243</c:v>
                  </c:pt>
                  <c:pt idx="10">
                    <c:v>0.18448144889738347</c:v>
                  </c:pt>
                  <c:pt idx="11">
                    <c:v>1.4641955816487866</c:v>
                  </c:pt>
                  <c:pt idx="12">
                    <c:v>0.56901337261597673</c:v>
                  </c:pt>
                  <c:pt idx="13">
                    <c:v>0.59282606142040639</c:v>
                  </c:pt>
                  <c:pt idx="14">
                    <c:v>0.31914261175123371</c:v>
                  </c:pt>
                  <c:pt idx="15">
                    <c:v>0.24305920944776807</c:v>
                  </c:pt>
                  <c:pt idx="16">
                    <c:v>2.9195417761744085</c:v>
                  </c:pt>
                  <c:pt idx="17">
                    <c:v>0.30807255470439054</c:v>
                  </c:pt>
                  <c:pt idx="18">
                    <c:v>0.42497146847941525</c:v>
                  </c:pt>
                  <c:pt idx="19">
                    <c:v>0.18656755107107803</c:v>
                  </c:pt>
                  <c:pt idx="21">
                    <c:v>0.47834750422610911</c:v>
                  </c:pt>
                  <c:pt idx="22">
                    <c:v>0.21806203179704847</c:v>
                  </c:pt>
                  <c:pt idx="23">
                    <c:v>0.17912501859229057</c:v>
                  </c:pt>
                  <c:pt idx="24">
                    <c:v>0.17833475782889294</c:v>
                  </c:pt>
                  <c:pt idx="25">
                    <c:v>0.63246302882284344</c:v>
                  </c:pt>
                  <c:pt idx="26">
                    <c:v>0.71800760500299843</c:v>
                  </c:pt>
                  <c:pt idx="27">
                    <c:v>0.6941423812561327</c:v>
                  </c:pt>
                  <c:pt idx="28">
                    <c:v>1.9135628593113165</c:v>
                  </c:pt>
                </c:numCache>
              </c:numRef>
            </c:plus>
            <c:minus>
              <c:numRef>
                <c:f>pH!$E$35:$E$63</c:f>
                <c:numCache>
                  <c:formatCode>General</c:formatCode>
                  <c:ptCount val="29"/>
                  <c:pt idx="0">
                    <c:v>3.3880367215431555</c:v>
                  </c:pt>
                  <c:pt idx="1">
                    <c:v>1.417585272834917</c:v>
                  </c:pt>
                  <c:pt idx="2">
                    <c:v>0.75788005677288772</c:v>
                  </c:pt>
                  <c:pt idx="3">
                    <c:v>0.93631602827791349</c:v>
                  </c:pt>
                  <c:pt idx="4">
                    <c:v>0.45681825763849715</c:v>
                  </c:pt>
                  <c:pt idx="5">
                    <c:v>0.28877005615462464</c:v>
                  </c:pt>
                  <c:pt idx="6">
                    <c:v>0.16822786272058099</c:v>
                  </c:pt>
                  <c:pt idx="7">
                    <c:v>0.32044296226424496</c:v>
                  </c:pt>
                  <c:pt idx="8">
                    <c:v>1.3447200004058946</c:v>
                  </c:pt>
                  <c:pt idx="9">
                    <c:v>0.44608081018982243</c:v>
                  </c:pt>
                  <c:pt idx="10">
                    <c:v>0.18448144889738347</c:v>
                  </c:pt>
                  <c:pt idx="11">
                    <c:v>1.4641955816487866</c:v>
                  </c:pt>
                  <c:pt idx="12">
                    <c:v>0.56901337261597673</c:v>
                  </c:pt>
                  <c:pt idx="13">
                    <c:v>0.59282606142040639</c:v>
                  </c:pt>
                  <c:pt idx="14">
                    <c:v>0.31914261175123371</c:v>
                  </c:pt>
                  <c:pt idx="15">
                    <c:v>0.24305920944776807</c:v>
                  </c:pt>
                  <c:pt idx="16">
                    <c:v>2.9195417761744085</c:v>
                  </c:pt>
                  <c:pt idx="17">
                    <c:v>0.30807255470439054</c:v>
                  </c:pt>
                  <c:pt idx="18">
                    <c:v>0.42497146847941525</c:v>
                  </c:pt>
                  <c:pt idx="19">
                    <c:v>0.18656755107107803</c:v>
                  </c:pt>
                  <c:pt idx="21">
                    <c:v>0.47834750422610911</c:v>
                  </c:pt>
                  <c:pt idx="22">
                    <c:v>0.21806203179704847</c:v>
                  </c:pt>
                  <c:pt idx="23">
                    <c:v>0.17912501859229057</c:v>
                  </c:pt>
                  <c:pt idx="24">
                    <c:v>0.17833475782889294</c:v>
                  </c:pt>
                  <c:pt idx="25">
                    <c:v>0.63246302882284344</c:v>
                  </c:pt>
                  <c:pt idx="26">
                    <c:v>0.71800760500299843</c:v>
                  </c:pt>
                  <c:pt idx="27">
                    <c:v>0.6941423812561327</c:v>
                  </c:pt>
                  <c:pt idx="28">
                    <c:v>1.91356285931131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H$3:$H$31</c:f>
              <c:numCache>
                <c:formatCode>General</c:formatCode>
                <c:ptCount val="29"/>
                <c:pt idx="0">
                  <c:v>7.9950000000000001</c:v>
                </c:pt>
                <c:pt idx="1">
                  <c:v>5.47</c:v>
                </c:pt>
                <c:pt idx="2">
                  <c:v>5.2149999999999999</c:v>
                </c:pt>
                <c:pt idx="3">
                  <c:v>7.9050000000000002</c:v>
                </c:pt>
                <c:pt idx="4">
                  <c:v>6.7649999999999997</c:v>
                </c:pt>
                <c:pt idx="5">
                  <c:v>5.5549999999999997</c:v>
                </c:pt>
                <c:pt idx="6">
                  <c:v>5.0199999999999996</c:v>
                </c:pt>
                <c:pt idx="7">
                  <c:v>4.6500000000000004</c:v>
                </c:pt>
                <c:pt idx="8">
                  <c:v>5.93</c:v>
                </c:pt>
                <c:pt idx="9">
                  <c:v>6.91</c:v>
                </c:pt>
                <c:pt idx="10">
                  <c:v>4.8250000000000002</c:v>
                </c:pt>
                <c:pt idx="11">
                  <c:v>5.49</c:v>
                </c:pt>
                <c:pt idx="12">
                  <c:v>5.3599999999999994</c:v>
                </c:pt>
                <c:pt idx="13">
                  <c:v>4.9550000000000001</c:v>
                </c:pt>
                <c:pt idx="14">
                  <c:v>4.5149999999999997</c:v>
                </c:pt>
                <c:pt idx="15">
                  <c:v>4.7450000000000001</c:v>
                </c:pt>
                <c:pt idx="16">
                  <c:v>4.38</c:v>
                </c:pt>
                <c:pt idx="17">
                  <c:v>4.51</c:v>
                </c:pt>
                <c:pt idx="18">
                  <c:v>6.0350000000000001</c:v>
                </c:pt>
                <c:pt idx="19">
                  <c:v>5.48</c:v>
                </c:pt>
                <c:pt idx="20">
                  <c:v>6.16</c:v>
                </c:pt>
                <c:pt idx="21">
                  <c:v>5.7249999999999996</c:v>
                </c:pt>
                <c:pt idx="22">
                  <c:v>4.7750000000000004</c:v>
                </c:pt>
                <c:pt idx="23">
                  <c:v>4.9749999999999996</c:v>
                </c:pt>
                <c:pt idx="24">
                  <c:v>4.68</c:v>
                </c:pt>
                <c:pt idx="25">
                  <c:v>7.08</c:v>
                </c:pt>
                <c:pt idx="26">
                  <c:v>6.0600000000000005</c:v>
                </c:pt>
                <c:pt idx="27">
                  <c:v>5.71</c:v>
                </c:pt>
                <c:pt idx="28">
                  <c:v>6.69</c:v>
                </c:pt>
              </c:numCache>
            </c:numRef>
          </c:xVal>
          <c:yVal>
            <c:numRef>
              <c:f>pH!$E$3:$E$31</c:f>
              <c:numCache>
                <c:formatCode>General</c:formatCode>
                <c:ptCount val="29"/>
                <c:pt idx="0">
                  <c:v>10.095639643268678</c:v>
                </c:pt>
                <c:pt idx="1">
                  <c:v>23.450491326602968</c:v>
                </c:pt>
                <c:pt idx="2">
                  <c:v>5.5516279309610157</c:v>
                </c:pt>
                <c:pt idx="3">
                  <c:v>9.317778530169603</c:v>
                </c:pt>
                <c:pt idx="4">
                  <c:v>9.9602931351188868</c:v>
                </c:pt>
                <c:pt idx="5">
                  <c:v>6.9260527951858215</c:v>
                </c:pt>
                <c:pt idx="6">
                  <c:v>8.5326362156884414</c:v>
                </c:pt>
                <c:pt idx="7">
                  <c:v>8.8225128847167209</c:v>
                </c:pt>
                <c:pt idx="8">
                  <c:v>14.454200768725345</c:v>
                </c:pt>
                <c:pt idx="9">
                  <c:v>9.7276957121875061</c:v>
                </c:pt>
                <c:pt idx="10">
                  <c:v>7.4176572242726921</c:v>
                </c:pt>
                <c:pt idx="11">
                  <c:v>9.4972154846856096</c:v>
                </c:pt>
                <c:pt idx="12">
                  <c:v>8.7777651071337548</c:v>
                </c:pt>
                <c:pt idx="13">
                  <c:v>8.5556871293308649</c:v>
                </c:pt>
                <c:pt idx="14">
                  <c:v>9.0300254908216129</c:v>
                </c:pt>
                <c:pt idx="15">
                  <c:v>10.944934491724993</c:v>
                </c:pt>
                <c:pt idx="16">
                  <c:v>14.433371627498092</c:v>
                </c:pt>
                <c:pt idx="17">
                  <c:v>10.949498894495056</c:v>
                </c:pt>
                <c:pt idx="18">
                  <c:v>6.74204733450311</c:v>
                </c:pt>
                <c:pt idx="19">
                  <c:v>6.3938326907096164</c:v>
                </c:pt>
                <c:pt idx="20">
                  <c:v>18.01357287647059</c:v>
                </c:pt>
                <c:pt idx="21">
                  <c:v>9.2036719226840891</c:v>
                </c:pt>
                <c:pt idx="22">
                  <c:v>19.556033689800202</c:v>
                </c:pt>
                <c:pt idx="23">
                  <c:v>5.7659425888518827</c:v>
                </c:pt>
                <c:pt idx="24">
                  <c:v>6.950169842954991</c:v>
                </c:pt>
                <c:pt idx="25">
                  <c:v>13.636619886867782</c:v>
                </c:pt>
                <c:pt idx="26">
                  <c:v>7.0295166515979171</c:v>
                </c:pt>
                <c:pt idx="27">
                  <c:v>15.284149350834152</c:v>
                </c:pt>
                <c:pt idx="28">
                  <c:v>17.5813268792295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D06-4B0A-9E11-196F5097DD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2493464"/>
        <c:axId val="342487232"/>
      </c:scatterChart>
      <c:valAx>
        <c:axId val="342493464"/>
        <c:scaling>
          <c:orientation val="minMax"/>
          <c:max val="8.5"/>
          <c:min val="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87232"/>
        <c:crosses val="autoZero"/>
        <c:crossBetween val="midCat"/>
      </c:valAx>
      <c:valAx>
        <c:axId val="342487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Iron 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934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pH adjusted mediu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O$11:$O$17</c:f>
                <c:numCache>
                  <c:formatCode>General</c:formatCode>
                  <c:ptCount val="7"/>
                  <c:pt idx="0">
                    <c:v>7.5712527716122399E-2</c:v>
                  </c:pt>
                  <c:pt idx="1">
                    <c:v>0.15176414067872196</c:v>
                  </c:pt>
                  <c:pt idx="2">
                    <c:v>2.6867412525201903E-2</c:v>
                  </c:pt>
                  <c:pt idx="3">
                    <c:v>0.15854189641214159</c:v>
                  </c:pt>
                  <c:pt idx="4">
                    <c:v>3.0105438762829319E-2</c:v>
                  </c:pt>
                  <c:pt idx="5">
                    <c:v>3.9936275362227977E-2</c:v>
                  </c:pt>
                  <c:pt idx="6">
                    <c:v>0.14574265418428903</c:v>
                  </c:pt>
                </c:numCache>
              </c:numRef>
            </c:plus>
            <c:minus>
              <c:numRef>
                <c:f>pH!$O$11:$O$17</c:f>
                <c:numCache>
                  <c:formatCode>General</c:formatCode>
                  <c:ptCount val="7"/>
                  <c:pt idx="0">
                    <c:v>7.5712527716122399E-2</c:v>
                  </c:pt>
                  <c:pt idx="1">
                    <c:v>0.15176414067872196</c:v>
                  </c:pt>
                  <c:pt idx="2">
                    <c:v>2.6867412525201903E-2</c:v>
                  </c:pt>
                  <c:pt idx="3">
                    <c:v>0.15854189641214159</c:v>
                  </c:pt>
                  <c:pt idx="4">
                    <c:v>3.0105438762829319E-2</c:v>
                  </c:pt>
                  <c:pt idx="5">
                    <c:v>3.9936275362227977E-2</c:v>
                  </c:pt>
                  <c:pt idx="6">
                    <c:v>0.145742654184289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Q$2:$Q$8</c:f>
              <c:numCache>
                <c:formatCode>General</c:formatCode>
                <c:ptCount val="7"/>
                <c:pt idx="0">
                  <c:v>6.22</c:v>
                </c:pt>
                <c:pt idx="1">
                  <c:v>6.45</c:v>
                </c:pt>
                <c:pt idx="2">
                  <c:v>5.96</c:v>
                </c:pt>
                <c:pt idx="3">
                  <c:v>5.53</c:v>
                </c:pt>
                <c:pt idx="4">
                  <c:v>5.12</c:v>
                </c:pt>
                <c:pt idx="5">
                  <c:v>4.6500000000000004</c:v>
                </c:pt>
                <c:pt idx="6">
                  <c:v>4.09</c:v>
                </c:pt>
              </c:numCache>
            </c:numRef>
          </c:xVal>
          <c:yVal>
            <c:numRef>
              <c:f>pH!$O$2:$O$8</c:f>
              <c:numCache>
                <c:formatCode>General</c:formatCode>
                <c:ptCount val="7"/>
                <c:pt idx="0">
                  <c:v>4.8540884263561139</c:v>
                </c:pt>
                <c:pt idx="1">
                  <c:v>5.3425435563547872</c:v>
                </c:pt>
                <c:pt idx="2">
                  <c:v>4.5199113401542741</c:v>
                </c:pt>
                <c:pt idx="3">
                  <c:v>3.4744087815550428</c:v>
                </c:pt>
                <c:pt idx="4">
                  <c:v>3.2007697411222567</c:v>
                </c:pt>
                <c:pt idx="5">
                  <c:v>2.4539102721230699</c:v>
                </c:pt>
                <c:pt idx="6">
                  <c:v>2.41140983882207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520-4449-80D7-DE8FD7349A2D}"/>
            </c:ext>
          </c:extLst>
        </c:ser>
        <c:ser>
          <c:idx val="1"/>
          <c:order val="1"/>
          <c:tx>
            <c:v>isolate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F$35:$F$63</c:f>
                <c:numCache>
                  <c:formatCode>General</c:formatCode>
                  <c:ptCount val="29"/>
                  <c:pt idx="0">
                    <c:v>0.19910377046939601</c:v>
                  </c:pt>
                  <c:pt idx="1">
                    <c:v>6.6585960456569865E-2</c:v>
                  </c:pt>
                  <c:pt idx="2">
                    <c:v>7.1426445312313624E-2</c:v>
                  </c:pt>
                  <c:pt idx="3">
                    <c:v>5.599706840074898E-2</c:v>
                  </c:pt>
                  <c:pt idx="4">
                    <c:v>4.5692495061273972E-2</c:v>
                  </c:pt>
                  <c:pt idx="5">
                    <c:v>3.6471355616013335E-2</c:v>
                  </c:pt>
                  <c:pt idx="6">
                    <c:v>7.8378218563185331E-2</c:v>
                  </c:pt>
                  <c:pt idx="7">
                    <c:v>7.2687930355843061E-2</c:v>
                  </c:pt>
                  <c:pt idx="8">
                    <c:v>0.18042201157830057</c:v>
                  </c:pt>
                  <c:pt idx="9">
                    <c:v>5.3091407140428704E-2</c:v>
                  </c:pt>
                  <c:pt idx="10">
                    <c:v>6.7165745818635603E-2</c:v>
                  </c:pt>
                  <c:pt idx="11">
                    <c:v>0.2614208797678963</c:v>
                  </c:pt>
                  <c:pt idx="12">
                    <c:v>0.15507230414383799</c:v>
                  </c:pt>
                  <c:pt idx="13">
                    <c:v>0.25665033424529471</c:v>
                  </c:pt>
                  <c:pt idx="14">
                    <c:v>4.7536684695932689E-2</c:v>
                  </c:pt>
                  <c:pt idx="15">
                    <c:v>2.3989407693966673E-2</c:v>
                  </c:pt>
                  <c:pt idx="16">
                    <c:v>1.9806381002049591E-2</c:v>
                  </c:pt>
                  <c:pt idx="17">
                    <c:v>0.18840598218279261</c:v>
                  </c:pt>
                  <c:pt idx="18">
                    <c:v>0.16544269319318031</c:v>
                  </c:pt>
                  <c:pt idx="19">
                    <c:v>2.6099438270187344E-2</c:v>
                  </c:pt>
                  <c:pt idx="21">
                    <c:v>0.18189754049815063</c:v>
                  </c:pt>
                  <c:pt idx="22">
                    <c:v>3.3452840850758489E-2</c:v>
                  </c:pt>
                  <c:pt idx="23">
                    <c:v>2.4489309459121807E-2</c:v>
                  </c:pt>
                  <c:pt idx="24">
                    <c:v>4.3608647530661952E-2</c:v>
                  </c:pt>
                  <c:pt idx="25">
                    <c:v>4.0263202606524433E-2</c:v>
                  </c:pt>
                  <c:pt idx="26">
                    <c:v>8.2104303329157205E-2</c:v>
                  </c:pt>
                  <c:pt idx="27">
                    <c:v>9.42224435721295E-2</c:v>
                  </c:pt>
                  <c:pt idx="28">
                    <c:v>0.78209049714562073</c:v>
                  </c:pt>
                </c:numCache>
              </c:numRef>
            </c:plus>
            <c:minus>
              <c:numRef>
                <c:f>pH!$F$35:$F$63</c:f>
                <c:numCache>
                  <c:formatCode>General</c:formatCode>
                  <c:ptCount val="29"/>
                  <c:pt idx="0">
                    <c:v>0.19910377046939601</c:v>
                  </c:pt>
                  <c:pt idx="1">
                    <c:v>6.6585960456569865E-2</c:v>
                  </c:pt>
                  <c:pt idx="2">
                    <c:v>7.1426445312313624E-2</c:v>
                  </c:pt>
                  <c:pt idx="3">
                    <c:v>5.599706840074898E-2</c:v>
                  </c:pt>
                  <c:pt idx="4">
                    <c:v>4.5692495061273972E-2</c:v>
                  </c:pt>
                  <c:pt idx="5">
                    <c:v>3.6471355616013335E-2</c:v>
                  </c:pt>
                  <c:pt idx="6">
                    <c:v>7.8378218563185331E-2</c:v>
                  </c:pt>
                  <c:pt idx="7">
                    <c:v>7.2687930355843061E-2</c:v>
                  </c:pt>
                  <c:pt idx="8">
                    <c:v>0.18042201157830057</c:v>
                  </c:pt>
                  <c:pt idx="9">
                    <c:v>5.3091407140428704E-2</c:v>
                  </c:pt>
                  <c:pt idx="10">
                    <c:v>6.7165745818635603E-2</c:v>
                  </c:pt>
                  <c:pt idx="11">
                    <c:v>0.2614208797678963</c:v>
                  </c:pt>
                  <c:pt idx="12">
                    <c:v>0.15507230414383799</c:v>
                  </c:pt>
                  <c:pt idx="13">
                    <c:v>0.25665033424529471</c:v>
                  </c:pt>
                  <c:pt idx="14">
                    <c:v>4.7536684695932689E-2</c:v>
                  </c:pt>
                  <c:pt idx="15">
                    <c:v>2.3989407693966673E-2</c:v>
                  </c:pt>
                  <c:pt idx="16">
                    <c:v>1.9806381002049591E-2</c:v>
                  </c:pt>
                  <c:pt idx="17">
                    <c:v>0.18840598218279261</c:v>
                  </c:pt>
                  <c:pt idx="18">
                    <c:v>0.16544269319318031</c:v>
                  </c:pt>
                  <c:pt idx="19">
                    <c:v>2.6099438270187344E-2</c:v>
                  </c:pt>
                  <c:pt idx="21">
                    <c:v>0.18189754049815063</c:v>
                  </c:pt>
                  <c:pt idx="22">
                    <c:v>3.3452840850758489E-2</c:v>
                  </c:pt>
                  <c:pt idx="23">
                    <c:v>2.4489309459121807E-2</c:v>
                  </c:pt>
                  <c:pt idx="24">
                    <c:v>4.3608647530661952E-2</c:v>
                  </c:pt>
                  <c:pt idx="25">
                    <c:v>4.0263202606524433E-2</c:v>
                  </c:pt>
                  <c:pt idx="26">
                    <c:v>8.2104303329157205E-2</c:v>
                  </c:pt>
                  <c:pt idx="27">
                    <c:v>9.42224435721295E-2</c:v>
                  </c:pt>
                  <c:pt idx="28">
                    <c:v>0.782090497145620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H$3:$H$31</c:f>
              <c:numCache>
                <c:formatCode>General</c:formatCode>
                <c:ptCount val="29"/>
                <c:pt idx="0">
                  <c:v>7.9950000000000001</c:v>
                </c:pt>
                <c:pt idx="1">
                  <c:v>5.47</c:v>
                </c:pt>
                <c:pt idx="2">
                  <c:v>5.2149999999999999</c:v>
                </c:pt>
                <c:pt idx="3">
                  <c:v>7.9050000000000002</c:v>
                </c:pt>
                <c:pt idx="4">
                  <c:v>6.7649999999999997</c:v>
                </c:pt>
                <c:pt idx="5">
                  <c:v>5.5549999999999997</c:v>
                </c:pt>
                <c:pt idx="6">
                  <c:v>5.0199999999999996</c:v>
                </c:pt>
                <c:pt idx="7">
                  <c:v>4.6500000000000004</c:v>
                </c:pt>
                <c:pt idx="8">
                  <c:v>5.93</c:v>
                </c:pt>
                <c:pt idx="9">
                  <c:v>6.91</c:v>
                </c:pt>
                <c:pt idx="10">
                  <c:v>4.8250000000000002</c:v>
                </c:pt>
                <c:pt idx="11">
                  <c:v>5.49</c:v>
                </c:pt>
                <c:pt idx="12">
                  <c:v>5.3599999999999994</c:v>
                </c:pt>
                <c:pt idx="13">
                  <c:v>4.9550000000000001</c:v>
                </c:pt>
                <c:pt idx="14">
                  <c:v>4.5149999999999997</c:v>
                </c:pt>
                <c:pt idx="15">
                  <c:v>4.7450000000000001</c:v>
                </c:pt>
                <c:pt idx="16">
                  <c:v>4.38</c:v>
                </c:pt>
                <c:pt idx="17">
                  <c:v>4.51</c:v>
                </c:pt>
                <c:pt idx="18">
                  <c:v>6.0350000000000001</c:v>
                </c:pt>
                <c:pt idx="19">
                  <c:v>5.48</c:v>
                </c:pt>
                <c:pt idx="20">
                  <c:v>6.16</c:v>
                </c:pt>
                <c:pt idx="21">
                  <c:v>5.7249999999999996</c:v>
                </c:pt>
                <c:pt idx="22">
                  <c:v>4.7750000000000004</c:v>
                </c:pt>
                <c:pt idx="23">
                  <c:v>4.9749999999999996</c:v>
                </c:pt>
                <c:pt idx="24">
                  <c:v>4.68</c:v>
                </c:pt>
                <c:pt idx="25">
                  <c:v>7.08</c:v>
                </c:pt>
                <c:pt idx="26">
                  <c:v>6.0600000000000005</c:v>
                </c:pt>
                <c:pt idx="27">
                  <c:v>5.71</c:v>
                </c:pt>
                <c:pt idx="28">
                  <c:v>6.69</c:v>
                </c:pt>
              </c:numCache>
            </c:numRef>
          </c:xVal>
          <c:yVal>
            <c:numRef>
              <c:f>pH!$F$3:$F$31</c:f>
              <c:numCache>
                <c:formatCode>General</c:formatCode>
                <c:ptCount val="29"/>
                <c:pt idx="0">
                  <c:v>4.0450542704852719</c:v>
                </c:pt>
                <c:pt idx="1">
                  <c:v>2.8830514439034274</c:v>
                </c:pt>
                <c:pt idx="2">
                  <c:v>3.3153435343779978</c:v>
                </c:pt>
                <c:pt idx="3">
                  <c:v>3.7117592995759949</c:v>
                </c:pt>
                <c:pt idx="4">
                  <c:v>4.1433570110199787</c:v>
                </c:pt>
                <c:pt idx="5">
                  <c:v>3.6576859410680806</c:v>
                </c:pt>
                <c:pt idx="6">
                  <c:v>4.1065444901267432</c:v>
                </c:pt>
                <c:pt idx="7">
                  <c:v>4.1887594568068742</c:v>
                </c:pt>
                <c:pt idx="8">
                  <c:v>3.0858137649857795</c:v>
                </c:pt>
                <c:pt idx="9">
                  <c:v>3.2120390874691584</c:v>
                </c:pt>
                <c:pt idx="10">
                  <c:v>3.440382920932116</c:v>
                </c:pt>
                <c:pt idx="11">
                  <c:v>3.9420199147301838</c:v>
                </c:pt>
                <c:pt idx="12">
                  <c:v>2.5995400002155225</c:v>
                </c:pt>
                <c:pt idx="13">
                  <c:v>3.2434522944179043</c:v>
                </c:pt>
                <c:pt idx="14">
                  <c:v>4.9802450063069399</c:v>
                </c:pt>
                <c:pt idx="15">
                  <c:v>2.8537757774660859</c:v>
                </c:pt>
                <c:pt idx="16">
                  <c:v>4.0012937202204482</c:v>
                </c:pt>
                <c:pt idx="17">
                  <c:v>3.7152163107465341</c:v>
                </c:pt>
                <c:pt idx="18">
                  <c:v>4.0571201111119874</c:v>
                </c:pt>
                <c:pt idx="19">
                  <c:v>4.9563744514031187</c:v>
                </c:pt>
                <c:pt idx="20">
                  <c:v>2.1123405186274509</c:v>
                </c:pt>
                <c:pt idx="21">
                  <c:v>2.7322003408038831</c:v>
                </c:pt>
                <c:pt idx="22">
                  <c:v>3.0866460620014524</c:v>
                </c:pt>
                <c:pt idx="23">
                  <c:v>4.3335990421032369</c:v>
                </c:pt>
                <c:pt idx="24">
                  <c:v>3.2831666673189823</c:v>
                </c:pt>
                <c:pt idx="25">
                  <c:v>3.2069770308143917</c:v>
                </c:pt>
                <c:pt idx="26">
                  <c:v>6.6648197744976185</c:v>
                </c:pt>
                <c:pt idx="27">
                  <c:v>2.5960428596663396</c:v>
                </c:pt>
                <c:pt idx="28">
                  <c:v>4.45875312957292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520-4449-80D7-DE8FD7349A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2493464"/>
        <c:axId val="342487232"/>
      </c:scatterChart>
      <c:valAx>
        <c:axId val="342493464"/>
        <c:scaling>
          <c:orientation val="minMax"/>
          <c:max val="8.5"/>
          <c:min val="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pH valu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87232"/>
        <c:crosses val="autoZero"/>
        <c:crossBetween val="midCat"/>
      </c:valAx>
      <c:valAx>
        <c:axId val="342487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Copper</a:t>
                </a:r>
                <a:r>
                  <a:rPr lang="en-US" b="1" baseline="0">
                    <a:solidFill>
                      <a:schemeClr val="tx1"/>
                    </a:solidFill>
                  </a:rPr>
                  <a:t> </a:t>
                </a:r>
                <a:r>
                  <a:rPr lang="en-US" b="1">
                    <a:solidFill>
                      <a:schemeClr val="tx1"/>
                    </a:solidFill>
                  </a:rPr>
                  <a:t>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93464"/>
        <c:crosses val="autoZero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457129743839821"/>
          <c:y val="5.5859711752691422E-2"/>
          <c:w val="0.77465362439402197"/>
          <c:h val="0.71865338509053511"/>
        </c:manualLayout>
      </c:layout>
      <c:scatterChart>
        <c:scatterStyle val="lineMarker"/>
        <c:varyColors val="0"/>
        <c:ser>
          <c:idx val="0"/>
          <c:order val="0"/>
          <c:tx>
            <c:v>pH adjusted medium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P$11:$P$17</c:f>
                <c:numCache>
                  <c:formatCode>General</c:formatCode>
                  <c:ptCount val="7"/>
                  <c:pt idx="0">
                    <c:v>2.851313670150947E-2</c:v>
                  </c:pt>
                  <c:pt idx="1">
                    <c:v>0.19965168696270932</c:v>
                  </c:pt>
                  <c:pt idx="2">
                    <c:v>0.12540880409413457</c:v>
                  </c:pt>
                  <c:pt idx="3">
                    <c:v>0.58660938983370192</c:v>
                  </c:pt>
                  <c:pt idx="4">
                    <c:v>0.27913977336931473</c:v>
                  </c:pt>
                  <c:pt idx="5">
                    <c:v>0.53705320488637265</c:v>
                  </c:pt>
                  <c:pt idx="6">
                    <c:v>2.8683136050104374</c:v>
                  </c:pt>
                </c:numCache>
              </c:numRef>
            </c:plus>
            <c:minus>
              <c:numRef>
                <c:f>pH!$P$11:$P$17</c:f>
                <c:numCache>
                  <c:formatCode>General</c:formatCode>
                  <c:ptCount val="7"/>
                  <c:pt idx="0">
                    <c:v>2.851313670150947E-2</c:v>
                  </c:pt>
                  <c:pt idx="1">
                    <c:v>0.19965168696270932</c:v>
                  </c:pt>
                  <c:pt idx="2">
                    <c:v>0.12540880409413457</c:v>
                  </c:pt>
                  <c:pt idx="3">
                    <c:v>0.58660938983370192</c:v>
                  </c:pt>
                  <c:pt idx="4">
                    <c:v>0.27913977336931473</c:v>
                  </c:pt>
                  <c:pt idx="5">
                    <c:v>0.53705320488637265</c:v>
                  </c:pt>
                  <c:pt idx="6">
                    <c:v>2.86831360501043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Q$2:$Q$8</c:f>
              <c:numCache>
                <c:formatCode>General</c:formatCode>
                <c:ptCount val="7"/>
                <c:pt idx="0">
                  <c:v>6.22</c:v>
                </c:pt>
                <c:pt idx="1">
                  <c:v>6.45</c:v>
                </c:pt>
                <c:pt idx="2">
                  <c:v>5.96</c:v>
                </c:pt>
                <c:pt idx="3">
                  <c:v>5.53</c:v>
                </c:pt>
                <c:pt idx="4">
                  <c:v>5.12</c:v>
                </c:pt>
                <c:pt idx="5">
                  <c:v>4.6500000000000004</c:v>
                </c:pt>
                <c:pt idx="6">
                  <c:v>4.09</c:v>
                </c:pt>
              </c:numCache>
            </c:numRef>
          </c:xVal>
          <c:yVal>
            <c:numRef>
              <c:f>pH!$P$2:$P$8</c:f>
              <c:numCache>
                <c:formatCode>General</c:formatCode>
                <c:ptCount val="7"/>
                <c:pt idx="0">
                  <c:v>4.4939024161396972</c:v>
                </c:pt>
                <c:pt idx="1">
                  <c:v>6.5159028032715343</c:v>
                </c:pt>
                <c:pt idx="2">
                  <c:v>7.8903762436822502</c:v>
                </c:pt>
                <c:pt idx="3">
                  <c:v>17.937492375788011</c:v>
                </c:pt>
                <c:pt idx="4">
                  <c:v>15.681294792899612</c:v>
                </c:pt>
                <c:pt idx="5">
                  <c:v>20.434197411170931</c:v>
                </c:pt>
                <c:pt idx="6">
                  <c:v>37.0774363172275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5DD-4964-B6BB-44604A6E74B0}"/>
            </c:ext>
          </c:extLst>
        </c:ser>
        <c:ser>
          <c:idx val="1"/>
          <c:order val="1"/>
          <c:tx>
            <c:v>isolates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H!$G$35:$G$63</c:f>
                <c:numCache>
                  <c:formatCode>General</c:formatCode>
                  <c:ptCount val="29"/>
                  <c:pt idx="0">
                    <c:v>0.1026310853322132</c:v>
                  </c:pt>
                  <c:pt idx="1">
                    <c:v>0.60282165256997611</c:v>
                  </c:pt>
                  <c:pt idx="2">
                    <c:v>0.18030010446767239</c:v>
                  </c:pt>
                  <c:pt idx="3">
                    <c:v>0.21428082545563301</c:v>
                  </c:pt>
                  <c:pt idx="4">
                    <c:v>6.729438231320109E-2</c:v>
                  </c:pt>
                  <c:pt idx="5">
                    <c:v>3.0252581474082614E-2</c:v>
                  </c:pt>
                  <c:pt idx="6">
                    <c:v>0.91871177196252618</c:v>
                  </c:pt>
                  <c:pt idx="7">
                    <c:v>0.45166091264236613</c:v>
                  </c:pt>
                  <c:pt idx="8">
                    <c:v>2.8308856245886158</c:v>
                  </c:pt>
                  <c:pt idx="9">
                    <c:v>0.18225993228101092</c:v>
                  </c:pt>
                  <c:pt idx="10">
                    <c:v>0.24854136343440306</c:v>
                  </c:pt>
                  <c:pt idx="11">
                    <c:v>1.7539121483050388</c:v>
                  </c:pt>
                  <c:pt idx="12">
                    <c:v>1.0721324528884253</c:v>
                  </c:pt>
                  <c:pt idx="13">
                    <c:v>0.15172826710234044</c:v>
                  </c:pt>
                  <c:pt idx="14">
                    <c:v>0.10455920218611489</c:v>
                  </c:pt>
                  <c:pt idx="15">
                    <c:v>0.12142488401754443</c:v>
                  </c:pt>
                  <c:pt idx="16">
                    <c:v>0.29349641490776918</c:v>
                  </c:pt>
                  <c:pt idx="17">
                    <c:v>1.1917748628320446</c:v>
                  </c:pt>
                  <c:pt idx="18">
                    <c:v>0.49123537676336887</c:v>
                  </c:pt>
                  <c:pt idx="19">
                    <c:v>6.5008055966331024E-2</c:v>
                  </c:pt>
                  <c:pt idx="21">
                    <c:v>0.15182260754697582</c:v>
                  </c:pt>
                  <c:pt idx="22">
                    <c:v>0.24187885131403944</c:v>
                  </c:pt>
                  <c:pt idx="23">
                    <c:v>9.2523036182808549E-2</c:v>
                  </c:pt>
                  <c:pt idx="24">
                    <c:v>8.4088989982555998E-2</c:v>
                  </c:pt>
                  <c:pt idx="25">
                    <c:v>0.25826148751804617</c:v>
                  </c:pt>
                  <c:pt idx="26">
                    <c:v>5.4836865916498008E-2</c:v>
                  </c:pt>
                  <c:pt idx="27">
                    <c:v>0.52198324631992044</c:v>
                  </c:pt>
                  <c:pt idx="28">
                    <c:v>1.5902977840135479</c:v>
                  </c:pt>
                </c:numCache>
              </c:numRef>
            </c:plus>
            <c:minus>
              <c:numRef>
                <c:f>pH!$G$35:$G$63</c:f>
                <c:numCache>
                  <c:formatCode>General</c:formatCode>
                  <c:ptCount val="29"/>
                  <c:pt idx="0">
                    <c:v>0.1026310853322132</c:v>
                  </c:pt>
                  <c:pt idx="1">
                    <c:v>0.60282165256997611</c:v>
                  </c:pt>
                  <c:pt idx="2">
                    <c:v>0.18030010446767239</c:v>
                  </c:pt>
                  <c:pt idx="3">
                    <c:v>0.21428082545563301</c:v>
                  </c:pt>
                  <c:pt idx="4">
                    <c:v>6.729438231320109E-2</c:v>
                  </c:pt>
                  <c:pt idx="5">
                    <c:v>3.0252581474082614E-2</c:v>
                  </c:pt>
                  <c:pt idx="6">
                    <c:v>0.91871177196252618</c:v>
                  </c:pt>
                  <c:pt idx="7">
                    <c:v>0.45166091264236613</c:v>
                  </c:pt>
                  <c:pt idx="8">
                    <c:v>2.8308856245886158</c:v>
                  </c:pt>
                  <c:pt idx="9">
                    <c:v>0.18225993228101092</c:v>
                  </c:pt>
                  <c:pt idx="10">
                    <c:v>0.24854136343440306</c:v>
                  </c:pt>
                  <c:pt idx="11">
                    <c:v>1.7539121483050388</c:v>
                  </c:pt>
                  <c:pt idx="12">
                    <c:v>1.0721324528884253</c:v>
                  </c:pt>
                  <c:pt idx="13">
                    <c:v>0.15172826710234044</c:v>
                  </c:pt>
                  <c:pt idx="14">
                    <c:v>0.10455920218611489</c:v>
                  </c:pt>
                  <c:pt idx="15">
                    <c:v>0.12142488401754443</c:v>
                  </c:pt>
                  <c:pt idx="16">
                    <c:v>0.29349641490776918</c:v>
                  </c:pt>
                  <c:pt idx="17">
                    <c:v>1.1917748628320446</c:v>
                  </c:pt>
                  <c:pt idx="18">
                    <c:v>0.49123537676336887</c:v>
                  </c:pt>
                  <c:pt idx="19">
                    <c:v>6.5008055966331024E-2</c:v>
                  </c:pt>
                  <c:pt idx="21">
                    <c:v>0.15182260754697582</c:v>
                  </c:pt>
                  <c:pt idx="22">
                    <c:v>0.24187885131403944</c:v>
                  </c:pt>
                  <c:pt idx="23">
                    <c:v>9.2523036182808549E-2</c:v>
                  </c:pt>
                  <c:pt idx="24">
                    <c:v>8.4088989982555998E-2</c:v>
                  </c:pt>
                  <c:pt idx="25">
                    <c:v>0.25826148751804617</c:v>
                  </c:pt>
                  <c:pt idx="26">
                    <c:v>5.4836865916498008E-2</c:v>
                  </c:pt>
                  <c:pt idx="27">
                    <c:v>0.52198324631992044</c:v>
                  </c:pt>
                  <c:pt idx="28">
                    <c:v>1.59029778401354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pH!$H$3:$H$31</c:f>
              <c:numCache>
                <c:formatCode>General</c:formatCode>
                <c:ptCount val="29"/>
                <c:pt idx="0">
                  <c:v>7.9950000000000001</c:v>
                </c:pt>
                <c:pt idx="1">
                  <c:v>5.47</c:v>
                </c:pt>
                <c:pt idx="2">
                  <c:v>5.2149999999999999</c:v>
                </c:pt>
                <c:pt idx="3">
                  <c:v>7.9050000000000002</c:v>
                </c:pt>
                <c:pt idx="4">
                  <c:v>6.7649999999999997</c:v>
                </c:pt>
                <c:pt idx="5">
                  <c:v>5.5549999999999997</c:v>
                </c:pt>
                <c:pt idx="6">
                  <c:v>5.0199999999999996</c:v>
                </c:pt>
                <c:pt idx="7">
                  <c:v>4.6500000000000004</c:v>
                </c:pt>
                <c:pt idx="8">
                  <c:v>5.93</c:v>
                </c:pt>
                <c:pt idx="9">
                  <c:v>6.91</c:v>
                </c:pt>
                <c:pt idx="10">
                  <c:v>4.8250000000000002</c:v>
                </c:pt>
                <c:pt idx="11">
                  <c:v>5.49</c:v>
                </c:pt>
                <c:pt idx="12">
                  <c:v>5.3599999999999994</c:v>
                </c:pt>
                <c:pt idx="13">
                  <c:v>4.9550000000000001</c:v>
                </c:pt>
                <c:pt idx="14">
                  <c:v>4.5149999999999997</c:v>
                </c:pt>
                <c:pt idx="15">
                  <c:v>4.7450000000000001</c:v>
                </c:pt>
                <c:pt idx="16">
                  <c:v>4.38</c:v>
                </c:pt>
                <c:pt idx="17">
                  <c:v>4.51</c:v>
                </c:pt>
                <c:pt idx="18">
                  <c:v>6.0350000000000001</c:v>
                </c:pt>
                <c:pt idx="19">
                  <c:v>5.48</c:v>
                </c:pt>
                <c:pt idx="20">
                  <c:v>6.16</c:v>
                </c:pt>
                <c:pt idx="21">
                  <c:v>5.7249999999999996</c:v>
                </c:pt>
                <c:pt idx="22">
                  <c:v>4.7750000000000004</c:v>
                </c:pt>
                <c:pt idx="23">
                  <c:v>4.9749999999999996</c:v>
                </c:pt>
                <c:pt idx="24">
                  <c:v>4.68</c:v>
                </c:pt>
                <c:pt idx="25">
                  <c:v>7.08</c:v>
                </c:pt>
                <c:pt idx="26">
                  <c:v>6.0600000000000005</c:v>
                </c:pt>
                <c:pt idx="27">
                  <c:v>5.71</c:v>
                </c:pt>
                <c:pt idx="28">
                  <c:v>6.69</c:v>
                </c:pt>
              </c:numCache>
            </c:numRef>
          </c:xVal>
          <c:yVal>
            <c:numRef>
              <c:f>pH!$G$3:$G$31</c:f>
              <c:numCache>
                <c:formatCode>General</c:formatCode>
                <c:ptCount val="29"/>
                <c:pt idx="0">
                  <c:v>2.8811652245257924</c:v>
                </c:pt>
                <c:pt idx="1">
                  <c:v>22.85925914457636</c:v>
                </c:pt>
                <c:pt idx="2">
                  <c:v>10.214372624577594</c:v>
                </c:pt>
                <c:pt idx="3">
                  <c:v>3.8695834445531632</c:v>
                </c:pt>
                <c:pt idx="4">
                  <c:v>3.2179018444863341</c:v>
                </c:pt>
                <c:pt idx="5">
                  <c:v>8.021592763576324</c:v>
                </c:pt>
                <c:pt idx="6">
                  <c:v>11.955323540647468</c:v>
                </c:pt>
                <c:pt idx="7">
                  <c:v>15.904226627236048</c:v>
                </c:pt>
                <c:pt idx="8">
                  <c:v>12.726378698810478</c:v>
                </c:pt>
                <c:pt idx="9">
                  <c:v>5.5141262546236414</c:v>
                </c:pt>
                <c:pt idx="10">
                  <c:v>16.978022151832679</c:v>
                </c:pt>
                <c:pt idx="11">
                  <c:v>22.849025826317103</c:v>
                </c:pt>
                <c:pt idx="12">
                  <c:v>9.692626190051902</c:v>
                </c:pt>
                <c:pt idx="13">
                  <c:v>10.997664463081486</c:v>
                </c:pt>
                <c:pt idx="14">
                  <c:v>16.315189606414972</c:v>
                </c:pt>
                <c:pt idx="15">
                  <c:v>16.862270722260249</c:v>
                </c:pt>
                <c:pt idx="16">
                  <c:v>16.419702751088643</c:v>
                </c:pt>
                <c:pt idx="17">
                  <c:v>15.154413987924624</c:v>
                </c:pt>
                <c:pt idx="18">
                  <c:v>8.580809702190539</c:v>
                </c:pt>
                <c:pt idx="19">
                  <c:v>5.7686018785113129</c:v>
                </c:pt>
                <c:pt idx="20">
                  <c:v>4.1886992284313731</c:v>
                </c:pt>
                <c:pt idx="21">
                  <c:v>5.8612641288588314</c:v>
                </c:pt>
                <c:pt idx="22">
                  <c:v>22.41327028689469</c:v>
                </c:pt>
                <c:pt idx="23">
                  <c:v>10.27049428133874</c:v>
                </c:pt>
                <c:pt idx="24">
                  <c:v>17.963859462818007</c:v>
                </c:pt>
                <c:pt idx="25">
                  <c:v>7.0941178046388691</c:v>
                </c:pt>
                <c:pt idx="26">
                  <c:v>1.9494220890040397</c:v>
                </c:pt>
                <c:pt idx="27">
                  <c:v>10.330931237487736</c:v>
                </c:pt>
                <c:pt idx="28">
                  <c:v>6.55005100695483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5DD-4964-B6BB-44604A6E74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2493464"/>
        <c:axId val="342487232"/>
      </c:scatterChart>
      <c:valAx>
        <c:axId val="342493464"/>
        <c:scaling>
          <c:orientation val="minMax"/>
          <c:max val="8.5"/>
          <c:min val="4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pH value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87232"/>
        <c:crosses val="autoZero"/>
        <c:crossBetween val="midCat"/>
      </c:valAx>
      <c:valAx>
        <c:axId val="342487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baseline="0">
                    <a:solidFill>
                      <a:schemeClr val="tx1"/>
                    </a:solidFill>
                  </a:rPr>
                  <a:t>Manganese </a:t>
                </a:r>
                <a:r>
                  <a:rPr lang="en-US" b="1">
                    <a:solidFill>
                      <a:schemeClr val="tx1"/>
                    </a:solidFill>
                  </a:rPr>
                  <a:t>(mg kg-1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424934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1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1" i="1" dirty="0">
                <a:solidFill>
                  <a:schemeClr val="tx1"/>
                </a:solidFill>
              </a:rPr>
              <a:t>N. </a:t>
            </a:r>
            <a:r>
              <a:rPr lang="en-US" b="1" i="1" dirty="0" err="1">
                <a:solidFill>
                  <a:schemeClr val="tx1"/>
                </a:solidFill>
              </a:rPr>
              <a:t>caerulescens</a:t>
            </a:r>
            <a:endParaRPr lang="en-US" b="1" i="1" dirty="0">
              <a:solidFill>
                <a:schemeClr val="tx1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1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iomass!$A$3</c:f>
              <c:strCache>
                <c:ptCount val="1"/>
                <c:pt idx="0">
                  <c:v>NC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880-4411-9144-68FF3182437E}"/>
              </c:ext>
            </c:extLst>
          </c:dPt>
          <c:errBars>
            <c:errBarType val="both"/>
            <c:errValType val="cust"/>
            <c:noEndCap val="0"/>
            <c:plus>
              <c:numRef>
                <c:f>biomass!$F$3</c:f>
                <c:numCache>
                  <c:formatCode>General</c:formatCode>
                  <c:ptCount val="1"/>
                  <c:pt idx="0">
                    <c:v>23.109401646179521</c:v>
                  </c:pt>
                </c:numCache>
              </c:numRef>
            </c:plus>
            <c:minus>
              <c:numRef>
                <c:f>biomass!$F$3</c:f>
                <c:numCache>
                  <c:formatCode>General</c:formatCode>
                  <c:ptCount val="1"/>
                  <c:pt idx="0">
                    <c:v>23.1094016461795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biomass!$D$3</c:f>
              <c:numCache>
                <c:formatCode>General</c:formatCode>
                <c:ptCount val="1"/>
                <c:pt idx="0">
                  <c:v>100.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880-4411-9144-68FF3182437E}"/>
            </c:ext>
          </c:extLst>
        </c:ser>
        <c:ser>
          <c:idx val="1"/>
          <c:order val="1"/>
          <c:tx>
            <c:strRef>
              <c:f>biomass!$A$9</c:f>
              <c:strCache>
                <c:ptCount val="1"/>
                <c:pt idx="0">
                  <c:v>ARN176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F$9</c:f>
                <c:numCache>
                  <c:formatCode>General</c:formatCode>
                  <c:ptCount val="1"/>
                  <c:pt idx="0">
                    <c:v>27.932557666239195</c:v>
                  </c:pt>
                </c:numCache>
              </c:numRef>
            </c:plus>
            <c:minus>
              <c:numRef>
                <c:f>biomass!$F$9</c:f>
                <c:numCache>
                  <c:formatCode>General</c:formatCode>
                  <c:ptCount val="1"/>
                  <c:pt idx="0">
                    <c:v>27.9325576662391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biomass!$D$9</c:f>
              <c:numCache>
                <c:formatCode>General</c:formatCode>
                <c:ptCount val="1"/>
                <c:pt idx="0">
                  <c:v>89.8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880-4411-9144-68FF3182437E}"/>
            </c:ext>
          </c:extLst>
        </c:ser>
        <c:ser>
          <c:idx val="2"/>
          <c:order val="2"/>
          <c:tx>
            <c:strRef>
              <c:f>biomass!$A$15</c:f>
              <c:strCache>
                <c:ptCount val="1"/>
                <c:pt idx="0">
                  <c:v>1.5R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F$15</c:f>
                <c:numCache>
                  <c:formatCode>General</c:formatCode>
                  <c:ptCount val="1"/>
                  <c:pt idx="0">
                    <c:v>20.070985138862628</c:v>
                  </c:pt>
                </c:numCache>
              </c:numRef>
            </c:plus>
            <c:minus>
              <c:numRef>
                <c:f>biomass!$F$15</c:f>
                <c:numCache>
                  <c:formatCode>General</c:formatCode>
                  <c:ptCount val="1"/>
                  <c:pt idx="0">
                    <c:v>20.0709851388626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biomass!$D$15</c:f>
              <c:numCache>
                <c:formatCode>General</c:formatCode>
                <c:ptCount val="1"/>
                <c:pt idx="0">
                  <c:v>98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880-4411-9144-68FF3182437E}"/>
            </c:ext>
          </c:extLst>
        </c:ser>
        <c:ser>
          <c:idx val="3"/>
          <c:order val="3"/>
          <c:tx>
            <c:strRef>
              <c:f>biomass!$A$21</c:f>
              <c:strCache>
                <c:ptCount val="1"/>
                <c:pt idx="0">
                  <c:v>SA35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iomass!$F$21</c:f>
                <c:numCache>
                  <c:formatCode>General</c:formatCode>
                  <c:ptCount val="1"/>
                  <c:pt idx="0">
                    <c:v>31.172281134224225</c:v>
                  </c:pt>
                </c:numCache>
              </c:numRef>
            </c:plus>
            <c:minus>
              <c:numRef>
                <c:f>biomass!$F$21</c:f>
                <c:numCache>
                  <c:formatCode>General</c:formatCode>
                  <c:ptCount val="1"/>
                  <c:pt idx="0">
                    <c:v>31.1722811342242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biomass!$D$21</c:f>
              <c:numCache>
                <c:formatCode>General</c:formatCode>
                <c:ptCount val="1"/>
                <c:pt idx="0">
                  <c:v>103.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880-4411-9144-68FF318243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5844008"/>
        <c:axId val="555846632"/>
      </c:barChart>
      <c:catAx>
        <c:axId val="5558440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555846632"/>
        <c:crosses val="autoZero"/>
        <c:auto val="1"/>
        <c:lblAlgn val="ctr"/>
        <c:lblOffset val="100"/>
        <c:noMultiLvlLbl val="0"/>
      </c:catAx>
      <c:valAx>
        <c:axId val="555846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dry weight (mg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55844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55F8-1D02-4417-9241-55C834FD9970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B441-5312-499D-93C3-6E37886527FA}" type="slidenum">
              <a:rPr lang="it-IT" smtClean="0"/>
              <a:t>‹Nr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4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16632" y="119484"/>
            <a:ext cx="2736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1</a:t>
            </a:r>
            <a:r>
              <a:rPr lang="it-IT" dirty="0"/>
              <a:t>: 16s </a:t>
            </a:r>
            <a:r>
              <a:rPr lang="it-IT" dirty="0" err="1"/>
              <a:t>rRNA</a:t>
            </a:r>
            <a:endParaRPr lang="it-IT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3E3E394-621C-4827-89CB-FF13733C9D7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3608"/>
            <a:ext cx="6858000" cy="5822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86174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o 19"/>
          <p:cNvGrpSpPr/>
          <p:nvPr/>
        </p:nvGrpSpPr>
        <p:grpSpPr>
          <a:xfrm>
            <a:off x="38812" y="739534"/>
            <a:ext cx="6815904" cy="7200801"/>
            <a:chOff x="38812" y="739534"/>
            <a:chExt cx="6815904" cy="7200801"/>
          </a:xfrm>
        </p:grpSpPr>
        <p:grpSp>
          <p:nvGrpSpPr>
            <p:cNvPr id="14" name="Gruppo 13"/>
            <p:cNvGrpSpPr/>
            <p:nvPr/>
          </p:nvGrpSpPr>
          <p:grpSpPr>
            <a:xfrm>
              <a:off x="38812" y="742912"/>
              <a:ext cx="6815904" cy="7197423"/>
              <a:chOff x="38812" y="742912"/>
              <a:chExt cx="6815904" cy="7197423"/>
            </a:xfrm>
          </p:grpSpPr>
          <p:grpSp>
            <p:nvGrpSpPr>
              <p:cNvPr id="12" name="Gruppo 11"/>
              <p:cNvGrpSpPr/>
              <p:nvPr/>
            </p:nvGrpSpPr>
            <p:grpSpPr>
              <a:xfrm>
                <a:off x="38812" y="807080"/>
                <a:ext cx="6815904" cy="7133255"/>
                <a:chOff x="38812" y="807080"/>
                <a:chExt cx="6815904" cy="7133255"/>
              </a:xfrm>
            </p:grpSpPr>
            <p:grpSp>
              <p:nvGrpSpPr>
                <p:cNvPr id="9" name="Gruppo 8"/>
                <p:cNvGrpSpPr/>
                <p:nvPr/>
              </p:nvGrpSpPr>
              <p:grpSpPr>
                <a:xfrm>
                  <a:off x="93900" y="807080"/>
                  <a:ext cx="6760816" cy="2186508"/>
                  <a:chOff x="-61740" y="904355"/>
                  <a:chExt cx="6760816" cy="2186508"/>
                </a:xfrm>
              </p:grpSpPr>
              <p:graphicFrame>
                <p:nvGraphicFramePr>
                  <p:cNvPr id="3" name="Grafico 2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019276297"/>
                      </p:ext>
                    </p:extLst>
                  </p:nvPr>
                </p:nvGraphicFramePr>
                <p:xfrm>
                  <a:off x="-61740" y="904355"/>
                  <a:ext cx="3486100" cy="218650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graphicFrame>
                <p:nvGraphicFramePr>
                  <p:cNvPr id="4" name="Grafico 3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182598959"/>
                      </p:ext>
                    </p:extLst>
                  </p:nvPr>
                </p:nvGraphicFramePr>
                <p:xfrm>
                  <a:off x="3212976" y="904355"/>
                  <a:ext cx="3486100" cy="218650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</p:grpSp>
            <p:grpSp>
              <p:nvGrpSpPr>
                <p:cNvPr id="10" name="Gruppo 9"/>
                <p:cNvGrpSpPr/>
                <p:nvPr/>
              </p:nvGrpSpPr>
              <p:grpSpPr>
                <a:xfrm>
                  <a:off x="38812" y="3092930"/>
                  <a:ext cx="6765577" cy="2186508"/>
                  <a:chOff x="-1290637" y="3757092"/>
                  <a:chExt cx="6765577" cy="2186508"/>
                </a:xfrm>
              </p:grpSpPr>
              <p:graphicFrame>
                <p:nvGraphicFramePr>
                  <p:cNvPr id="5" name="Grafico 4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945593923"/>
                      </p:ext>
                    </p:extLst>
                  </p:nvPr>
                </p:nvGraphicFramePr>
                <p:xfrm>
                  <a:off x="-1290637" y="3757092"/>
                  <a:ext cx="3486100" cy="218650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  <p:graphicFrame>
                <p:nvGraphicFramePr>
                  <p:cNvPr id="6" name="Grafico 5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574951729"/>
                      </p:ext>
                    </p:extLst>
                  </p:nvPr>
                </p:nvGraphicFramePr>
                <p:xfrm>
                  <a:off x="1988840" y="3757092"/>
                  <a:ext cx="3486100" cy="218650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5"/>
                  </a:graphicData>
                </a:graphic>
              </p:graphicFrame>
            </p:grpSp>
            <p:grpSp>
              <p:nvGrpSpPr>
                <p:cNvPr id="11" name="Gruppo 10"/>
                <p:cNvGrpSpPr/>
                <p:nvPr/>
              </p:nvGrpSpPr>
              <p:grpSpPr>
                <a:xfrm>
                  <a:off x="139262" y="5439427"/>
                  <a:ext cx="6680013" cy="2500908"/>
                  <a:chOff x="-1290637" y="6300192"/>
                  <a:chExt cx="6687851" cy="2500908"/>
                </a:xfrm>
              </p:grpSpPr>
              <p:graphicFrame>
                <p:nvGraphicFramePr>
                  <p:cNvPr id="7" name="Grafico 6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765200678"/>
                      </p:ext>
                    </p:extLst>
                  </p:nvPr>
                </p:nvGraphicFramePr>
                <p:xfrm>
                  <a:off x="-1290637" y="6300192"/>
                  <a:ext cx="3389623" cy="250090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graphicFrame>
                <p:nvGraphicFramePr>
                  <p:cNvPr id="8" name="Grafico 7"/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781214722"/>
                      </p:ext>
                    </p:extLst>
                  </p:nvPr>
                </p:nvGraphicFramePr>
                <p:xfrm>
                  <a:off x="1911114" y="6300192"/>
                  <a:ext cx="3486100" cy="2500908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"/>
                  </a:graphicData>
                </a:graphic>
              </p:graphicFrame>
            </p:grpSp>
          </p:grpSp>
          <p:sp>
            <p:nvSpPr>
              <p:cNvPr id="13" name="CasellaDiTesto 12"/>
              <p:cNvSpPr txBox="1"/>
              <p:nvPr/>
            </p:nvSpPr>
            <p:spPr>
              <a:xfrm>
                <a:off x="139262" y="742912"/>
                <a:ext cx="19339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dirty="0"/>
                  <a:t>A</a:t>
                </a:r>
              </a:p>
            </p:txBody>
          </p:sp>
        </p:grpSp>
        <p:sp>
          <p:nvSpPr>
            <p:cNvPr id="15" name="CasellaDiTesto 14"/>
            <p:cNvSpPr txBox="1"/>
            <p:nvPr/>
          </p:nvSpPr>
          <p:spPr>
            <a:xfrm>
              <a:off x="147284" y="2883732"/>
              <a:ext cx="1933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C</a:t>
              </a: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156556" y="5274948"/>
              <a:ext cx="1933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E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3451630" y="5284240"/>
              <a:ext cx="1933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F</a:t>
              </a:r>
            </a:p>
          </p:txBody>
        </p:sp>
        <p:sp>
          <p:nvSpPr>
            <p:cNvPr id="18" name="CasellaDiTesto 17"/>
            <p:cNvSpPr txBox="1"/>
            <p:nvPr/>
          </p:nvSpPr>
          <p:spPr>
            <a:xfrm>
              <a:off x="3445042" y="2883732"/>
              <a:ext cx="1933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D</a:t>
              </a: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3452882" y="739534"/>
              <a:ext cx="1933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B</a:t>
              </a:r>
            </a:p>
          </p:txBody>
        </p:sp>
      </p:grpSp>
      <p:sp>
        <p:nvSpPr>
          <p:cNvPr id="21" name="CasellaDiTesto 20"/>
          <p:cNvSpPr txBox="1"/>
          <p:nvPr/>
        </p:nvSpPr>
        <p:spPr>
          <a:xfrm>
            <a:off x="332655" y="98212"/>
            <a:ext cx="6471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10</a:t>
            </a:r>
            <a:r>
              <a:rPr lang="it-IT" dirty="0"/>
              <a:t>: Heavy metal mobilization assay, pH adjusted medium</a:t>
            </a:r>
          </a:p>
        </p:txBody>
      </p:sp>
    </p:spTree>
    <p:extLst>
      <p:ext uri="{BB962C8B-B14F-4D97-AF65-F5344CB8AC3E}">
        <p14:creationId xmlns:p14="http://schemas.microsoft.com/office/powerpoint/2010/main" val="30685494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938FF0BE-7498-43DD-B732-8328D93BDE48}"/>
              </a:ext>
            </a:extLst>
          </p:cNvPr>
          <p:cNvSpPr txBox="1"/>
          <p:nvPr/>
        </p:nvSpPr>
        <p:spPr>
          <a:xfrm>
            <a:off x="209178" y="-28296"/>
            <a:ext cx="6439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11</a:t>
            </a:r>
            <a:r>
              <a:rPr lang="it-IT" dirty="0"/>
              <a:t>: Dry </a:t>
            </a:r>
            <a:r>
              <a:rPr lang="it-IT" dirty="0" err="1"/>
              <a:t>biomass</a:t>
            </a:r>
            <a:r>
              <a:rPr lang="it-IT" dirty="0"/>
              <a:t> of </a:t>
            </a:r>
            <a:r>
              <a:rPr lang="it-IT" i="1" dirty="0"/>
              <a:t>B. </a:t>
            </a:r>
            <a:r>
              <a:rPr lang="it-IT" i="1" dirty="0" err="1"/>
              <a:t>napus</a:t>
            </a:r>
            <a:r>
              <a:rPr lang="it-IT" i="1" dirty="0"/>
              <a:t> </a:t>
            </a:r>
            <a:r>
              <a:rPr lang="it-IT" dirty="0"/>
              <a:t>and </a:t>
            </a:r>
            <a:r>
              <a:rPr lang="it-IT" i="1" dirty="0"/>
              <a:t>N. </a:t>
            </a:r>
            <a:r>
              <a:rPr lang="it-IT" i="1" dirty="0" err="1"/>
              <a:t>caerulescens</a:t>
            </a:r>
            <a:r>
              <a:rPr lang="it-IT" i="1" dirty="0"/>
              <a:t> </a:t>
            </a:r>
            <a:endParaRPr lang="it-IT" dirty="0"/>
          </a:p>
        </p:txBody>
      </p:sp>
      <p:grpSp>
        <p:nvGrpSpPr>
          <p:cNvPr id="9" name="Gruppo 7">
            <a:extLst>
              <a:ext uri="{FF2B5EF4-FFF2-40B4-BE49-F238E27FC236}">
                <a16:creationId xmlns:a16="http://schemas.microsoft.com/office/drawing/2014/main" id="{9A0E1E23-6D7A-47FB-BA25-FBB1363B7419}"/>
              </a:ext>
            </a:extLst>
          </p:cNvPr>
          <p:cNvGrpSpPr/>
          <p:nvPr/>
        </p:nvGrpSpPr>
        <p:grpSpPr>
          <a:xfrm>
            <a:off x="790492" y="1115616"/>
            <a:ext cx="4702998" cy="5800102"/>
            <a:chOff x="657322" y="899592"/>
            <a:chExt cx="4702998" cy="5800102"/>
          </a:xfrm>
        </p:grpSpPr>
        <p:graphicFrame>
          <p:nvGraphicFramePr>
            <p:cNvPr id="14" name="Grafico 3">
              <a:extLst>
                <a:ext uri="{FF2B5EF4-FFF2-40B4-BE49-F238E27FC236}">
                  <a16:creationId xmlns:a16="http://schemas.microsoft.com/office/drawing/2014/main" id="{B02BE00F-2F01-4574-B695-2330BD5E0AC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32301760"/>
                </p:ext>
              </p:extLst>
            </p:nvPr>
          </p:nvGraphicFramePr>
          <p:xfrm>
            <a:off x="820977" y="3956494"/>
            <a:ext cx="4539343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1" name="CasellaDiTesto 5">
              <a:extLst>
                <a:ext uri="{FF2B5EF4-FFF2-40B4-BE49-F238E27FC236}">
                  <a16:creationId xmlns:a16="http://schemas.microsoft.com/office/drawing/2014/main" id="{94686370-1318-460F-A89B-FE2AE67045B8}"/>
                </a:ext>
              </a:extLst>
            </p:cNvPr>
            <p:cNvSpPr txBox="1"/>
            <p:nvPr/>
          </p:nvSpPr>
          <p:spPr>
            <a:xfrm>
              <a:off x="661298" y="899592"/>
              <a:ext cx="3273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b="1" dirty="0"/>
                <a:t>A</a:t>
              </a:r>
            </a:p>
          </p:txBody>
        </p:sp>
        <p:sp>
          <p:nvSpPr>
            <p:cNvPr id="12" name="CasellaDiTesto 6">
              <a:extLst>
                <a:ext uri="{FF2B5EF4-FFF2-40B4-BE49-F238E27FC236}">
                  <a16:creationId xmlns:a16="http://schemas.microsoft.com/office/drawing/2014/main" id="{BD741B4A-AA9A-4398-9C29-3D5C95A80FB3}"/>
                </a:ext>
              </a:extLst>
            </p:cNvPr>
            <p:cNvSpPr txBox="1"/>
            <p:nvPr/>
          </p:nvSpPr>
          <p:spPr>
            <a:xfrm>
              <a:off x="657322" y="3923928"/>
              <a:ext cx="32730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b="1" dirty="0"/>
                <a:t>B</a:t>
              </a:r>
            </a:p>
          </p:txBody>
        </p:sp>
      </p:grpSp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02EA30FE-0D33-4E7E-8981-1A8FC06658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0016674"/>
              </p:ext>
            </p:extLst>
          </p:nvPr>
        </p:nvGraphicFramePr>
        <p:xfrm>
          <a:off x="908720" y="11156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3069505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65162" y="-28296"/>
            <a:ext cx="70362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12</a:t>
            </a:r>
            <a:r>
              <a:rPr lang="it-IT" dirty="0"/>
              <a:t>: Metal </a:t>
            </a:r>
            <a:r>
              <a:rPr lang="it-IT" dirty="0" err="1"/>
              <a:t>concentration</a:t>
            </a:r>
            <a:r>
              <a:rPr lang="it-IT" dirty="0"/>
              <a:t> in </a:t>
            </a:r>
            <a:r>
              <a:rPr lang="it-IT" i="1" dirty="0"/>
              <a:t>B. </a:t>
            </a:r>
            <a:r>
              <a:rPr lang="it-IT" i="1" dirty="0" err="1"/>
              <a:t>napus</a:t>
            </a:r>
            <a:r>
              <a:rPr lang="it-IT" i="1" dirty="0"/>
              <a:t> </a:t>
            </a:r>
            <a:r>
              <a:rPr lang="it-IT" dirty="0"/>
              <a:t>and </a:t>
            </a:r>
            <a:r>
              <a:rPr lang="it-IT" i="1" dirty="0"/>
              <a:t>N. </a:t>
            </a:r>
            <a:r>
              <a:rPr lang="it-IT" i="1" dirty="0" err="1"/>
              <a:t>caerulescens</a:t>
            </a:r>
            <a:r>
              <a:rPr lang="it-IT" i="1" dirty="0"/>
              <a:t> </a:t>
            </a:r>
            <a:r>
              <a:rPr lang="it-IT" dirty="0" err="1"/>
              <a:t>shoots</a:t>
            </a:r>
            <a:endParaRPr lang="it-IT" dirty="0"/>
          </a:p>
        </p:txBody>
      </p:sp>
      <p:grpSp>
        <p:nvGrpSpPr>
          <p:cNvPr id="34" name="Group 33"/>
          <p:cNvGrpSpPr/>
          <p:nvPr/>
        </p:nvGrpSpPr>
        <p:grpSpPr>
          <a:xfrm>
            <a:off x="1106995" y="341036"/>
            <a:ext cx="4662265" cy="8371208"/>
            <a:chOff x="1106995" y="341036"/>
            <a:chExt cx="4662265" cy="8371208"/>
          </a:xfrm>
        </p:grpSpPr>
        <p:grpSp>
          <p:nvGrpSpPr>
            <p:cNvPr id="27" name="Gruppo 26"/>
            <p:cNvGrpSpPr/>
            <p:nvPr/>
          </p:nvGrpSpPr>
          <p:grpSpPr>
            <a:xfrm>
              <a:off x="1106995" y="341036"/>
              <a:ext cx="4644009" cy="5502490"/>
              <a:chOff x="1124743" y="755410"/>
              <a:chExt cx="4644009" cy="5502490"/>
            </a:xfrm>
          </p:grpSpPr>
          <p:grpSp>
            <p:nvGrpSpPr>
              <p:cNvPr id="24" name="Gruppo 23"/>
              <p:cNvGrpSpPr/>
              <p:nvPr/>
            </p:nvGrpSpPr>
            <p:grpSpPr>
              <a:xfrm>
                <a:off x="1124743" y="936476"/>
                <a:ext cx="4644009" cy="5321424"/>
                <a:chOff x="1124743" y="936476"/>
                <a:chExt cx="4644009" cy="5321424"/>
              </a:xfrm>
            </p:grpSpPr>
            <p:grpSp>
              <p:nvGrpSpPr>
                <p:cNvPr id="22" name="Gruppo 21"/>
                <p:cNvGrpSpPr/>
                <p:nvPr/>
              </p:nvGrpSpPr>
              <p:grpSpPr>
                <a:xfrm>
                  <a:off x="1124743" y="936476"/>
                  <a:ext cx="4644009" cy="5321424"/>
                  <a:chOff x="1124743" y="936476"/>
                  <a:chExt cx="4644009" cy="5321424"/>
                </a:xfrm>
              </p:grpSpPr>
              <p:grpSp>
                <p:nvGrpSpPr>
                  <p:cNvPr id="19" name="Gruppo 18"/>
                  <p:cNvGrpSpPr/>
                  <p:nvPr/>
                </p:nvGrpSpPr>
                <p:grpSpPr>
                  <a:xfrm>
                    <a:off x="1124743" y="936476"/>
                    <a:ext cx="4644009" cy="5321424"/>
                    <a:chOff x="1124743" y="936476"/>
                    <a:chExt cx="4644009" cy="5321424"/>
                  </a:xfrm>
                </p:grpSpPr>
                <p:grpSp>
                  <p:nvGrpSpPr>
                    <p:cNvPr id="17" name="Gruppo 16"/>
                    <p:cNvGrpSpPr/>
                    <p:nvPr/>
                  </p:nvGrpSpPr>
                  <p:grpSpPr>
                    <a:xfrm>
                      <a:off x="1124743" y="936476"/>
                      <a:ext cx="4644009" cy="5321424"/>
                      <a:chOff x="1124743" y="936476"/>
                      <a:chExt cx="4644009" cy="5321424"/>
                    </a:xfrm>
                  </p:grpSpPr>
                  <p:grpSp>
                    <p:nvGrpSpPr>
                      <p:cNvPr id="15" name="Gruppo 14"/>
                      <p:cNvGrpSpPr/>
                      <p:nvPr/>
                    </p:nvGrpSpPr>
                    <p:grpSpPr>
                      <a:xfrm>
                        <a:off x="1124743" y="936476"/>
                        <a:ext cx="4644009" cy="5321424"/>
                        <a:chOff x="1124743" y="936476"/>
                        <a:chExt cx="4644009" cy="5321424"/>
                      </a:xfrm>
                    </p:grpSpPr>
                    <p:grpSp>
                      <p:nvGrpSpPr>
                        <p:cNvPr id="13" name="Gruppo 12"/>
                        <p:cNvGrpSpPr/>
                        <p:nvPr/>
                      </p:nvGrpSpPr>
                      <p:grpSpPr>
                        <a:xfrm>
                          <a:off x="1124743" y="936476"/>
                          <a:ext cx="4644009" cy="5321424"/>
                          <a:chOff x="1124743" y="936476"/>
                          <a:chExt cx="4644009" cy="5321424"/>
                        </a:xfrm>
                      </p:grpSpPr>
                      <p:grpSp>
                        <p:nvGrpSpPr>
                          <p:cNvPr id="11" name="Gruppo 10"/>
                          <p:cNvGrpSpPr/>
                          <p:nvPr/>
                        </p:nvGrpSpPr>
                        <p:grpSpPr>
                          <a:xfrm>
                            <a:off x="1124743" y="936476"/>
                            <a:ext cx="4644009" cy="5321424"/>
                            <a:chOff x="1124743" y="936476"/>
                            <a:chExt cx="4644009" cy="5321424"/>
                          </a:xfrm>
                        </p:grpSpPr>
                        <p:grpSp>
                          <p:nvGrpSpPr>
                            <p:cNvPr id="9" name="Gruppo 8"/>
                            <p:cNvGrpSpPr/>
                            <p:nvPr/>
                          </p:nvGrpSpPr>
                          <p:grpSpPr>
                            <a:xfrm>
                              <a:off x="1124743" y="936476"/>
                              <a:ext cx="4644009" cy="5321424"/>
                              <a:chOff x="1124743" y="936476"/>
                              <a:chExt cx="4644009" cy="5321424"/>
                            </a:xfrm>
                          </p:grpSpPr>
                          <p:grpSp>
                            <p:nvGrpSpPr>
                              <p:cNvPr id="5" name="Gruppo 4"/>
                              <p:cNvGrpSpPr/>
                              <p:nvPr/>
                            </p:nvGrpSpPr>
                            <p:grpSpPr>
                              <a:xfrm>
                                <a:off x="1143000" y="936476"/>
                                <a:ext cx="4625752" cy="5321424"/>
                                <a:chOff x="1143000" y="936476"/>
                                <a:chExt cx="4625752" cy="5321424"/>
                              </a:xfrm>
                            </p:grpSpPr>
                            <p:graphicFrame>
                              <p:nvGraphicFramePr>
                                <p:cNvPr id="3" name="Grafico 2"/>
                                <p:cNvGraphicFramePr>
                                  <a:graphicFrameLocks/>
                                </p:cNvGraphicFramePr>
                                <p:nvPr/>
                              </p:nvGraphicFramePr>
                              <p:xfrm>
                                <a:off x="1143000" y="936476"/>
                                <a:ext cx="4572000" cy="2552700"/>
                              </p:xfrm>
                              <a:graphic>
                                <a:graphicData uri="http://schemas.openxmlformats.org/drawingml/2006/chart">
                                  <c:chart xmlns:c="http://schemas.openxmlformats.org/drawingml/2006/chart" xmlns:r="http://schemas.openxmlformats.org/officeDocument/2006/relationships" r:id="rId2"/>
                                </a:graphicData>
                              </a:graphic>
                            </p:graphicFrame>
                            <p:graphicFrame>
                              <p:nvGraphicFramePr>
                                <p:cNvPr id="4" name="Grafico 3"/>
                                <p:cNvGraphicFramePr>
                                  <a:graphicFrameLocks/>
                                </p:cNvGraphicFramePr>
                                <p:nvPr/>
                              </p:nvGraphicFramePr>
                              <p:xfrm>
                                <a:off x="1196752" y="3489176"/>
                                <a:ext cx="4572000" cy="2768724"/>
                              </p:xfrm>
                              <a:graphic>
                                <a:graphicData uri="http://schemas.openxmlformats.org/drawingml/2006/chart">
                                  <c:chart xmlns:c="http://schemas.openxmlformats.org/drawingml/2006/chart" xmlns:r="http://schemas.openxmlformats.org/officeDocument/2006/relationships" r:id="rId3"/>
                                </a:graphicData>
                              </a:graphic>
                            </p:graphicFrame>
                          </p:grpSp>
                          <p:grpSp>
                            <p:nvGrpSpPr>
                              <p:cNvPr id="8" name="Gruppo 7"/>
                              <p:cNvGrpSpPr/>
                              <p:nvPr/>
                            </p:nvGrpSpPr>
                            <p:grpSpPr>
                              <a:xfrm>
                                <a:off x="1124743" y="971600"/>
                                <a:ext cx="576065" cy="3186374"/>
                                <a:chOff x="1124743" y="971600"/>
                                <a:chExt cx="576065" cy="3186374"/>
                              </a:xfrm>
                            </p:grpSpPr>
                            <p:sp>
                              <p:nvSpPr>
                                <p:cNvPr id="6" name="CasellaDiTesto 5"/>
                                <p:cNvSpPr txBox="1"/>
                                <p:nvPr/>
                              </p:nvSpPr>
                              <p:spPr>
                                <a:xfrm>
                                  <a:off x="1124743" y="971600"/>
                                  <a:ext cx="576065" cy="33855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it-IT" sz="1600" b="1" dirty="0"/>
                                    <a:t>A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7" name="CasellaDiTesto 6"/>
                                <p:cNvSpPr txBox="1"/>
                                <p:nvPr/>
                              </p:nvSpPr>
                              <p:spPr>
                                <a:xfrm>
                                  <a:off x="1124743" y="3819420"/>
                                  <a:ext cx="576065" cy="338554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r>
                                    <a:rPr lang="it-IT" sz="1600" b="1" dirty="0"/>
                                    <a:t>B</a:t>
                                  </a:r>
                                </a:p>
                              </p:txBody>
                            </p:sp>
                          </p:grpSp>
                        </p:grpSp>
                        <p:sp>
                          <p:nvSpPr>
                            <p:cNvPr id="10" name="CasellaDiTesto 9"/>
                            <p:cNvSpPr txBox="1"/>
                            <p:nvPr/>
                          </p:nvSpPr>
                          <p:spPr>
                            <a:xfrm>
                              <a:off x="5139774" y="1554037"/>
                              <a:ext cx="216024" cy="26161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it-IT" sz="1100" dirty="0"/>
                                <a:t>*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12" name="CasellaDiTesto 11"/>
                          <p:cNvSpPr txBox="1"/>
                          <p:nvPr/>
                        </p:nvSpPr>
                        <p:spPr>
                          <a:xfrm>
                            <a:off x="2014967" y="4220708"/>
                            <a:ext cx="216024" cy="26161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it-IT" sz="1100" dirty="0"/>
                              <a:t>*</a:t>
                            </a:r>
                          </a:p>
                        </p:txBody>
                      </p:sp>
                    </p:grpSp>
                    <p:sp>
                      <p:nvSpPr>
                        <p:cNvPr id="14" name="CasellaDiTesto 13"/>
                        <p:cNvSpPr txBox="1"/>
                        <p:nvPr/>
                      </p:nvSpPr>
                      <p:spPr>
                        <a:xfrm>
                          <a:off x="2737383" y="5316166"/>
                          <a:ext cx="360040" cy="261610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it-IT" sz="1100" dirty="0"/>
                            <a:t>**</a:t>
                          </a:r>
                        </a:p>
                      </p:txBody>
                    </p:sp>
                  </p:grpSp>
                  <p:sp>
                    <p:nvSpPr>
                      <p:cNvPr id="16" name="CasellaDiTesto 15"/>
                      <p:cNvSpPr txBox="1"/>
                      <p:nvPr/>
                    </p:nvSpPr>
                    <p:spPr>
                      <a:xfrm>
                        <a:off x="2881074" y="5231117"/>
                        <a:ext cx="360040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it-IT" sz="1100" dirty="0"/>
                          <a:t>**</a:t>
                        </a:r>
                      </a:p>
                    </p:txBody>
                  </p:sp>
                </p:grpSp>
                <p:sp>
                  <p:nvSpPr>
                    <p:cNvPr id="18" name="CasellaDiTesto 17"/>
                    <p:cNvSpPr txBox="1"/>
                    <p:nvPr/>
                  </p:nvSpPr>
                  <p:spPr>
                    <a:xfrm>
                      <a:off x="3014370" y="5274662"/>
                      <a:ext cx="360040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sz="1100" dirty="0"/>
                        <a:t>**</a:t>
                      </a:r>
                    </a:p>
                  </p:txBody>
                </p:sp>
              </p:grpSp>
              <p:sp>
                <p:nvSpPr>
                  <p:cNvPr id="20" name="CasellaDiTesto 19"/>
                  <p:cNvSpPr txBox="1"/>
                  <p:nvPr/>
                </p:nvSpPr>
                <p:spPr>
                  <a:xfrm>
                    <a:off x="3501008" y="5296427"/>
                    <a:ext cx="36004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100" dirty="0"/>
                      <a:t>**</a:t>
                    </a:r>
                  </a:p>
                </p:txBody>
              </p:sp>
              <p:sp>
                <p:nvSpPr>
                  <p:cNvPr id="21" name="CasellaDiTesto 20"/>
                  <p:cNvSpPr txBox="1"/>
                  <p:nvPr/>
                </p:nvSpPr>
                <p:spPr>
                  <a:xfrm>
                    <a:off x="3780331" y="5248535"/>
                    <a:ext cx="360040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100" dirty="0"/>
                      <a:t>**</a:t>
                    </a:r>
                  </a:p>
                </p:txBody>
              </p:sp>
            </p:grpSp>
            <p:sp>
              <p:nvSpPr>
                <p:cNvPr id="23" name="CasellaDiTesto 22"/>
                <p:cNvSpPr txBox="1"/>
                <p:nvPr/>
              </p:nvSpPr>
              <p:spPr>
                <a:xfrm>
                  <a:off x="5021885" y="4600463"/>
                  <a:ext cx="36004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100" dirty="0"/>
                    <a:t>**</a:t>
                  </a:r>
                </a:p>
              </p:txBody>
            </p:sp>
          </p:grpSp>
          <p:sp>
            <p:nvSpPr>
              <p:cNvPr id="25" name="CasellaDiTesto 24"/>
              <p:cNvSpPr txBox="1"/>
              <p:nvPr/>
            </p:nvSpPr>
            <p:spPr>
              <a:xfrm>
                <a:off x="2852936" y="755410"/>
                <a:ext cx="163876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i="1" dirty="0"/>
                  <a:t>N. </a:t>
                </a:r>
                <a:r>
                  <a:rPr lang="en-US" sz="1400" b="1" i="1" dirty="0" err="1"/>
                  <a:t>caerulescens</a:t>
                </a:r>
                <a:r>
                  <a:rPr lang="en-US" sz="1400" b="1" dirty="0"/>
                  <a:t> </a:t>
                </a:r>
                <a:endParaRPr lang="it-IT" sz="1400" b="1" dirty="0"/>
              </a:p>
            </p:txBody>
          </p:sp>
          <p:sp>
            <p:nvSpPr>
              <p:cNvPr id="26" name="CasellaDiTesto 25"/>
              <p:cNvSpPr txBox="1"/>
              <p:nvPr/>
            </p:nvSpPr>
            <p:spPr>
              <a:xfrm>
                <a:off x="2852936" y="3679941"/>
                <a:ext cx="163876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i="1" dirty="0"/>
                  <a:t>B. </a:t>
                </a:r>
                <a:r>
                  <a:rPr lang="en-US" sz="1400" b="1" i="1" dirty="0" err="1"/>
                  <a:t>napus</a:t>
                </a:r>
                <a:endParaRPr lang="it-IT" sz="1400" b="1" dirty="0"/>
              </a:p>
            </p:txBody>
          </p:sp>
        </p:grpSp>
        <p:grpSp>
          <p:nvGrpSpPr>
            <p:cNvPr id="28" name="Gruppo 6"/>
            <p:cNvGrpSpPr/>
            <p:nvPr/>
          </p:nvGrpSpPr>
          <p:grpSpPr>
            <a:xfrm>
              <a:off x="1197260" y="5969044"/>
              <a:ext cx="4572000" cy="2743200"/>
              <a:chOff x="800708" y="1187624"/>
              <a:chExt cx="4572000" cy="2743200"/>
            </a:xfrm>
          </p:grpSpPr>
          <p:grpSp>
            <p:nvGrpSpPr>
              <p:cNvPr id="29" name="Gruppo 4"/>
              <p:cNvGrpSpPr/>
              <p:nvPr/>
            </p:nvGrpSpPr>
            <p:grpSpPr>
              <a:xfrm>
                <a:off x="800708" y="1187624"/>
                <a:ext cx="4572000" cy="2743200"/>
                <a:chOff x="800708" y="1187624"/>
                <a:chExt cx="4572000" cy="2743200"/>
              </a:xfrm>
            </p:grpSpPr>
            <p:graphicFrame>
              <p:nvGraphicFramePr>
                <p:cNvPr id="31" name="Grafico 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7017474"/>
                    </p:ext>
                  </p:extLst>
                </p:nvPr>
              </p:nvGraphicFramePr>
              <p:xfrm>
                <a:off x="800708" y="1187624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32" name="CasellaDiTesto 3"/>
                <p:cNvSpPr txBox="1"/>
                <p:nvPr/>
              </p:nvSpPr>
              <p:spPr>
                <a:xfrm>
                  <a:off x="2422767" y="2743749"/>
                  <a:ext cx="1190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200" dirty="0"/>
                    <a:t>*</a:t>
                  </a:r>
                </a:p>
              </p:txBody>
            </p:sp>
          </p:grpSp>
          <p:sp>
            <p:nvSpPr>
              <p:cNvPr id="30" name="CasellaDiTesto 5"/>
              <p:cNvSpPr txBox="1"/>
              <p:nvPr/>
            </p:nvSpPr>
            <p:spPr>
              <a:xfrm>
                <a:off x="3989818" y="1709098"/>
                <a:ext cx="14401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/>
                  <a:t>*</a:t>
                </a:r>
              </a:p>
            </p:txBody>
          </p:sp>
        </p:grpSp>
        <p:sp>
          <p:nvSpPr>
            <p:cNvPr id="33" name="CasellaDiTesto 6"/>
            <p:cNvSpPr txBox="1"/>
            <p:nvPr/>
          </p:nvSpPr>
          <p:spPr>
            <a:xfrm>
              <a:off x="1126045" y="5969044"/>
              <a:ext cx="5760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600" b="1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960338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97919AB1-6B64-4AE4-AF80-A16B5800F10A}"/>
              </a:ext>
            </a:extLst>
          </p:cNvPr>
          <p:cNvSpPr txBox="1"/>
          <p:nvPr/>
        </p:nvSpPr>
        <p:spPr>
          <a:xfrm>
            <a:off x="209178" y="-28296"/>
            <a:ext cx="6439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13</a:t>
            </a:r>
            <a:r>
              <a:rPr lang="it-IT" dirty="0"/>
              <a:t>: Metal </a:t>
            </a:r>
            <a:r>
              <a:rPr lang="it-IT" dirty="0" err="1"/>
              <a:t>concentration</a:t>
            </a:r>
            <a:r>
              <a:rPr lang="it-IT" dirty="0"/>
              <a:t> in </a:t>
            </a:r>
            <a:r>
              <a:rPr lang="it-IT" i="1" dirty="0"/>
              <a:t>B. </a:t>
            </a:r>
            <a:r>
              <a:rPr lang="it-IT" i="1" dirty="0" err="1"/>
              <a:t>napus</a:t>
            </a:r>
            <a:r>
              <a:rPr lang="it-IT" dirty="0"/>
              <a:t> roots</a:t>
            </a:r>
          </a:p>
        </p:txBody>
      </p:sp>
      <p:graphicFrame>
        <p:nvGraphicFramePr>
          <p:cNvPr id="3" name="Grafico 7">
            <a:extLst>
              <a:ext uri="{FF2B5EF4-FFF2-40B4-BE49-F238E27FC236}">
                <a16:creationId xmlns:a16="http://schemas.microsoft.com/office/drawing/2014/main" id="{00000000-0008-0000-04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8002258"/>
              </p:ext>
            </p:extLst>
          </p:nvPr>
        </p:nvGraphicFramePr>
        <p:xfrm>
          <a:off x="58291" y="755576"/>
          <a:ext cx="6590531" cy="39751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687369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16632" y="11948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</a:t>
            </a:r>
            <a:r>
              <a:rPr lang="en-US" dirty="0"/>
              <a:t>: Pan-genome size</a:t>
            </a:r>
          </a:p>
        </p:txBody>
      </p:sp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2"/>
          <a:srcRect l="16603" t="12422" r="38015" b="6861"/>
          <a:stretch/>
        </p:blipFill>
        <p:spPr>
          <a:xfrm>
            <a:off x="1093210" y="1043608"/>
            <a:ext cx="4133304" cy="41332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350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372402" y="395536"/>
            <a:ext cx="5928594" cy="8525867"/>
            <a:chOff x="372402" y="395536"/>
            <a:chExt cx="5928594" cy="8525867"/>
          </a:xfrm>
        </p:grpSpPr>
        <p:grpSp>
          <p:nvGrpSpPr>
            <p:cNvPr id="15" name="Group 14"/>
            <p:cNvGrpSpPr/>
            <p:nvPr/>
          </p:nvGrpSpPr>
          <p:grpSpPr>
            <a:xfrm>
              <a:off x="422417" y="395536"/>
              <a:ext cx="5878579" cy="8525867"/>
              <a:chOff x="422417" y="395536"/>
              <a:chExt cx="5878579" cy="8525867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422417" y="395536"/>
                <a:ext cx="5878579" cy="8525867"/>
                <a:chOff x="422417" y="395536"/>
                <a:chExt cx="5878579" cy="8525867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422417" y="395536"/>
                  <a:ext cx="5833114" cy="6634028"/>
                  <a:chOff x="422417" y="395536"/>
                  <a:chExt cx="5833114" cy="6634028"/>
                </a:xfrm>
              </p:grpSpPr>
              <p:grpSp>
                <p:nvGrpSpPr>
                  <p:cNvPr id="8" name="Group 7">
                    <a:extLst>
                      <a:ext uri="{FF2B5EF4-FFF2-40B4-BE49-F238E27FC236}">
                        <a16:creationId xmlns:a16="http://schemas.microsoft.com/office/drawing/2014/main" id="{14C919DB-CDBA-4C6A-84F2-F3E9E316C1DA}"/>
                      </a:ext>
                    </a:extLst>
                  </p:cNvPr>
                  <p:cNvGrpSpPr/>
                  <p:nvPr/>
                </p:nvGrpSpPr>
                <p:grpSpPr>
                  <a:xfrm>
                    <a:off x="458053" y="395536"/>
                    <a:ext cx="216043" cy="6634028"/>
                    <a:chOff x="458053" y="539552"/>
                    <a:chExt cx="216043" cy="6634028"/>
                  </a:xfrm>
                </p:grpSpPr>
                <p:sp>
                  <p:nvSpPr>
                    <p:cNvPr id="166" name="CasellaDiTesto 21"/>
                    <p:cNvSpPr txBox="1"/>
                    <p:nvPr/>
                  </p:nvSpPr>
                  <p:spPr>
                    <a:xfrm>
                      <a:off x="476672" y="539552"/>
                      <a:ext cx="19742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b="1" dirty="0"/>
                        <a:t>A</a:t>
                      </a:r>
                    </a:p>
                  </p:txBody>
                </p:sp>
                <p:sp>
                  <p:nvSpPr>
                    <p:cNvPr id="167" name="CasellaDiTesto 21"/>
                    <p:cNvSpPr txBox="1"/>
                    <p:nvPr/>
                  </p:nvSpPr>
                  <p:spPr>
                    <a:xfrm>
                      <a:off x="476672" y="2699792"/>
                      <a:ext cx="19742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b="1" dirty="0"/>
                        <a:t>B</a:t>
                      </a:r>
                    </a:p>
                  </p:txBody>
                </p:sp>
                <p:sp>
                  <p:nvSpPr>
                    <p:cNvPr id="168" name="CasellaDiTesto 21"/>
                    <p:cNvSpPr txBox="1"/>
                    <p:nvPr/>
                  </p:nvSpPr>
                  <p:spPr>
                    <a:xfrm>
                      <a:off x="458053" y="4778732"/>
                      <a:ext cx="19742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b="1" dirty="0"/>
                        <a:t>C</a:t>
                      </a:r>
                    </a:p>
                  </p:txBody>
                </p:sp>
                <p:sp>
                  <p:nvSpPr>
                    <p:cNvPr id="169" name="CasellaDiTesto 21"/>
                    <p:cNvSpPr txBox="1"/>
                    <p:nvPr/>
                  </p:nvSpPr>
                  <p:spPr>
                    <a:xfrm>
                      <a:off x="458053" y="6804248"/>
                      <a:ext cx="19742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it-IT" b="1" dirty="0"/>
                        <a:t>D</a:t>
                      </a:r>
                    </a:p>
                  </p:txBody>
                </p:sp>
              </p:grpSp>
              <p:pic>
                <p:nvPicPr>
                  <p:cNvPr id="9" name="Picture 8"/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2417" y="4552753"/>
                    <a:ext cx="5833114" cy="2229373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1415" y="6660232"/>
                  <a:ext cx="5829581" cy="2261171"/>
                </a:xfrm>
                <a:prstGeom prst="rect">
                  <a:avLst/>
                </a:prstGeom>
              </p:spPr>
            </p:pic>
          </p:grpSp>
          <p:grpSp>
            <p:nvGrpSpPr>
              <p:cNvPr id="14" name="Group 13"/>
              <p:cNvGrpSpPr/>
              <p:nvPr/>
            </p:nvGrpSpPr>
            <p:grpSpPr>
              <a:xfrm>
                <a:off x="422417" y="2566093"/>
                <a:ext cx="5826048" cy="1985367"/>
                <a:chOff x="422417" y="2566093"/>
                <a:chExt cx="5826048" cy="1985367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6279"/>
                <a:stretch/>
              </p:blipFill>
              <p:spPr>
                <a:xfrm>
                  <a:off x="422417" y="2699792"/>
                  <a:ext cx="5826048" cy="1851668"/>
                </a:xfrm>
                <a:prstGeom prst="rect">
                  <a:avLst/>
                </a:prstGeom>
              </p:spPr>
            </p:pic>
            <p:pic>
              <p:nvPicPr>
                <p:cNvPr id="18" name="Picture 17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89325" b="93868"/>
                <a:stretch/>
              </p:blipFill>
              <p:spPr>
                <a:xfrm>
                  <a:off x="437744" y="2566093"/>
                  <a:ext cx="621935" cy="135632"/>
                </a:xfrm>
                <a:prstGeom prst="rect">
                  <a:avLst/>
                </a:prstGeom>
              </p:spPr>
            </p:pic>
          </p:grpSp>
        </p:grpSp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2402" y="395536"/>
              <a:ext cx="5833114" cy="2137513"/>
            </a:xfrm>
            <a:prstGeom prst="rect">
              <a:avLst/>
            </a:prstGeom>
          </p:spPr>
        </p:pic>
      </p:grpSp>
      <p:sp>
        <p:nvSpPr>
          <p:cNvPr id="20" name="TextBox 83"/>
          <p:cNvSpPr txBox="1"/>
          <p:nvPr/>
        </p:nvSpPr>
        <p:spPr>
          <a:xfrm>
            <a:off x="-99392" y="0"/>
            <a:ext cx="720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</a:t>
            </a:r>
            <a:r>
              <a:rPr lang="en-US" dirty="0"/>
              <a:t>: (A) Lycopene </a:t>
            </a:r>
            <a:r>
              <a:rPr lang="en-US" dirty="0" err="1"/>
              <a:t>elongase</a:t>
            </a:r>
            <a:r>
              <a:rPr lang="en-US" dirty="0"/>
              <a:t>, (B) GGPS, </a:t>
            </a:r>
            <a:r>
              <a:rPr lang="en-US" dirty="0" err="1"/>
              <a:t>cyclases</a:t>
            </a:r>
            <a:r>
              <a:rPr lang="en-US" dirty="0"/>
              <a:t> (C) Ye/g and (D) </a:t>
            </a:r>
            <a:r>
              <a:rPr lang="en-US" dirty="0" err="1"/>
              <a:t>Yf</a:t>
            </a:r>
            <a:r>
              <a:rPr lang="en-US" dirty="0"/>
              <a:t>/h</a:t>
            </a:r>
          </a:p>
        </p:txBody>
      </p:sp>
    </p:spTree>
    <p:extLst>
      <p:ext uri="{BB962C8B-B14F-4D97-AF65-F5344CB8AC3E}">
        <p14:creationId xmlns:p14="http://schemas.microsoft.com/office/powerpoint/2010/main" val="3675470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5161"/>
          <p:cNvSpPr txBox="1"/>
          <p:nvPr/>
        </p:nvSpPr>
        <p:spPr>
          <a:xfrm>
            <a:off x="342900" y="539552"/>
            <a:ext cx="4958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</a:t>
            </a:r>
            <a:r>
              <a:rPr lang="en-US" dirty="0"/>
              <a:t>: Glycosyl transferase</a:t>
            </a:r>
          </a:p>
        </p:txBody>
      </p:sp>
      <p:grpSp>
        <p:nvGrpSpPr>
          <p:cNvPr id="77" name="Group 76">
            <a:extLst>
              <a:ext uri="{FF2B5EF4-FFF2-40B4-BE49-F238E27FC236}">
                <a16:creationId xmlns:a16="http://schemas.microsoft.com/office/drawing/2014/main" id="{B47172B1-935B-4D64-B990-6512FEF2A2FB}"/>
              </a:ext>
            </a:extLst>
          </p:cNvPr>
          <p:cNvGrpSpPr/>
          <p:nvPr/>
        </p:nvGrpSpPr>
        <p:grpSpPr>
          <a:xfrm>
            <a:off x="342900" y="1475656"/>
            <a:ext cx="6067239" cy="1953274"/>
            <a:chOff x="342900" y="3059832"/>
            <a:chExt cx="6067239" cy="1953274"/>
          </a:xfrm>
        </p:grpSpPr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E81B6D5A-14FD-464D-9EAE-C813928DAA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00" y="3059832"/>
              <a:ext cx="5952939" cy="1943683"/>
            </a:xfrm>
            <a:prstGeom prst="rect">
              <a:avLst/>
            </a:prstGeom>
          </p:spPr>
        </p:pic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C4583FBC-1C18-40DE-9A3E-8C54C4E8B591}"/>
                </a:ext>
              </a:extLst>
            </p:cNvPr>
            <p:cNvGrpSpPr/>
            <p:nvPr/>
          </p:nvGrpSpPr>
          <p:grpSpPr>
            <a:xfrm>
              <a:off x="6181539" y="4581106"/>
              <a:ext cx="228600" cy="432000"/>
              <a:chOff x="5314950" y="5292490"/>
              <a:chExt cx="228600" cy="432000"/>
            </a:xfrm>
          </p:grpSpPr>
          <p:cxnSp>
            <p:nvCxnSpPr>
              <p:cNvPr id="74" name="Connettore diritto 69">
                <a:extLst>
                  <a:ext uri="{FF2B5EF4-FFF2-40B4-BE49-F238E27FC236}">
                    <a16:creationId xmlns:a16="http://schemas.microsoft.com/office/drawing/2014/main" id="{9EA488D3-9C32-430C-BF54-94210D908B76}"/>
                  </a:ext>
                </a:extLst>
              </p:cNvPr>
              <p:cNvCxnSpPr/>
              <p:nvPr/>
            </p:nvCxnSpPr>
            <p:spPr>
              <a:xfrm>
                <a:off x="5314950" y="5292490"/>
                <a:ext cx="0" cy="43200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5" name="CasellaDiTesto 70">
                <a:extLst>
                  <a:ext uri="{FF2B5EF4-FFF2-40B4-BE49-F238E27FC236}">
                    <a16:creationId xmlns:a16="http://schemas.microsoft.com/office/drawing/2014/main" id="{61ED2700-16B2-48BD-8BF3-1F3EBFD09FB6}"/>
                  </a:ext>
                </a:extLst>
              </p:cNvPr>
              <p:cNvSpPr txBox="1"/>
              <p:nvPr/>
            </p:nvSpPr>
            <p:spPr>
              <a:xfrm>
                <a:off x="5372100" y="5353491"/>
                <a:ext cx="171450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350" dirty="0"/>
                  <a:t>?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749783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188640" y="251520"/>
            <a:ext cx="4680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5</a:t>
            </a:r>
            <a:r>
              <a:rPr lang="it-IT" dirty="0"/>
              <a:t>: </a:t>
            </a:r>
            <a:r>
              <a:rPr lang="it-IT" dirty="0" err="1"/>
              <a:t>Terpenoid</a:t>
            </a:r>
            <a:r>
              <a:rPr lang="it-IT" dirty="0"/>
              <a:t> UV spectrum and </a:t>
            </a:r>
            <a:r>
              <a:rPr lang="it-IT" dirty="0" err="1"/>
              <a:t>structure</a:t>
            </a:r>
            <a:endParaRPr lang="it-IT" dirty="0"/>
          </a:p>
        </p:txBody>
      </p:sp>
      <p:grpSp>
        <p:nvGrpSpPr>
          <p:cNvPr id="13" name="Gruppo 12"/>
          <p:cNvGrpSpPr/>
          <p:nvPr/>
        </p:nvGrpSpPr>
        <p:grpSpPr>
          <a:xfrm>
            <a:off x="433370" y="1259632"/>
            <a:ext cx="5991260" cy="4485850"/>
            <a:chOff x="433370" y="2411760"/>
            <a:chExt cx="5991260" cy="4485850"/>
          </a:xfrm>
        </p:grpSpPr>
        <p:grpSp>
          <p:nvGrpSpPr>
            <p:cNvPr id="11" name="Gruppo 10"/>
            <p:cNvGrpSpPr/>
            <p:nvPr/>
          </p:nvGrpSpPr>
          <p:grpSpPr>
            <a:xfrm>
              <a:off x="477854" y="2411760"/>
              <a:ext cx="5516432" cy="2120478"/>
              <a:chOff x="477854" y="2649270"/>
              <a:chExt cx="5516432" cy="2120478"/>
            </a:xfrm>
          </p:grpSpPr>
          <p:grpSp>
            <p:nvGrpSpPr>
              <p:cNvPr id="9" name="Gruppo 8"/>
              <p:cNvGrpSpPr/>
              <p:nvPr/>
            </p:nvGrpSpPr>
            <p:grpSpPr>
              <a:xfrm>
                <a:off x="863715" y="2723048"/>
                <a:ext cx="5130571" cy="2046700"/>
                <a:chOff x="800315" y="2723048"/>
                <a:chExt cx="5130571" cy="2046700"/>
              </a:xfrm>
            </p:grpSpPr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00315" y="2723049"/>
                  <a:ext cx="2564030" cy="162137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028" name="Picture 4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364345" y="2723048"/>
                  <a:ext cx="2566541" cy="16158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8" name="Textfeld 7"/>
                <p:cNvSpPr txBox="1"/>
                <p:nvPr/>
              </p:nvSpPr>
              <p:spPr>
                <a:xfrm>
                  <a:off x="1316447" y="4338860"/>
                  <a:ext cx="1651414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100" b="1" i="1" dirty="0" err="1"/>
                    <a:t>Microbacterium</a:t>
                  </a:r>
                  <a:r>
                    <a:rPr lang="en-US" sz="1100" b="1" dirty="0"/>
                    <a:t> sp. 1.5R</a:t>
                  </a:r>
                </a:p>
                <a:p>
                  <a:pPr algn="ctr"/>
                  <a:r>
                    <a:rPr lang="en-US" sz="1100" dirty="0"/>
                    <a:t>(yellow pigmented strain)</a:t>
                  </a:r>
                </a:p>
              </p:txBody>
            </p:sp>
            <p:sp>
              <p:nvSpPr>
                <p:cNvPr id="17" name="Textfeld 16"/>
                <p:cNvSpPr txBox="1"/>
                <p:nvPr/>
              </p:nvSpPr>
              <p:spPr>
                <a:xfrm>
                  <a:off x="3794243" y="4338861"/>
                  <a:ext cx="1939013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i="1" dirty="0"/>
                    <a:t>M. </a:t>
                  </a:r>
                  <a:r>
                    <a:rPr lang="en-US" sz="1100" b="1" i="1" dirty="0" err="1"/>
                    <a:t>azadirachtae</a:t>
                  </a:r>
                  <a:r>
                    <a:rPr lang="en-US" sz="1100" b="1" i="1" dirty="0"/>
                    <a:t> </a:t>
                  </a:r>
                  <a:r>
                    <a:rPr lang="en-US" sz="1100" b="1" dirty="0"/>
                    <a:t>ARN176</a:t>
                  </a:r>
                </a:p>
                <a:p>
                  <a:pPr algn="ctr"/>
                  <a:r>
                    <a:rPr lang="en-US" sz="1100" dirty="0"/>
                    <a:t>(colorless strain)</a:t>
                  </a:r>
                </a:p>
              </p:txBody>
            </p:sp>
          </p:grpSp>
          <p:sp>
            <p:nvSpPr>
              <p:cNvPr id="16" name="CasellaDiTesto 15"/>
              <p:cNvSpPr txBox="1"/>
              <p:nvPr/>
            </p:nvSpPr>
            <p:spPr>
              <a:xfrm>
                <a:off x="477854" y="2649270"/>
                <a:ext cx="19742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/>
                  <a:t>A</a:t>
                </a:r>
              </a:p>
            </p:txBody>
          </p:sp>
        </p:grpSp>
        <p:grpSp>
          <p:nvGrpSpPr>
            <p:cNvPr id="12" name="Gruppo 11"/>
            <p:cNvGrpSpPr/>
            <p:nvPr/>
          </p:nvGrpSpPr>
          <p:grpSpPr>
            <a:xfrm>
              <a:off x="433370" y="4593486"/>
              <a:ext cx="5991260" cy="2304124"/>
              <a:chOff x="433370" y="4593486"/>
              <a:chExt cx="5991260" cy="2304124"/>
            </a:xfrm>
          </p:grpSpPr>
          <p:grpSp>
            <p:nvGrpSpPr>
              <p:cNvPr id="3" name="Gruppo 2"/>
              <p:cNvGrpSpPr/>
              <p:nvPr/>
            </p:nvGrpSpPr>
            <p:grpSpPr>
              <a:xfrm>
                <a:off x="433370" y="4858155"/>
                <a:ext cx="5991260" cy="2039455"/>
                <a:chOff x="458670" y="4858155"/>
                <a:chExt cx="5991260" cy="2039455"/>
              </a:xfrm>
            </p:grpSpPr>
            <p:sp>
              <p:nvSpPr>
                <p:cNvPr id="4" name="Textfeld 3"/>
                <p:cNvSpPr txBox="1"/>
                <p:nvPr/>
              </p:nvSpPr>
              <p:spPr>
                <a:xfrm>
                  <a:off x="2384125" y="5550361"/>
                  <a:ext cx="179940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Sarcinaxanthindiglucoside</a:t>
                  </a:r>
                  <a:endParaRPr lang="de-DE" sz="1200" dirty="0"/>
                </a:p>
              </p:txBody>
            </p:sp>
            <p:sp>
              <p:nvSpPr>
                <p:cNvPr id="5" name="Textfeld 4"/>
                <p:cNvSpPr txBox="1"/>
                <p:nvPr/>
              </p:nvSpPr>
              <p:spPr>
                <a:xfrm>
                  <a:off x="2255146" y="6620611"/>
                  <a:ext cx="20275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Decaprenoxanthindiglucoside</a:t>
                  </a:r>
                  <a:endParaRPr lang="de-DE" sz="1200" dirty="0"/>
                </a:p>
              </p:txBody>
            </p:sp>
            <p:pic>
              <p:nvPicPr>
                <p:cNvPr id="1032" name="Picture 8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8670" y="4858155"/>
                  <a:ext cx="5991260" cy="87388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033" name="Picture 9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8670" y="5911298"/>
                  <a:ext cx="5991260" cy="87388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18" name="CasellaDiTesto 17"/>
              <p:cNvSpPr txBox="1"/>
              <p:nvPr/>
            </p:nvSpPr>
            <p:spPr>
              <a:xfrm>
                <a:off x="476672" y="4593486"/>
                <a:ext cx="19742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/>
                  <a:t>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697898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CasellaDiTesto 206"/>
          <p:cNvSpPr txBox="1"/>
          <p:nvPr/>
        </p:nvSpPr>
        <p:spPr>
          <a:xfrm>
            <a:off x="188640" y="251520"/>
            <a:ext cx="6552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6</a:t>
            </a:r>
            <a:r>
              <a:rPr lang="it-IT" dirty="0"/>
              <a:t>: </a:t>
            </a:r>
            <a:r>
              <a:rPr lang="it-IT" dirty="0" err="1"/>
              <a:t>Phylogenetic</a:t>
            </a:r>
            <a:r>
              <a:rPr lang="it-IT" dirty="0"/>
              <a:t> </a:t>
            </a:r>
            <a:r>
              <a:rPr lang="it-IT" dirty="0" err="1"/>
              <a:t>tree</a:t>
            </a:r>
            <a:r>
              <a:rPr lang="it-IT" dirty="0"/>
              <a:t> </a:t>
            </a:r>
            <a:r>
              <a:rPr lang="it-IT" dirty="0" err="1"/>
              <a:t>based</a:t>
            </a:r>
            <a:r>
              <a:rPr lang="it-IT" dirty="0"/>
              <a:t> on NRPS </a:t>
            </a:r>
            <a:r>
              <a:rPr lang="it-IT" dirty="0" err="1"/>
              <a:t>sequences</a:t>
            </a:r>
            <a:endParaRPr lang="it-IT" dirty="0"/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56CB4E56-B126-48B6-8B4D-5865464E07D2}"/>
              </a:ext>
            </a:extLst>
          </p:cNvPr>
          <p:cNvGrpSpPr/>
          <p:nvPr/>
        </p:nvGrpSpPr>
        <p:grpSpPr>
          <a:xfrm>
            <a:off x="0" y="1547664"/>
            <a:ext cx="6862544" cy="7694593"/>
            <a:chOff x="0" y="1547664"/>
            <a:chExt cx="6862544" cy="7694593"/>
          </a:xfrm>
        </p:grpSpPr>
        <p:pic>
          <p:nvPicPr>
            <p:cNvPr id="205" name="Picture 204">
              <a:extLst>
                <a:ext uri="{FF2B5EF4-FFF2-40B4-BE49-F238E27FC236}">
                  <a16:creationId xmlns:a16="http://schemas.microsoft.com/office/drawing/2014/main" id="{099909C0-CB07-4D4E-90AE-B2D9AB7A412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547664"/>
              <a:ext cx="6858000" cy="7694593"/>
            </a:xfrm>
            <a:prstGeom prst="rect">
              <a:avLst/>
            </a:prstGeom>
          </p:spPr>
        </p:pic>
        <p:sp>
          <p:nvSpPr>
            <p:cNvPr id="2" name="Rechteck 1">
              <a:extLst>
                <a:ext uri="{FF2B5EF4-FFF2-40B4-BE49-F238E27FC236}">
                  <a16:creationId xmlns:a16="http://schemas.microsoft.com/office/drawing/2014/main" id="{FDD44371-F124-42D8-8E42-F51384A00B78}"/>
                </a:ext>
              </a:extLst>
            </p:cNvPr>
            <p:cNvSpPr>
              <a:spLocks/>
            </p:cNvSpPr>
            <p:nvPr/>
          </p:nvSpPr>
          <p:spPr>
            <a:xfrm>
              <a:off x="6741368" y="7452321"/>
              <a:ext cx="121176" cy="419173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24474038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CasellaDiTesto 214"/>
          <p:cNvSpPr txBox="1"/>
          <p:nvPr/>
        </p:nvSpPr>
        <p:spPr>
          <a:xfrm>
            <a:off x="8384" y="147326"/>
            <a:ext cx="6516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7</a:t>
            </a:r>
            <a:r>
              <a:rPr lang="it-IT" dirty="0"/>
              <a:t>: </a:t>
            </a:r>
            <a:r>
              <a:rPr lang="it-IT" dirty="0" err="1"/>
              <a:t>Tree</a:t>
            </a:r>
            <a:r>
              <a:rPr lang="it-IT" dirty="0"/>
              <a:t> </a:t>
            </a:r>
            <a:r>
              <a:rPr lang="it-IT" dirty="0" err="1"/>
              <a:t>based</a:t>
            </a:r>
            <a:r>
              <a:rPr lang="it-IT" dirty="0"/>
              <a:t> on PKS </a:t>
            </a:r>
            <a:r>
              <a:rPr lang="it-IT" dirty="0" err="1"/>
              <a:t>sequences</a:t>
            </a:r>
            <a:endParaRPr lang="it-IT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B7D5450-4F17-4571-AD15-289BCFA274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27584"/>
            <a:ext cx="6858000" cy="78059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39434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CasellaDiTesto 201"/>
          <p:cNvSpPr txBox="1"/>
          <p:nvPr/>
        </p:nvSpPr>
        <p:spPr>
          <a:xfrm>
            <a:off x="8384" y="147326"/>
            <a:ext cx="68496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8</a:t>
            </a:r>
            <a:r>
              <a:rPr lang="it-IT" dirty="0"/>
              <a:t>: Tree based on fad15 fatty acid ligase sequence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63C8715-7511-4B56-A2C0-5ADFCE610F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72158"/>
            <a:ext cx="6858000" cy="8464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62174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o 9"/>
          <p:cNvGrpSpPr/>
          <p:nvPr/>
        </p:nvGrpSpPr>
        <p:grpSpPr>
          <a:xfrm>
            <a:off x="450625" y="874331"/>
            <a:ext cx="5477024" cy="6505981"/>
            <a:chOff x="450625" y="874331"/>
            <a:chExt cx="5477024" cy="6505981"/>
          </a:xfrm>
        </p:grpSpPr>
        <p:sp>
          <p:nvSpPr>
            <p:cNvPr id="20" name="Rettangolo 19"/>
            <p:cNvSpPr/>
            <p:nvPr/>
          </p:nvSpPr>
          <p:spPr>
            <a:xfrm>
              <a:off x="1156213" y="6516216"/>
              <a:ext cx="1512000" cy="540000"/>
            </a:xfrm>
            <a:prstGeom prst="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1" name="Rettangolo 20"/>
            <p:cNvSpPr/>
            <p:nvPr/>
          </p:nvSpPr>
          <p:spPr>
            <a:xfrm>
              <a:off x="2726506" y="6516216"/>
              <a:ext cx="2880000" cy="540000"/>
            </a:xfrm>
            <a:prstGeom prst="rect">
              <a:avLst/>
            </a:pr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167" name="Gruppo 166"/>
            <p:cNvGrpSpPr/>
            <p:nvPr/>
          </p:nvGrpSpPr>
          <p:grpSpPr>
            <a:xfrm>
              <a:off x="450625" y="874331"/>
              <a:ext cx="5477024" cy="6505981"/>
              <a:chOff x="450625" y="874331"/>
              <a:chExt cx="5477024" cy="6505981"/>
            </a:xfrm>
          </p:grpSpPr>
          <p:grpSp>
            <p:nvGrpSpPr>
              <p:cNvPr id="165" name="Gruppo 164"/>
              <p:cNvGrpSpPr/>
              <p:nvPr/>
            </p:nvGrpSpPr>
            <p:grpSpPr>
              <a:xfrm>
                <a:off x="450625" y="874331"/>
                <a:ext cx="5477024" cy="6505981"/>
                <a:chOff x="450625" y="874331"/>
                <a:chExt cx="5477024" cy="6505981"/>
              </a:xfrm>
            </p:grpSpPr>
            <p:grpSp>
              <p:nvGrpSpPr>
                <p:cNvPr id="163" name="Gruppo 162"/>
                <p:cNvGrpSpPr/>
                <p:nvPr/>
              </p:nvGrpSpPr>
              <p:grpSpPr>
                <a:xfrm>
                  <a:off x="450625" y="874331"/>
                  <a:ext cx="5477024" cy="6505981"/>
                  <a:chOff x="450625" y="874331"/>
                  <a:chExt cx="5477024" cy="6505981"/>
                </a:xfrm>
              </p:grpSpPr>
              <p:grpSp>
                <p:nvGrpSpPr>
                  <p:cNvPr id="161" name="Gruppo 160"/>
                  <p:cNvGrpSpPr/>
                  <p:nvPr/>
                </p:nvGrpSpPr>
                <p:grpSpPr>
                  <a:xfrm>
                    <a:off x="450625" y="874331"/>
                    <a:ext cx="5477024" cy="6505981"/>
                    <a:chOff x="450625" y="874331"/>
                    <a:chExt cx="5477024" cy="6505981"/>
                  </a:xfrm>
                </p:grpSpPr>
                <p:grpSp>
                  <p:nvGrpSpPr>
                    <p:cNvPr id="159" name="Gruppo 158"/>
                    <p:cNvGrpSpPr/>
                    <p:nvPr/>
                  </p:nvGrpSpPr>
                  <p:grpSpPr>
                    <a:xfrm>
                      <a:off x="450625" y="874331"/>
                      <a:ext cx="5477024" cy="6505981"/>
                      <a:chOff x="450625" y="874331"/>
                      <a:chExt cx="5477024" cy="6505981"/>
                    </a:xfrm>
                  </p:grpSpPr>
                  <p:grpSp>
                    <p:nvGrpSpPr>
                      <p:cNvPr id="157" name="Gruppo 156"/>
                      <p:cNvGrpSpPr/>
                      <p:nvPr/>
                    </p:nvGrpSpPr>
                    <p:grpSpPr>
                      <a:xfrm>
                        <a:off x="450625" y="874331"/>
                        <a:ext cx="5477024" cy="6505981"/>
                        <a:chOff x="450625" y="874331"/>
                        <a:chExt cx="5477024" cy="6505981"/>
                      </a:xfrm>
                    </p:grpSpPr>
                    <p:grpSp>
                      <p:nvGrpSpPr>
                        <p:cNvPr id="155" name="Gruppo 154"/>
                        <p:cNvGrpSpPr/>
                        <p:nvPr/>
                      </p:nvGrpSpPr>
                      <p:grpSpPr>
                        <a:xfrm>
                          <a:off x="450625" y="874331"/>
                          <a:ext cx="5477024" cy="6505981"/>
                          <a:chOff x="450625" y="874331"/>
                          <a:chExt cx="5477024" cy="6505981"/>
                        </a:xfrm>
                      </p:grpSpPr>
                      <p:grpSp>
                        <p:nvGrpSpPr>
                          <p:cNvPr id="153" name="Gruppo 152"/>
                          <p:cNvGrpSpPr/>
                          <p:nvPr/>
                        </p:nvGrpSpPr>
                        <p:grpSpPr>
                          <a:xfrm>
                            <a:off x="450625" y="874331"/>
                            <a:ext cx="5477024" cy="6505981"/>
                            <a:chOff x="450625" y="874331"/>
                            <a:chExt cx="5477024" cy="6505981"/>
                          </a:xfrm>
                        </p:grpSpPr>
                        <p:grpSp>
                          <p:nvGrpSpPr>
                            <p:cNvPr id="151" name="Gruppo 150"/>
                            <p:cNvGrpSpPr/>
                            <p:nvPr/>
                          </p:nvGrpSpPr>
                          <p:grpSpPr>
                            <a:xfrm>
                              <a:off x="450625" y="874331"/>
                              <a:ext cx="5477024" cy="6505981"/>
                              <a:chOff x="450625" y="874331"/>
                              <a:chExt cx="5477024" cy="6505981"/>
                            </a:xfrm>
                          </p:grpSpPr>
                          <p:grpSp>
                            <p:nvGrpSpPr>
                              <p:cNvPr id="149" name="Gruppo 148"/>
                              <p:cNvGrpSpPr/>
                              <p:nvPr/>
                            </p:nvGrpSpPr>
                            <p:grpSpPr>
                              <a:xfrm>
                                <a:off x="450625" y="874331"/>
                                <a:ext cx="5477024" cy="6505981"/>
                                <a:chOff x="450625" y="874331"/>
                                <a:chExt cx="5477024" cy="6505981"/>
                              </a:xfrm>
                            </p:grpSpPr>
                            <p:grpSp>
                              <p:nvGrpSpPr>
                                <p:cNvPr id="147" name="Gruppo 146"/>
                                <p:cNvGrpSpPr/>
                                <p:nvPr/>
                              </p:nvGrpSpPr>
                              <p:grpSpPr>
                                <a:xfrm>
                                  <a:off x="450625" y="874331"/>
                                  <a:ext cx="5477024" cy="6505981"/>
                                  <a:chOff x="450625" y="874331"/>
                                  <a:chExt cx="5477024" cy="6505981"/>
                                </a:xfrm>
                              </p:grpSpPr>
                              <p:grpSp>
                                <p:nvGrpSpPr>
                                  <p:cNvPr id="145" name="Gruppo 144"/>
                                  <p:cNvGrpSpPr/>
                                  <p:nvPr/>
                                </p:nvGrpSpPr>
                                <p:grpSpPr>
                                  <a:xfrm>
                                    <a:off x="450625" y="874331"/>
                                    <a:ext cx="5477024" cy="6505981"/>
                                    <a:chOff x="450625" y="874331"/>
                                    <a:chExt cx="5477024" cy="6505981"/>
                                  </a:xfrm>
                                </p:grpSpPr>
                                <p:grpSp>
                                  <p:nvGrpSpPr>
                                    <p:cNvPr id="143" name="Gruppo 142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450625" y="874331"/>
                                      <a:ext cx="5477024" cy="6505981"/>
                                      <a:chOff x="450625" y="874331"/>
                                      <a:chExt cx="5477024" cy="6505981"/>
                                    </a:xfrm>
                                  </p:grpSpPr>
                                  <p:grpSp>
                                    <p:nvGrpSpPr>
                                      <p:cNvPr id="141" name="Gruppo 140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450625" y="874331"/>
                                        <a:ext cx="5477024" cy="6505981"/>
                                        <a:chOff x="450625" y="874331"/>
                                        <a:chExt cx="5477024" cy="6505981"/>
                                      </a:xfrm>
                                    </p:grpSpPr>
                                    <p:grpSp>
                                      <p:nvGrpSpPr>
                                        <p:cNvPr id="139" name="Gruppo 138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450625" y="874331"/>
                                          <a:ext cx="5477024" cy="6505981"/>
                                          <a:chOff x="450625" y="874331"/>
                                          <a:chExt cx="5477024" cy="6505981"/>
                                        </a:xfrm>
                                      </p:grpSpPr>
                                      <p:grpSp>
                                        <p:nvGrpSpPr>
                                          <p:cNvPr id="137" name="Gruppo 136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450625" y="874331"/>
                                            <a:ext cx="5477024" cy="6505981"/>
                                            <a:chOff x="450625" y="874331"/>
                                            <a:chExt cx="5477024" cy="6505981"/>
                                          </a:xfrm>
                                        </p:grpSpPr>
                                        <p:grpSp>
                                          <p:nvGrpSpPr>
                                            <p:cNvPr id="135" name="Gruppo 134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450625" y="874331"/>
                                              <a:ext cx="5477024" cy="6505981"/>
                                              <a:chOff x="450625" y="874331"/>
                                              <a:chExt cx="5477024" cy="6505981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133" name="Gruppo 132"/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450625" y="874331"/>
                                                <a:ext cx="5477024" cy="6505981"/>
                                                <a:chOff x="450625" y="874331"/>
                                                <a:chExt cx="5477024" cy="6505981"/>
                                              </a:xfrm>
                                            </p:grpSpPr>
                                            <p:grpSp>
                                              <p:nvGrpSpPr>
                                                <p:cNvPr id="131" name="Gruppo 130"/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450625" y="874331"/>
                                                  <a:ext cx="5477024" cy="6505981"/>
                                                  <a:chOff x="450625" y="874331"/>
                                                  <a:chExt cx="5477024" cy="6505981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129" name="Gruppo 128"/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450625" y="874331"/>
                                                    <a:ext cx="5477024" cy="6505981"/>
                                                    <a:chOff x="450625" y="874331"/>
                                                    <a:chExt cx="5477024" cy="6505981"/>
                                                  </a:xfrm>
                                                </p:grpSpPr>
                                                <p:grpSp>
                                                  <p:nvGrpSpPr>
                                                    <p:cNvPr id="127" name="Gruppo 126"/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450625" y="874331"/>
                                                      <a:ext cx="5477024" cy="6505981"/>
                                                      <a:chOff x="450625" y="874331"/>
                                                      <a:chExt cx="5477024" cy="6505981"/>
                                                    </a:xfrm>
                                                  </p:grpSpPr>
                                                  <p:grpSp>
                                                    <p:nvGrpSpPr>
                                                      <p:cNvPr id="125" name="Gruppo 124"/>
                                                      <p:cNvGrpSpPr/>
                                                      <p:nvPr/>
                                                    </p:nvGrpSpPr>
                                                    <p:grpSpPr>
                                                      <a:xfrm>
                                                        <a:off x="450625" y="874331"/>
                                                        <a:ext cx="5477024" cy="6505981"/>
                                                        <a:chOff x="450625" y="874331"/>
                                                        <a:chExt cx="5477024" cy="6505981"/>
                                                      </a:xfrm>
                                                    </p:grpSpPr>
                                                    <p:grpSp>
                                                      <p:nvGrpSpPr>
                                                        <p:cNvPr id="123" name="Gruppo 122"/>
                                                        <p:cNvGrpSpPr/>
                                                        <p:nvPr/>
                                                      </p:nvGrpSpPr>
                                                      <p:grpSpPr>
                                                        <a:xfrm>
                                                          <a:off x="450625" y="874331"/>
                                                          <a:ext cx="5477024" cy="6505981"/>
                                                          <a:chOff x="450625" y="874331"/>
                                                          <a:chExt cx="5477024" cy="6505981"/>
                                                        </a:xfrm>
                                                      </p:grpSpPr>
                                                      <p:grpSp>
                                                        <p:nvGrpSpPr>
                                                          <p:cNvPr id="121" name="Gruppo 120"/>
                                                          <p:cNvGrpSpPr/>
                                                          <p:nvPr/>
                                                        </p:nvGrpSpPr>
                                                        <p:grpSpPr>
                                                          <a:xfrm>
                                                            <a:off x="450625" y="874331"/>
                                                            <a:ext cx="5477024" cy="6505981"/>
                                                            <a:chOff x="450625" y="874331"/>
                                                            <a:chExt cx="5477024" cy="6505981"/>
                                                          </a:xfrm>
                                                        </p:grpSpPr>
                                                        <p:grpSp>
                                                          <p:nvGrpSpPr>
                                                            <p:cNvPr id="119" name="Gruppo 118"/>
                                                            <p:cNvGrpSpPr/>
                                                            <p:nvPr/>
                                                          </p:nvGrpSpPr>
                                                          <p:grpSpPr>
                                                            <a:xfrm>
                                                              <a:off x="450625" y="874331"/>
                                                              <a:ext cx="5477024" cy="6505981"/>
                                                              <a:chOff x="450625" y="874331"/>
                                                              <a:chExt cx="5477024" cy="6505981"/>
                                                            </a:xfrm>
                                                          </p:grpSpPr>
                                                          <p:grpSp>
                                                            <p:nvGrpSpPr>
                                                              <p:cNvPr id="117" name="Gruppo 116"/>
                                                              <p:cNvGrpSpPr/>
                                                              <p:nvPr/>
                                                            </p:nvGrpSpPr>
                                                            <p:grpSpPr>
                                                              <a:xfrm>
                                                                <a:off x="450625" y="874331"/>
                                                                <a:ext cx="5477024" cy="6505981"/>
                                                                <a:chOff x="450625" y="874331"/>
                                                                <a:chExt cx="5477024" cy="6505981"/>
                                                              </a:xfrm>
                                                            </p:grpSpPr>
                                                            <p:grpSp>
                                                              <p:nvGrpSpPr>
                                                                <p:cNvPr id="115" name="Gruppo 114"/>
                                                                <p:cNvGrpSpPr/>
                                                                <p:nvPr/>
                                                              </p:nvGrpSpPr>
                                                              <p:grpSpPr>
                                                                <a:xfrm>
                                                                  <a:off x="450625" y="874331"/>
                                                                  <a:ext cx="5477024" cy="6505981"/>
                                                                  <a:chOff x="450625" y="874331"/>
                                                                  <a:chExt cx="5477024" cy="6505981"/>
                                                                </a:xfrm>
                                                              </p:grpSpPr>
                                                              <p:grpSp>
                                                                <p:nvGrpSpPr>
                                                                  <p:cNvPr id="113" name="Gruppo 112"/>
                                                                  <p:cNvGrpSpPr/>
                                                                  <p:nvPr/>
                                                                </p:nvGrpSpPr>
                                                                <p:grpSpPr>
                                                                  <a:xfrm>
                                                                    <a:off x="450625" y="874331"/>
                                                                    <a:ext cx="5477024" cy="6505981"/>
                                                                    <a:chOff x="450625" y="874331"/>
                                                                    <a:chExt cx="5477024" cy="6505981"/>
                                                                  </a:xfrm>
                                                                </p:grpSpPr>
                                                                <p:grpSp>
                                                                  <p:nvGrpSpPr>
                                                                    <p:cNvPr id="111" name="Gruppo 110"/>
                                                                    <p:cNvGrpSpPr/>
                                                                    <p:nvPr/>
                                                                  </p:nvGrpSpPr>
                                                                  <p:grpSpPr>
                                                                    <a:xfrm>
                                                                      <a:off x="450625" y="874331"/>
                                                                      <a:ext cx="5477024" cy="6505981"/>
                                                                      <a:chOff x="450625" y="874331"/>
                                                                      <a:chExt cx="5477024" cy="6505981"/>
                                                                    </a:xfrm>
                                                                  </p:grpSpPr>
                                                                  <p:grpSp>
                                                                    <p:nvGrpSpPr>
                                                                      <p:cNvPr id="109" name="Gruppo 108"/>
                                                                      <p:cNvGrpSpPr/>
                                                                      <p:nvPr/>
                                                                    </p:nvGrpSpPr>
                                                                    <p:grpSpPr>
                                                                      <a:xfrm>
                                                                        <a:off x="450625" y="874331"/>
                                                                        <a:ext cx="5477024" cy="6505981"/>
                                                                        <a:chOff x="450625" y="874331"/>
                                                                        <a:chExt cx="5477024" cy="6505981"/>
                                                                      </a:xfrm>
                                                                    </p:grpSpPr>
                                                                    <p:grpSp>
                                                                      <p:nvGrpSpPr>
                                                                        <p:cNvPr id="107" name="Gruppo 106"/>
                                                                        <p:cNvGrpSpPr/>
                                                                        <p:nvPr/>
                                                                      </p:nvGrpSpPr>
                                                                      <p:grpSpPr>
                                                                        <a:xfrm>
                                                                          <a:off x="450625" y="874331"/>
                                                                          <a:ext cx="5477024" cy="6505981"/>
                                                                          <a:chOff x="450625" y="874331"/>
                                                                          <a:chExt cx="5477024" cy="6505981"/>
                                                                        </a:xfrm>
                                                                      </p:grpSpPr>
                                                                      <p:grpSp>
                                                                        <p:nvGrpSpPr>
                                                                          <p:cNvPr id="105" name="Gruppo 104"/>
                                                                          <p:cNvGrpSpPr/>
                                                                          <p:nvPr/>
                                                                        </p:nvGrpSpPr>
                                                                        <p:grpSpPr>
                                                                          <a:xfrm>
                                                                            <a:off x="450625" y="874331"/>
                                                                            <a:ext cx="5477024" cy="6505981"/>
                                                                            <a:chOff x="450625" y="874331"/>
                                                                            <a:chExt cx="5477024" cy="6505981"/>
                                                                          </a:xfrm>
                                                                        </p:grpSpPr>
                                                                        <p:grpSp>
                                                                          <p:nvGrpSpPr>
                                                                            <p:cNvPr id="103" name="Gruppo 102"/>
                                                                            <p:cNvGrpSpPr/>
                                                                            <p:nvPr/>
                                                                          </p:nvGrpSpPr>
                                                                          <p:grpSpPr>
                                                                            <a:xfrm>
                                                                              <a:off x="450625" y="874331"/>
                                                                              <a:ext cx="5477024" cy="6505981"/>
                                                                              <a:chOff x="450625" y="874331"/>
                                                                              <a:chExt cx="5477024" cy="6505981"/>
                                                                            </a:xfrm>
                                                                          </p:grpSpPr>
                                                                          <p:grpSp>
                                                                            <p:nvGrpSpPr>
                                                                              <p:cNvPr id="101" name="Gruppo 100"/>
                                                                              <p:cNvGrpSpPr/>
                                                                              <p:nvPr/>
                                                                            </p:nvGrpSpPr>
                                                                            <p:grpSpPr>
                                                                              <a:xfrm>
                                                                                <a:off x="450625" y="874331"/>
                                                                                <a:ext cx="5477024" cy="6505981"/>
                                                                                <a:chOff x="450625" y="874331"/>
                                                                                <a:chExt cx="5477024" cy="6505981"/>
                                                                              </a:xfrm>
                                                                            </p:grpSpPr>
                                                                            <p:grpSp>
                                                                              <p:nvGrpSpPr>
                                                                                <p:cNvPr id="99" name="Gruppo 98"/>
                                                                                <p:cNvGrpSpPr/>
                                                                                <p:nvPr/>
                                                                              </p:nvGrpSpPr>
                                                                              <p:grpSpPr>
                                                                                <a:xfrm>
                                                                                  <a:off x="450625" y="874331"/>
                                                                                  <a:ext cx="5477024" cy="6505981"/>
                                                                                  <a:chOff x="450625" y="874331"/>
                                                                                  <a:chExt cx="5477024" cy="6505981"/>
                                                                                </a:xfrm>
                                                                              </p:grpSpPr>
                                                                              <p:grpSp>
                                                                                <p:nvGrpSpPr>
                                                                                  <p:cNvPr id="97" name="Gruppo 96"/>
                                                                                  <p:cNvGrpSpPr/>
                                                                                  <p:nvPr/>
                                                                                </p:nvGrpSpPr>
                                                                                <p:grpSpPr>
                                                                                  <a:xfrm>
                                                                                    <a:off x="450625" y="874331"/>
                                                                                    <a:ext cx="5477024" cy="6505981"/>
                                                                                    <a:chOff x="450625" y="874331"/>
                                                                                    <a:chExt cx="5477024" cy="6505981"/>
                                                                                  </a:xfrm>
                                                                                </p:grpSpPr>
                                                                                <p:grpSp>
                                                                                  <p:nvGrpSpPr>
                                                                                    <p:cNvPr id="95" name="Gruppo 94"/>
                                                                                    <p:cNvGrpSpPr/>
                                                                                    <p:nvPr/>
                                                                                  </p:nvGrpSpPr>
                                                                                  <p:grpSpPr>
                                                                                    <a:xfrm>
                                                                                      <a:off x="450625" y="874331"/>
                                                                                      <a:ext cx="5477024" cy="6505981"/>
                                                                                      <a:chOff x="450625" y="874331"/>
                                                                                      <a:chExt cx="5477024" cy="6505981"/>
                                                                                    </a:xfrm>
                                                                                  </p:grpSpPr>
                                                                                  <p:grpSp>
                                                                                    <p:nvGrpSpPr>
                                                                                      <p:cNvPr id="93" name="Gruppo 92"/>
                                                                                      <p:cNvGrpSpPr/>
                                                                                      <p:nvPr/>
                                                                                    </p:nvGrpSpPr>
                                                                                    <p:grpSpPr>
                                                                                      <a:xfrm>
                                                                                        <a:off x="450625" y="874331"/>
                                                                                        <a:ext cx="5477024" cy="6505981"/>
                                                                                        <a:chOff x="450625" y="874331"/>
                                                                                        <a:chExt cx="5477024" cy="6505981"/>
                                                                                      </a:xfrm>
                                                                                    </p:grpSpPr>
                                                                                    <p:grpSp>
                                                                                      <p:nvGrpSpPr>
                                                                                        <p:cNvPr id="91" name="Gruppo 90"/>
                                                                                        <p:cNvGrpSpPr/>
                                                                                        <p:nvPr/>
                                                                                      </p:nvGrpSpPr>
                                                                                      <p:grpSpPr>
                                                                                        <a:xfrm>
                                                                                          <a:off x="450625" y="874331"/>
                                                                                          <a:ext cx="5477024" cy="6505981"/>
                                                                                          <a:chOff x="450625" y="874331"/>
                                                                                          <a:chExt cx="5477024" cy="6505981"/>
                                                                                        </a:xfrm>
                                                                                      </p:grpSpPr>
                                                                                      <p:grpSp>
                                                                                        <p:nvGrpSpPr>
                                                                                          <p:cNvPr id="89" name="Gruppo 88"/>
                                                                                          <p:cNvGrpSpPr/>
                                                                                          <p:nvPr/>
                                                                                        </p:nvGrpSpPr>
                                                                                        <p:grpSpPr>
                                                                                          <a:xfrm>
                                                                                            <a:off x="450625" y="874331"/>
                                                                                            <a:ext cx="5477024" cy="6505981"/>
                                                                                            <a:chOff x="450625" y="874331"/>
                                                                                            <a:chExt cx="5477024" cy="6505981"/>
                                                                                          </a:xfrm>
                                                                                        </p:grpSpPr>
                                                                                        <p:grpSp>
                                                                                          <p:nvGrpSpPr>
                                                                                            <p:cNvPr id="87" name="Gruppo 86"/>
                                                                                            <p:cNvGrpSpPr/>
                                                                                            <p:nvPr/>
                                                                                          </p:nvGrpSpPr>
                                                                                          <p:grpSpPr>
                                                                                            <a:xfrm>
                                                                                              <a:off x="450625" y="874331"/>
                                                                                              <a:ext cx="5477024" cy="6505981"/>
                                                                                              <a:chOff x="450625" y="874331"/>
                                                                                              <a:chExt cx="5477024" cy="6505981"/>
                                                                                            </a:xfrm>
                                                                                          </p:grpSpPr>
                                                                                          <p:grpSp>
                                                                                            <p:nvGrpSpPr>
                                                                                              <p:cNvPr id="85" name="Gruppo 84"/>
                                                                                              <p:cNvGrpSpPr/>
                                                                                              <p:nvPr/>
                                                                                            </p:nvGrpSpPr>
                                                                                            <p:grpSpPr>
                                                                                              <a:xfrm>
                                                                                                <a:off x="450625" y="874331"/>
                                                                                                <a:ext cx="5477024" cy="6505981"/>
                                                                                                <a:chOff x="450625" y="874331"/>
                                                                                                <a:chExt cx="5477024" cy="6505981"/>
                                                                                              </a:xfrm>
                                                                                            </p:grpSpPr>
                                                                                            <p:grpSp>
                                                                                              <p:nvGrpSpPr>
                                                                                                <p:cNvPr id="83" name="Gruppo 82"/>
                                                                                                <p:cNvGrpSpPr/>
                                                                                                <p:nvPr/>
                                                                                              </p:nvGrpSpPr>
                                                                                              <p:grpSpPr>
                                                                                                <a:xfrm>
                                                                                                  <a:off x="450625" y="874331"/>
                                                                                                  <a:ext cx="5477024" cy="6505981"/>
                                                                                                  <a:chOff x="450625" y="874331"/>
                                                                                                  <a:chExt cx="5477024" cy="6505981"/>
                                                                                                </a:xfrm>
                                                                                              </p:grpSpPr>
                                                                                              <p:grpSp>
                                                                                                <p:nvGrpSpPr>
                                                                                                  <p:cNvPr id="81" name="Gruppo 80"/>
                                                                                                  <p:cNvGrpSpPr/>
                                                                                                  <p:nvPr/>
                                                                                                </p:nvGrpSpPr>
                                                                                                <p:grpSpPr>
                                                                                                  <a:xfrm>
                                                                                                    <a:off x="450625" y="874331"/>
                                                                                                    <a:ext cx="5477024" cy="6505981"/>
                                                                                                    <a:chOff x="450625" y="874331"/>
                                                                                                    <a:chExt cx="5477024" cy="6505981"/>
                                                                                                  </a:xfrm>
                                                                                                </p:grpSpPr>
                                                                                                <p:grpSp>
                                                                                                  <p:nvGrpSpPr>
                                                                                                    <p:cNvPr id="79" name="Gruppo 78"/>
                                                                                                    <p:cNvGrpSpPr/>
                                                                                                    <p:nvPr/>
                                                                                                  </p:nvGrpSpPr>
                                                                                                  <p:grpSpPr>
                                                                                                    <a:xfrm>
                                                                                                      <a:off x="450625" y="874331"/>
                                                                                                      <a:ext cx="5477024" cy="6505981"/>
                                                                                                      <a:chOff x="450625" y="874331"/>
                                                                                                      <a:chExt cx="5477024" cy="6505981"/>
                                                                                                    </a:xfrm>
                                                                                                  </p:grpSpPr>
                                                                                                  <p:grpSp>
                                                                                                    <p:nvGrpSpPr>
                                                                                                      <p:cNvPr id="77" name="Gruppo 76"/>
                                                                                                      <p:cNvGrpSpPr/>
                                                                                                      <p:nvPr/>
                                                                                                    </p:nvGrpSpPr>
                                                                                                    <p:grpSpPr>
                                                                                                      <a:xfrm>
                                                                                                        <a:off x="450625" y="874331"/>
                                                                                                        <a:ext cx="5477024" cy="6505981"/>
                                                                                                        <a:chOff x="450625" y="874331"/>
                                                                                                        <a:chExt cx="5477024" cy="6505981"/>
                                                                                                      </a:xfrm>
                                                                                                    </p:grpSpPr>
                                                                                                    <p:grpSp>
                                                                                                      <p:nvGrpSpPr>
                                                                                                        <p:cNvPr id="75" name="Gruppo 74"/>
                                                                                                        <p:cNvGrpSpPr/>
                                                                                                        <p:nvPr/>
                                                                                                      </p:nvGrpSpPr>
                                                                                                      <p:grpSpPr>
                                                                                                        <a:xfrm>
                                                                                                          <a:off x="450625" y="874331"/>
                                                                                                          <a:ext cx="5477024" cy="6505981"/>
                                                                                                          <a:chOff x="450625" y="874331"/>
                                                                                                          <a:chExt cx="5477024" cy="6505981"/>
                                                                                                        </a:xfrm>
                                                                                                      </p:grpSpPr>
                                                                                                      <p:grpSp>
                                                                                                        <p:nvGrpSpPr>
                                                                                                          <p:cNvPr id="73" name="Gruppo 72"/>
                                                                                                          <p:cNvGrpSpPr/>
                                                                                                          <p:nvPr/>
                                                                                                        </p:nvGrpSpPr>
                                                                                                        <p:grpSpPr>
                                                                                                          <a:xfrm>
                                                                                                            <a:off x="450625" y="874331"/>
                                                                                                            <a:ext cx="5477024" cy="6505981"/>
                                                                                                            <a:chOff x="450625" y="874331"/>
                                                                                                            <a:chExt cx="5477024" cy="6505981"/>
                                                                                                          </a:xfrm>
                                                                                                        </p:grpSpPr>
                                                                                                        <p:grpSp>
                                                                                                          <p:nvGrpSpPr>
                                                                                                            <p:cNvPr id="71" name="Gruppo 70"/>
                                                                                                            <p:cNvGrpSpPr/>
                                                                                                            <p:nvPr/>
                                                                                                          </p:nvGrpSpPr>
                                                                                                          <p:grpSpPr>
                                                                                                            <a:xfrm>
                                                                                                              <a:off x="450625" y="874331"/>
                                                                                                              <a:ext cx="5477024" cy="6505981"/>
                                                                                                              <a:chOff x="450625" y="874331"/>
                                                                                                              <a:chExt cx="5477024" cy="6505981"/>
                                                                                                            </a:xfrm>
                                                                                                          </p:grpSpPr>
                                                                                                          <p:grpSp>
                                                                                                            <p:nvGrpSpPr>
                                                                                                              <p:cNvPr id="69" name="Gruppo 68"/>
                                                                                                              <p:cNvGrpSpPr/>
                                                                                                              <p:nvPr/>
                                                                                                            </p:nvGrpSpPr>
                                                                                                            <p:grpSpPr>
                                                                                                              <a:xfrm>
                                                                                                                <a:off x="450625" y="874331"/>
                                                                                                                <a:ext cx="5477024" cy="6505981"/>
                                                                                                                <a:chOff x="450625" y="874331"/>
                                                                                                                <a:chExt cx="5477024" cy="6505981"/>
                                                                                                              </a:xfrm>
                                                                                                            </p:grpSpPr>
                                                                                                            <p:grpSp>
                                                                                                              <p:nvGrpSpPr>
                                                                                                                <p:cNvPr id="67" name="Gruppo 66"/>
                                                                                                                <p:cNvGrpSpPr/>
                                                                                                                <p:nvPr/>
                                                                                                              </p:nvGrpSpPr>
                                                                                                              <p:grpSpPr>
                                                                                                                <a:xfrm>
                                                                                                                  <a:off x="450625" y="874331"/>
                                                                                                                  <a:ext cx="5477024" cy="6505981"/>
                                                                                                                  <a:chOff x="450625" y="874331"/>
                                                                                                                  <a:chExt cx="5477024" cy="6505981"/>
                                                                                                                </a:xfrm>
                                                                                                              </p:grpSpPr>
                                                                                                              <p:grpSp>
                                                                                                                <p:nvGrpSpPr>
                                                                                                                  <p:cNvPr id="65" name="Gruppo 64"/>
                                                                                                                  <p:cNvGrpSpPr/>
                                                                                                                  <p:nvPr/>
                                                                                                                </p:nvGrpSpPr>
                                                                                                                <p:grpSpPr>
                                                                                                                  <a:xfrm>
                                                                                                                    <a:off x="450625" y="874331"/>
                                                                                                                    <a:ext cx="5477024" cy="6505981"/>
                                                                                                                    <a:chOff x="450625" y="874331"/>
                                                                                                                    <a:chExt cx="5477024" cy="6505981"/>
                                                                                                                  </a:xfrm>
                                                                                                                </p:grpSpPr>
                                                                                                                <p:grpSp>
                                                                                                                  <p:nvGrpSpPr>
                                                                                                                    <p:cNvPr id="63" name="Gruppo 62"/>
                                                                                                                    <p:cNvGrpSpPr/>
                                                                                                                    <p:nvPr/>
                                                                                                                  </p:nvGrpSpPr>
                                                                                                                  <p:grpSpPr>
                                                                                                                    <a:xfrm>
                                                                                                                      <a:off x="450625" y="874331"/>
                                                                                                                      <a:ext cx="5477024" cy="6505981"/>
                                                                                                                      <a:chOff x="450625" y="874331"/>
                                                                                                                      <a:chExt cx="5477024" cy="6505981"/>
                                                                                                                    </a:xfrm>
                                                                                                                  </p:grpSpPr>
                                                                                                                  <p:grpSp>
                                                                                                                    <p:nvGrpSpPr>
                                                                                                                      <p:cNvPr id="61" name="Gruppo 60"/>
                                                                                                                      <p:cNvGrpSpPr/>
                                                                                                                      <p:nvPr/>
                                                                                                                    </p:nvGrpSpPr>
                                                                                                                    <p:grpSpPr>
                                                                                                                      <a:xfrm>
                                                                                                                        <a:off x="450625" y="874331"/>
                                                                                                                        <a:ext cx="5477024" cy="6505981"/>
                                                                                                                        <a:chOff x="450625" y="874331"/>
                                                                                                                        <a:chExt cx="5477024" cy="6505981"/>
                                                                                                                      </a:xfrm>
                                                                                                                    </p:grpSpPr>
                                                                                                                    <p:grpSp>
                                                                                                                      <p:nvGrpSpPr>
                                                                                                                        <p:cNvPr id="59" name="Gruppo 58"/>
                                                                                                                        <p:cNvGrpSpPr/>
                                                                                                                        <p:nvPr/>
                                                                                                                      </p:nvGrpSpPr>
                                                                                                                      <p:grpSpPr>
                                                                                                                        <a:xfrm>
                                                                                                                          <a:off x="450625" y="874331"/>
                                                                                                                          <a:ext cx="5477024" cy="6505981"/>
                                                                                                                          <a:chOff x="450625" y="874331"/>
                                                                                                                          <a:chExt cx="5477024" cy="6505981"/>
                                                                                                                        </a:xfrm>
                                                                                                                      </p:grpSpPr>
                                                                                                                      <p:grpSp>
                                                                                                                        <p:nvGrpSpPr>
                                                                                                                          <p:cNvPr id="57" name="Gruppo 56"/>
                                                                                                                          <p:cNvGrpSpPr/>
                                                                                                                          <p:nvPr/>
                                                                                                                        </p:nvGrpSpPr>
                                                                                                                        <p:grpSpPr>
                                                                                                                          <a:xfrm>
                                                                                                                            <a:off x="450625" y="874331"/>
                                                                                                                            <a:ext cx="5477024" cy="6505981"/>
                                                                                                                            <a:chOff x="450625" y="874331"/>
                                                                                                                            <a:chExt cx="5477024" cy="6505981"/>
                                                                                                                          </a:xfrm>
                                                                                                                        </p:grpSpPr>
                                                                                                                        <p:grpSp>
                                                                                                                          <p:nvGrpSpPr>
                                                                                                                            <p:cNvPr id="55" name="Gruppo 54"/>
                                                                                                                            <p:cNvGrpSpPr/>
                                                                                                                            <p:nvPr/>
                                                                                                                          </p:nvGrpSpPr>
                                                                                                                          <p:grpSpPr>
                                                                                                                            <a:xfrm>
                                                                                                                              <a:off x="450625" y="874331"/>
                                                                                                                              <a:ext cx="5477024" cy="6505981"/>
                                                                                                                              <a:chOff x="450625" y="874331"/>
                                                                                                                              <a:chExt cx="5477024" cy="6505981"/>
                                                                                                                            </a:xfrm>
                                                                                                                          </p:grpSpPr>
                                                                                                                          <p:grpSp>
                                                                                                                            <p:nvGrpSpPr>
                                                                                                                              <p:cNvPr id="53" name="Gruppo 52"/>
                                                                                                                              <p:cNvGrpSpPr/>
                                                                                                                              <p:nvPr/>
                                                                                                                            </p:nvGrpSpPr>
                                                                                                                            <p:grpSpPr>
                                                                                                                              <a:xfrm>
                                                                                                                                <a:off x="450625" y="874331"/>
                                                                                                                                <a:ext cx="5477024" cy="6505981"/>
                                                                                                                                <a:chOff x="450625" y="874331"/>
                                                                                                                                <a:chExt cx="5477024" cy="6505981"/>
                                                                                                                              </a:xfrm>
                                                                                                                            </p:grpSpPr>
                                                                                                                            <p:grpSp>
                                                                                                                              <p:nvGrpSpPr>
                                                                                                                                <p:cNvPr id="19" name="Gruppo 18"/>
                                                                                                                                <p:cNvGrpSpPr/>
                                                                                                                                <p:nvPr/>
                                                                                                                              </p:nvGrpSpPr>
                                                                                                                              <p:grpSpPr>
                                                                                                                                <a:xfrm>
                                                                                                                                  <a:off x="450625" y="874331"/>
                                                                                                                                  <a:ext cx="5477024" cy="6505981"/>
                                                                                                                                  <a:chOff x="450625" y="874331"/>
                                                                                                                                  <a:chExt cx="5477024" cy="6505981"/>
                                                                                                                                </a:xfrm>
                                                                                                                              </p:grpSpPr>
                                                                                                                              <p:grpSp>
                                                                                                                                <p:nvGrpSpPr>
                                                                                                                                  <p:cNvPr id="13" name="Gruppo 12"/>
                                                                                                                                  <p:cNvGrpSpPr/>
                                                                                                                                  <p:nvPr/>
                                                                                                                                </p:nvGrpSpPr>
                                                                                                                                <p:grpSpPr>
                                                                                                                                  <a:xfrm>
                                                                                                                                    <a:off x="450625" y="874331"/>
                                                                                                                                    <a:ext cx="5477024" cy="6272539"/>
                                                                                                                                    <a:chOff x="450625" y="874331"/>
                                                                                                                                    <a:chExt cx="5477024" cy="6272539"/>
                                                                                                                                  </a:xfrm>
                                                                                                                                </p:grpSpPr>
                                                                                                                                <p:grpSp>
                                                                                                                                  <p:nvGrpSpPr>
                                                                                                                                    <p:cNvPr id="9" name="Gruppo 8"/>
                                                                                                                                    <p:cNvGrpSpPr/>
                                                                                                                                    <p:nvPr/>
                                                                                                                                  </p:nvGrpSpPr>
                                                                                                                                  <p:grpSpPr>
                                                                                                                                    <a:xfrm>
                                                                                                                                      <a:off x="450625" y="874331"/>
                                                                                                                                      <a:ext cx="5477024" cy="6272539"/>
                                                                                                                                      <a:chOff x="450625" y="874331"/>
                                                                                                                                      <a:chExt cx="5477024" cy="6272539"/>
                                                                                                                                    </a:xfrm>
                                                                                                                                  </p:grpSpPr>
                                                                                                                                  <p:grpSp>
                                                                                                                                    <p:nvGrpSpPr>
                                                                                                                                      <p:cNvPr id="6" name="Gruppo 5"/>
                                                                                                                                      <p:cNvGrpSpPr/>
                                                                                                                                      <p:nvPr/>
                                                                                                                                    </p:nvGrpSpPr>
                                                                                                                                    <p:grpSpPr>
                                                                                                                                      <a:xfrm>
                                                                                                                                        <a:off x="477854" y="874331"/>
                                                                                                                                        <a:ext cx="5441115" cy="3029159"/>
                                                                                                                                        <a:chOff x="477854" y="874331"/>
                                                                                                                                        <a:chExt cx="5441115" cy="3029159"/>
                                                                                                                                      </a:xfrm>
                                                                                                                                    </p:grpSpPr>
                                                                                                                                    <p:graphicFrame>
                                                                                                                                      <p:nvGraphicFramePr>
                                                                                                                                        <p:cNvPr id="3" name="Grafico 2"/>
                                                                                                                                        <p:cNvGraphicFramePr>
                                                                                                                                          <a:graphicFrameLocks/>
                                                                                                                                        </p:cNvGraphicFramePr>
                                                                                                                                        <p:nvPr>
                                                                                                                                          <p:extLst>
                                                                                                                                            <p:ext uri="{D42A27DB-BD31-4B8C-83A1-F6EECF244321}">
                                                                                                                                              <p14:modId xmlns:p14="http://schemas.microsoft.com/office/powerpoint/2010/main" val="2235638690"/>
                                                                                                                                            </p:ext>
                                                                                                                                          </p:extLst>
                                                                                                                                        </p:nvPr>
                                                                                                                                      </p:nvGraphicFramePr>
                                                                                                                                      <p:xfrm>
                                                                                                                                        <a:off x="620688" y="1043608"/>
                                                                                                                                        <a:ext cx="5298281" cy="2859882"/>
                                                                                                                                      </p:xfrm>
                                                                                                                                      <a:graphic>
                                                                                                                                        <a:graphicData uri="http://schemas.openxmlformats.org/drawingml/2006/chart">
                                                                                                                                          <c:chart xmlns:c="http://schemas.openxmlformats.org/drawingml/2006/chart" xmlns:r="http://schemas.openxmlformats.org/officeDocument/2006/relationships" r:id="rId2"/>
                                                                                                                                        </a:graphicData>
                                                                                                                                      </a:graphic>
                                                                                                                                    </p:graphicFrame>
                                                                                                                                    <p:sp>
                                                                                                                                      <p:nvSpPr>
                                                                                                                                        <p:cNvPr id="5" name="CasellaDiTesto 4"/>
                                                                                                                                        <p:cNvSpPr txBox="1"/>
                                                                                                                                        <p:nvPr/>
                                                                                                                                      </p:nvSpPr>
                                                                                                                                      <p:spPr>
                                                                                                                                        <a:xfrm>
                                                                                                                                          <a:off x="477854" y="874331"/>
                                                                                                                                          <a:ext cx="197424" cy="338554"/>
                                                                                                                                        </a:xfrm>
                                                                                                                                        <a:prstGeom prst="rect">
                                                                                                                                          <a:avLst/>
                                                                                                                                        </a:prstGeom>
                                                                                                                                        <a:noFill/>
                                                                                                                                      </p:spPr>
                                                                                                                                      <p:txBody>
              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              <a:spAutoFit/>
                                                                                                                                        </a:bodyPr>
                                                                                                                                        <a:lstStyle/>
                                                                                                                                        <a:p>
                                                                                                                                          <a:r>
                                                                                                                                            <a:rPr lang="it-IT" sz="1600" b="1" dirty="0"/>
                                                                                                                                            <a:t>A</a:t>
                                                                                                                                          </a:r>
                                                                                                                                        </a:p>
                                                                                                                                      </p:txBody>
                                                                                                                                    </p:sp>
                                                                                                                                  </p:grpSp>
                                                                                                                                  <p:grpSp>
                                                                                                                                    <p:nvGrpSpPr>
                                                                                                                                      <p:cNvPr id="8" name="Gruppo 7"/>
                                                                                                                                      <p:cNvGrpSpPr/>
                                                                                                                                      <p:nvPr/>
                                                                                                                                    </p:nvGrpSpPr>
                                                                                                                                    <p:grpSpPr>
                                                                                                                                      <a:xfrm>
                                                                                                                                        <a:off x="450625" y="3917593"/>
                                                                                                                                        <a:ext cx="5477024" cy="3229277"/>
                                                                                                                                        <a:chOff x="476752" y="3610635"/>
                                                                                                                                        <a:chExt cx="5477024" cy="3229277"/>
                                                                                                                                      </a:xfrm>
                                                                                                                                    </p:grpSpPr>
                                                                                                                                    <p:graphicFrame>
                                                                                                                                      <p:nvGraphicFramePr>
                                                                                                                                        <p:cNvPr id="4" name="Grafico 3"/>
                                                                                                                                        <p:cNvGraphicFramePr>
                                                                                                                                          <a:graphicFrameLocks/>
                                                                                                                                        </p:cNvGraphicFramePr>
                                                                                                                                        <p:nvPr>
                                                                                                                                          <p:extLst>
                                                                                                                                            <p:ext uri="{D42A27DB-BD31-4B8C-83A1-F6EECF244321}">
                                                                                                                                              <p14:modId xmlns:p14="http://schemas.microsoft.com/office/powerpoint/2010/main" val="2299230856"/>
                                                                                                                                            </p:ext>
                                                                                                                                          </p:extLst>
                                                                                                                                        </p:nvPr>
                                                                                                                                      </p:nvGraphicFramePr>
                                                                                                                                      <p:xfrm>
                                                                                                                                        <a:off x="585880" y="3779912"/>
                                                                                                                                        <a:ext cx="5367896" cy="3060000"/>
                                                                                                                                      </p:xfrm>
                                                                                                                                      <a:graphic>
                                                                                                                                        <a:graphicData uri="http://schemas.openxmlformats.org/drawingml/2006/chart">
                                                                                                                                          <c:chart xmlns:c="http://schemas.openxmlformats.org/drawingml/2006/chart" xmlns:r="http://schemas.openxmlformats.org/officeDocument/2006/relationships" r:id="rId3"/>
                                                                                                                                        </a:graphicData>
                                                                                                                                      </a:graphic>
                                                                                                                                    </p:graphicFrame>
                                                                                                                                    <p:sp>
                                                                                                                                      <p:nvSpPr>
                                                                                                                                        <p:cNvPr id="7" name="CasellaDiTesto 6"/>
                                                                                                                                        <p:cNvSpPr txBox="1"/>
                                                                                                                                        <p:nvPr/>
                                                                                                                                      </p:nvSpPr>
                                                                                                                                      <p:spPr>
                                                                                                                                        <a:xfrm>
                                                                                                                                          <a:off x="476752" y="3610635"/>
                                                                                                                                          <a:ext cx="197424" cy="338554"/>
                                                                                                                                        </a:xfrm>
                                                                                                                                        <a:prstGeom prst="rect">
                                                                                                                                          <a:avLst/>
                                                                                                                                        </a:prstGeom>
                                                                                                                                        <a:noFill/>
                                                                                                                                      </p:spPr>
                                                                                                                                      <p:txBody>
              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              <a:spAutoFit/>
                                                                                                                                        </a:bodyPr>
                                                                                                                                        <a:lstStyle/>
                                                                                                                                        <a:p>
                                                                                                                                          <a:r>
                                                                                                                                            <a:rPr lang="it-IT" sz="1600" b="1" dirty="0"/>
                                                                                                                                            <a:t>B</a:t>
                                                                                                                                          </a:r>
                                                                                                                                        </a:p>
                                                                                                                                      </p:txBody>
                                                                                                                                    </p:sp>
                                                                                                                                  </p:grpSp>
                                                                                                                                </p:grpSp>
                                                                                                                                <p:cxnSp>
                                                                                                                                  <p:nvCxnSpPr>
                                                                                                                                    <p:cNvPr id="11" name="Connettore diritto 10"/>
                                                                                                                                    <p:cNvCxnSpPr/>
                                                                                                                                    <p:nvPr/>
                                                                                                                                  </p:nvCxnSpPr>
                                                                                                                                  <p:spPr>
                                                                                                                                    <a:xfrm>
                                                                                                                                      <a:off x="1117370" y="1966696"/>
                                                                                                                                      <a:ext cx="4608512" cy="0"/>
                                                                                                                                    </a:xfrm>
                                                                                                                                    <a:prstGeom prst="line">
                                                                                                                                      <a:avLst/>
                                                                                                                                    </a:prstGeom>
                                                                                                                                    <a:ln>
                                                                                                                                      <a:solidFill>
  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  </a:solidFill>
                                                                                                                                    </a:ln>
                                                                                                                                  </p:spPr>
                                                                                                                                  <p:style>
                                                                                                                                    <a:lnRef idx="1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lnRef>
                                                                                                                                    <a:fill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fillRef>
                                                                                                                                    <a:effect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effectRef>
                                                                                                                                    <a:fontRef idx="minor">
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</a:fontRef>
                                                                                                                                  </p:style>
                                                                                                                                </p:cxnSp>
                                                                                                                                <p:cxnSp>
                                                                                                                                  <p:nvCxnSpPr>
                                                                                                                                    <p:cNvPr id="12" name="Connettore diritto 11"/>
                                                                                                                                    <p:cNvCxnSpPr/>
                                                                                                                                    <p:nvPr/>
                                                                                                                                  </p:nvCxnSpPr>
                                                                                                                                  <p:spPr>
                                                                                                                                    <a:xfrm>
                                                                                                                                      <a:off x="1132118" y="6049030"/>
                                                                                                                                      <a:ext cx="4608512" cy="0"/>
                                                                                                                                    </a:xfrm>
                                                                                                                                    <a:prstGeom prst="line">
                                                                                                                                      <a:avLst/>
                                                                                                                                    </a:prstGeom>
                                                                                                                                    <a:ln>
                                                                                                                                      <a:solidFill>
  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  </a:solidFill>
                                                                                                                                    </a:ln>
                                                                                                                                  </p:spPr>
                                                                                                                                  <p:style>
                                                                                                                                    <a:lnRef idx="1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lnRef>
                                                                                                                                    <a:fill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fillRef>
                                                                                                                                    <a:effect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effectRef>
                                                                                                                                    <a:fontRef idx="minor">
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</a:fontRef>
                                                                                                                                  </p:style>
                                                                                                                                </p:cxnSp>
                                                                                                                              </p:grpSp>
                                                                                                                              <p:grpSp>
                                                                                                                                <p:nvGrpSpPr>
                                                                                                                                  <p:cNvPr id="18" name="Gruppo 17"/>
                                                                                                                                  <p:cNvGrpSpPr/>
                                                                                                                                  <p:nvPr/>
                                                                                                                                </p:nvGrpSpPr>
                                                                                                                                <p:grpSpPr>
                                                                                                                                  <a:xfrm>
                                                                                                                                    <a:off x="1164922" y="7103313"/>
                                                                                                                                    <a:ext cx="4442884" cy="276999"/>
                                                                                                                                    <a:chOff x="1824907" y="8716568"/>
                                                                                                                                    <a:chExt cx="4442884" cy="276999"/>
                                                                                                                                  </a:xfrm>
                                                                                                                                </p:grpSpPr>
                                                                                                                                <p:cxnSp>
                                                                                                                                  <p:nvCxnSpPr>
                                                                                                                                    <p:cNvPr id="14" name="Connettore diritto 13"/>
                                                                                                                                    <p:cNvCxnSpPr/>
                                                                                                                                    <p:nvPr/>
                                                                                                                                  </p:nvCxnSpPr>
                                                                                                                                  <p:spPr>
                                                                                                                                    <a:xfrm>
                                                                                                                                      <a:off x="1824907" y="8748464"/>
                                                                                                                                      <a:ext cx="1476000" cy="0"/>
                                                                                                                                    </a:xfrm>
                                                                                                                                    <a:prstGeom prst="line">
                                                                                                                                      <a:avLst/>
                                                                                                                                    </a:prstGeom>
                                                                                                                                    <a:ln>
                                                                                                                                      <a:solidFill>
  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  </a:solidFill>
                                                                                                                                    </a:ln>
                                                                                                                                  </p:spPr>
                                                                                                                                  <p:style>
                                                                                                                                    <a:lnRef idx="1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lnRef>
                                                                                                                                    <a:fill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fillRef>
                                                                                                                                    <a:effect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effectRef>
                                                                                                                                    <a:fontRef idx="minor">
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</a:fontRef>
                                                                                                                                  </p:style>
                                                                                                                                </p:cxnSp>
                                                                                                                                <p:cxnSp>
                                                                                                                                  <p:nvCxnSpPr>
                                                                                                                                    <p:cNvPr id="15" name="Connettore diritto 14"/>
                                                                                                                                    <p:cNvCxnSpPr/>
                                                                                                                                    <p:nvPr/>
                                                                                                                                  </p:nvCxnSpPr>
                                                                                                                                  <p:spPr>
                                                                                                                                    <a:xfrm>
                                                                                                                                      <a:off x="3387791" y="8748464"/>
                                                                                                                                      <a:ext cx="2880000" cy="0"/>
                                                                                                                                    </a:xfrm>
                                                                                                                                    <a:prstGeom prst="line">
                                                                                                                                      <a:avLst/>
                                                                                                                                    </a:prstGeom>
                                                                                                                                    <a:ln>
                                                                                                                                      <a:solidFill>
  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  </a:solidFill>
                                                                                                                                    </a:ln>
                                                                                                                                  </p:spPr>
                                                                                                                                  <p:style>
                                                                                                                                    <a:lnRef idx="1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lnRef>
                                                                                                                                    <a:fill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fillRef>
                                                                                                                                    <a:effectRef idx="0">
                                                                                                                                      <a:schemeClr val="accent1"/>
                                                                                                                                    </a:effectRef>
                                                                                                                                    <a:fontRef idx="minor">
                                                                                                                                      <a:schemeClr val="tx1"/>
                                                                                                                                    </a:fontRef>
                                                                                                                                  </p:style>
                                                                                                                                </p:cxnSp>
                                                                                                                                <p:sp>
                                                                                                                                  <p:nvSpPr>
                                                                                                                                    <p:cNvPr id="16" name="CasellaDiTesto 15"/>
                                                                                                                                    <p:cNvSpPr txBox="1"/>
                                                                                                                                    <p:nvPr/>
                                                                                                                                  </p:nvSpPr>
                                                                                                                                  <p:spPr>
                                                                                                                                    <a:xfrm>
                                                                                                                                      <a:off x="2363668" y="8716568"/>
                                                                                                                                      <a:ext cx="585037" cy="276999"/>
                                                                                                                                    </a:xfrm>
                                                                                                                                    <a:prstGeom prst="rect">
                                                                                                                                      <a:avLst/>
                                                                                                                                    </a:prstGeom>
                                                                                                                                    <a:noFill/>
                                                                                                                                  </p:spPr>
                                                                                                                                  <p:txBody>
          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          <a:spAutoFit/>
                                                                                                                                    </a:bodyPr>
                                                                                                                                    <a:lstStyle/>
                                                                                                                                    <a:p>
                                                                                                                                      <a:r>
                                                                                                                                        <a:rPr lang="it-IT" sz="1200" dirty="0"/>
                                                                                                                                        <a:t>+HM</a:t>
                                                                                                                                      </a:r>
                                                                                                                                    </a:p>
                                                                                                                                  </p:txBody>
                                                                                                                                </p:sp>
                                                                                                                                <p:sp>
                                                                                                                                  <p:nvSpPr>
                                                                                                                                    <p:cNvPr id="17" name="CasellaDiTesto 16"/>
                                                                                                                                    <p:cNvSpPr txBox="1"/>
                                                                                                                                    <p:nvPr/>
                                                                                                                                  </p:nvSpPr>
                                                                                                                                  <p:spPr>
                                                                                                                                    <a:xfrm>
                                                                                                                                      <a:off x="4557153" y="8716568"/>
                                                                                                                                      <a:ext cx="585037" cy="276999"/>
                                                                                                                                    </a:xfrm>
                                                                                                                                    <a:prstGeom prst="rect">
                                                                                                                                      <a:avLst/>
                                                                                                                                    </a:prstGeom>
                                                                                                                                    <a:noFill/>
                                                                                                                                  </p:spPr>
                                                                                                                                  <p:txBody>
          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          <a:spAutoFit/>
                                                                                                                                    </a:bodyPr>
                                                                                                                                    <a:lstStyle/>
                                                                                                                                    <a:p>
                                                                                                                                      <a:r>
                                                                                                                                        <a:rPr lang="it-IT" sz="1200" dirty="0"/>
                                                                                                                                        <a:t>-HM</a:t>
                                                                                                                                      </a:r>
                                                                                                                                    </a:p>
                                                                                                                                  </p:txBody>
                                                                                                                                </p:sp>
                                                                                                                              </p:grpSp>
                                                                                                                            </p:grpSp>
                                                                                                                            <p:sp>
                                                                                                                              <p:nvSpPr>
                                                                                                                                <p:cNvPr id="52" name="CasellaDiTesto 51"/>
                                                                                                                                <p:cNvSpPr txBox="1"/>
                                                                                                                                <p:nvPr/>
                                                                                                                              </p:nvSpPr>
                                                                                                                              <p:spPr>
                                                                                                                                <a:xfrm>
                                                                                                                                  <a:off x="1065426" y="5920407"/>
                                                                                                                                  <a:ext cx="280658" cy="307777"/>
                                                                                                                                </a:xfrm>
                                                                                                                                <a:prstGeom prst="rect">
                                                                                                                                  <a:avLst/>
                                                                                                                                </a:prstGeom>
                                                                                                                                <a:noFill/>
                                                                                                                              </p:spPr>
                                                                                                                              <p:txBody>
      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      <a:spAutoFit/>
                                                                                                                                </a:bodyPr>
                                                                                                                                <a:lstStyle/>
                                                                                                                                <a:p>
                                                                                                                                  <a:pPr algn="ctr"/>
                                                                                                                                  <a:r>
      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      <a:t>**</a:t>
                                                                                                                                  </a:r>
                                                                                                                                </a:p>
                                                                                                                                <a:p>
                                                                                                                                  <a:pPr algn="ctr"/>
                                                                                                                                  <a:r>
      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      <a:t>8</a:t>
                                                                                                                                  </a:r>
                                                                                                                                </a:p>
                                                                                                                              </p:txBody>
                                                                                                                            </p:sp>
                                                                                                                          </p:grpSp>
                                                                                                                          <p:sp>
                                                                                                                            <p:nvSpPr>
                                                                                                                              <p:cNvPr id="54" name="CasellaDiTesto 53"/>
                                                                                                                              <p:cNvSpPr txBox="1"/>
                                                                                                                              <p:nvPr/>
                                                                                                                            </p:nvSpPr>
                                                                                                                            <p:spPr>
                                                                                                                              <a:xfrm>
                                                                                                                                <a:off x="1071584" y="1947816"/>
                                                                                                                                <a:ext cx="280658" cy="307777"/>
                                                                                                                              </a:xfrm>
                                                                                                                              <a:prstGeom prst="rect">
                                                                                                                                <a:avLst/>
                                                                                                                              </a:prstGeom>
                                                                                                                              <a:noFill/>
                                                                                                                            </p:spPr>
                                                                                                                            <p:txBody>
    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    <a:spAutoFit/>
                                                                                                                              </a:bodyPr>
                                                                                                                              <a:lstStyle/>
                                                                                                                              <a:p>
                                                                                                                                <a:pPr algn="ctr"/>
                                                                                                                                <a:r>
    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    <a:t>*</a:t>
                                                                                                                                </a:r>
                                                                                                                              </a:p>
                                                                                                                              <a:p>
                                                                                                                                <a:pPr algn="ctr"/>
                                                                                                                                <a:r>
    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    <a:t>8</a:t>
                                                                                                                                </a:r>
                                                                                                                              </a:p>
                                                                                                                            </p:txBody>
                                                                                                                          </p:sp>
                                                                                                                        </p:grpSp>
                                                                                                                        <p:sp>
                                                                                                                          <p:nvSpPr>
                                                                                                                            <p:cNvPr id="56" name="CasellaDiTesto 55"/>
                                                                                                                            <p:cNvSpPr txBox="1"/>
                                                                                                                            <p:nvPr/>
                                                                                                                          </p:nvSpPr>
                                                                                                                          <p:spPr>
                                                                                                                            <a:xfrm>
                                                                                                                              <a:off x="1223984" y="2410379"/>
                                                                                                                              <a:ext cx="280658" cy="307777"/>
                                                                                                                            </a:xfrm>
                                                                                                                            <a:prstGeom prst="rect">
                                                                                                                              <a:avLst/>
                                                                                                                            </a:prstGeom>
                                                                                                                            <a:noFill/>
                                                                                                                          </p:spPr>
                                                                                                                          <p:txBody>
  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  <a:spAutoFit/>
                                                                                                                            </a:bodyPr>
                                                                                                                            <a:lstStyle/>
                                                                                                                            <a:p>
                                                                                                                              <a:pPr algn="ctr"/>
                                                                                                                              <a:r>
  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  <a:t>**</a:t>
                                                                                                                              </a:r>
                                                                                                                            </a:p>
                                                                                                                            <a:p>
                                                                                                                              <a:pPr algn="ctr"/>
                                                                                                                              <a:r>
  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  <a:t>10</a:t>
                                                                                                                              </a:r>
                                                                                                                            </a:p>
                                                                                                                          </p:txBody>
                                                                                                                        </p:sp>
                                                                                                                      </p:grpSp>
                                                                                                                      <p:sp>
                                                                                                                        <p:nvSpPr>
                                                                                                                          <p:cNvPr id="58" name="CasellaDiTesto 57"/>
                                                                                                                          <p:cNvSpPr txBox="1"/>
                                                                                                                          <p:nvPr/>
                                                                                                                        </p:nvSpPr>
                                                                                                                        <p:spPr>
                                                                                                                          <a:xfrm>
                                                                                                                            <a:off x="1223142" y="4113372"/>
                                                                                                                            <a:ext cx="280658" cy="307777"/>
                                                                                                                          </a:xfrm>
                                                                                                                          <a:prstGeom prst="rect">
                                                                                                                            <a:avLst/>
                                                                                                                          </a:prstGeom>
                                                                                                                          <a:noFill/>
                                                                                                                        </p:spPr>
                                                                                                                        <p:txBody>
                                                                                                                          <a:bodyPr wrap="square" rtlCol="0">
                                                                                                                            <a:spAutoFit/>
                                                                                                                          </a:bodyPr>
                                                                                                                          <a:lstStyle/>
                                                                                                                          <a:p>
                                                                                                                            <a:pPr algn="ctr"/>
                                                                                                                            <a:r>
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<a:t>**</a:t>
                                                                                                                            </a:r>
                                                                                                                          </a:p>
                                                                                                                          <a:p>
                                                                                                                            <a:pPr algn="ctr"/>
                                                                                                                            <a:r>
  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  <a:t>10</a:t>
                                                                                                                            </a:r>
                                                                                                                          </a:p>
                                                                                                                        </p:txBody>
                                                                                                                      </p:sp>
                                                                                                                    </p:grpSp>
                                                                                                                    <p:sp>
                                                                                                                      <p:nvSpPr>
                                                                                                                        <p:cNvPr id="60" name="CasellaDiTesto 59"/>
                                                                                                                        <p:cNvSpPr txBox="1"/>
                                                                                                                        <p:nvPr/>
                                                                                                                      </p:nvSpPr>
                                                                                                                      <p:spPr>
                                                                                                                        <a:xfrm>
                                                                                                                          <a:off x="1381700" y="2262428"/>
                                                                                                                          <a:ext cx="280658" cy="307777"/>
                                                                                                                        </a:xfrm>
                                                                                                                        <a:prstGeom prst="rect">
                                                                                                                          <a:avLst/>
                                                                                                                        </a:prstGeom>
                                                                                                                        <a:noFill/>
                                                                                                                      </p:spPr>
                                                                                                                      <p:txBody>
                                                                                                                        <a:bodyPr wrap="square" rtlCol="0">
                                                                                                                          <a:spAutoFit/>
                                                                                                                        </a:bodyPr>
                                                                                                                        <a:lstStyle/>
                                                                                                                        <a:p>
                                                                                                                          <a:pPr algn="ctr"/>
                                                                                                                          <a:r>
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<a:t>**</a:t>
                                                                                                                          </a:r>
                                                                                                                        </a:p>
                                                                                                                        <a:p>
                                                                                                                          <a:pPr algn="ctr"/>
                                                                                                                          <a:r>
  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  <a:t>9</a:t>
                                                                                                                          </a:r>
                                                                                                                        </a:p>
                                                                                                                      </p:txBody>
                                                                                                                    </p:sp>
                                                                                                                  </p:grpSp>
                                                                                                                  <p:sp>
                                                                                                                    <p:nvSpPr>
                                                                                                                      <p:cNvPr id="62" name="CasellaDiTesto 61"/>
                                                                                                                      <p:cNvSpPr txBox="1"/>
                                                                                                                      <p:nvPr/>
                                                                                                                    </p:nvSpPr>
                                                                                                                    <p:spPr>
                                                                                                                      <a:xfrm>
                                                                                                                        <a:off x="1380858" y="5267916"/>
                                                                                                                        <a:ext cx="280658" cy="307777"/>
                                                                                                                      </a:xfrm>
                                                                                                                      <a:prstGeom prst="rect">
                                                                                                                        <a:avLst/>
                                                                                                                      </a:prstGeom>
                                                                                                                      <a:noFill/>
                                                                                                                    </p:spPr>
                                                                                                                    <p:txBody>
                                                                                                                      <a:bodyPr wrap="square" rtlCol="0">
                                                                                                                        <a:spAutoFit/>
                                                                                                                      </a:bodyPr>
                                                                                                                      <a:lstStyle/>
                                                                                                                      <a:p>
                                                                                                                        <a:pPr algn="ctr"/>
                                                                                                                        <a:r>
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<a:t>**</a:t>
                                                                                                                        </a:r>
                                                                                                                      </a:p>
                                                                                                                      <a:p>
                                                                                                                        <a:pPr algn="ctr"/>
                                                                                                                        <a:r>
  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  <a:t>9</a:t>
                                                                                                                        </a:r>
                                                                                                                      </a:p>
                                                                                                                    </p:txBody>
                                                                                                                  </p:sp>
                                                                                                                </p:grpSp>
                                                                                                                <p:sp>
                                                                                                                  <p:nvSpPr>
                                                                                                                    <p:cNvPr id="64" name="CasellaDiTesto 63"/>
                                                                                                                    <p:cNvSpPr txBox="1"/>
                                                                                                                    <p:nvPr/>
                                                                                                                  </p:nvSpPr>
                                                                                                                  <p:spPr>
                                                                                                                    <a:xfrm>
                                                                                                                      <a:off x="1539416" y="2123728"/>
                                                                                                                      <a:ext cx="280658" cy="307777"/>
                                                                                                                    </a:xfrm>
                                                                                                                    <a:prstGeom prst="rect">
                                                                                                                      <a:avLst/>
                                                                                                                    </a:prstGeom>
                                                                                                                    <a:noFill/>
                                                                                                                  </p:spPr>
                                                                                                                  <p:txBody>
                                                                                                                    <a:bodyPr wrap="square" rtlCol="0">
                                                                                                                      <a:spAutoFit/>
                                                                                                                    </a:bodyPr>
                                                                                                                    <a:lstStyle/>
                                                                                                                    <a:p>
                                                                                                                      <a:pPr algn="ctr"/>
                                                                                                                      <a:r>
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<a:t>**</a:t>
                                                                                                                      </a:r>
                                                                                                                    </a:p>
                                                                                                                    <a:p>
                                                                                                                      <a:pPr algn="ctr"/>
                                                                                                                      <a:r>
                                                                                                                        <a:rPr lang="it-IT" sz="700" dirty="0"/>
                                                                                                                        <a:t>9</a:t>
                                                                                                                      </a:r>
                                                                                                                    </a:p>
                                                                                                                  </p:txBody>
                                                                                                                </p:sp>
                                                                                                              </p:grpSp>
                                                                                                              <p:sp>
                                                                                                                <p:nvSpPr>
                                                                                                                  <p:cNvPr id="66" name="CasellaDiTesto 65"/>
                                                                                                                  <p:cNvSpPr txBox="1"/>
                                                                                                                  <p:nvPr/>
                                                                                                                </p:nvSpPr>
                                                                                                                <p:spPr>
                                                                                                                  <a:xfrm>
                                                                                                                    <a:off x="1533258" y="5910693"/>
                                                                                                                    <a:ext cx="280658" cy="200055"/>
                                                                                                                  </a:xfrm>
                                                                                                                  <a:prstGeom prst="rect">
                                                                                                                    <a:avLst/>
                                                                                                                  </a:prstGeom>
                                                                                                                  <a:noFill/>
                                                                                                                </p:spPr>
                                                                                                                <p:txBody>
                                                                                                                  <a:bodyPr wrap="square" rtlCol="0">
                                                                                                                    <a:spAutoFit/>
                                                                                                                  </a:bodyPr>
                                                                                                                  <a:lstStyle/>
                                                                                                                  <a:p>
                                                                                                                    <a:pPr algn="ctr"/>
                                                                                                                    <a:r>
                                                                                                                      <a:rPr lang="it-IT" sz="700" dirty="0"/>
                                                                                                                      <a:t>9</a:t>
                                                                                                                    </a:r>
                                                                                                                  </a:p>
                                                                                                                </p:txBody>
                                                                                                              </p:sp>
                                                                                                            </p:grpSp>
                                                                                                            <p:sp>
                                                                                                              <p:nvSpPr>
                                                                                                                <p:cNvPr id="68" name="CasellaDiTesto 67"/>
                                                                                                                <p:cNvSpPr txBox="1"/>
                                                                                                                <p:nvPr/>
                                                                                                              </p:nvSpPr>
                                                                                                              <p:spPr>
                                                                                                                <a:xfrm>
                                                                                                                  <a:off x="1691816" y="1963764"/>
                                                                                                                  <a:ext cx="280658" cy="307777"/>
                                                                                                                </a:xfrm>
                                                                                                                <a:prstGeom prst="rect">
                                                                                                                  <a:avLst/>
                                                                                                                </a:prstGeom>
                                                                                                                <a:noFill/>
                                                                                                              </p:spPr>
                                                                                                              <p:txBody>
                                                                                                                <a:bodyPr wrap="square" rtlCol="0">
                                                                                                                  <a:spAutoFit/>
                                                                                                                </a:bodyPr>
                                                                                                                <a:lstStyle/>
                                                                                                                <a:p>
                                                                                                                  <a:pPr algn="ctr"/>
                                                                                                                  <a:r>
                                                                                                                    <a:rPr lang="it-IT" sz="700" dirty="0"/>
                                                                                                                    <a:t>**</a:t>
                                                                                                                  </a:r>
                                                                                                                </a:p>
                                                                                                                <a:p>
                                                                                                                  <a:pPr algn="ctr"/>
                                                                                                                  <a:r>
                                                                                                                    <a:rPr lang="it-IT" sz="700" dirty="0"/>
                                                                                                                    <a:t>9</a:t>
                                                                                                                  </a:r>
                                                                                                                </a:p>
                                                                                                              </p:txBody>
                                                                                                            </p:sp>
                                                                                                          </p:grpSp>
                                                                                                          <p:sp>
                                                                                                            <p:nvSpPr>
                                                                                                              <p:cNvPr id="70" name="CasellaDiTesto 69"/>
                                                                                                              <p:cNvSpPr txBox="1"/>
                                                                                                              <p:nvPr/>
                                                                                                            </p:nvSpPr>
                                                                                                            <p:spPr>
                                                                                                              <a:xfrm>
                                                                                                                <a:off x="1692234" y="5900040"/>
                                                                                                                <a:ext cx="280658" cy="307777"/>
                                                                                                              </a:xfrm>
                                                                                                              <a:prstGeom prst="rect">
                                                                                                                <a:avLst/>
                                                                                                              </a:prstGeom>
                                                                                                              <a:noFill/>
                                                                                                            </p:spPr>
                                                                                                            <p:txBody>
                                                                                                              <a:bodyPr wrap="square" rtlCol="0">
                                                                                                                <a:spAutoFit/>
                                                                                                              </a:bodyPr>
                                                                                                              <a:lstStyle/>
                                                                                                              <a:p>
                                                                                                                <a:pPr algn="ctr"/>
                                                                                                                <a:r>
                                                                                                                  <a:rPr lang="it-IT" sz="700" dirty="0"/>
                                                                                                                  <a:t>**</a:t>
                                                                                                                </a:r>
                                                                                                              </a:p>
                                                                                                              <a:p>
                                                                                                                <a:pPr algn="ctr"/>
                                                                                                                <a:r>
                                                                                                                  <a:rPr lang="it-IT" sz="700" dirty="0"/>
                                                                                                                  <a:t>9</a:t>
                                                                                                                </a:r>
                                                                                                              </a:p>
                                                                                                            </p:txBody>
                                                                                                          </p:sp>
                                                                                                        </p:grpSp>
                                                                                                        <p:sp>
                                                                                                          <p:nvSpPr>
                                                                                                            <p:cNvPr id="72" name="CasellaDiTesto 71"/>
                                                                                                            <p:cNvSpPr txBox="1"/>
                                                                                                            <p:nvPr/>
                                                                                                          </p:nvSpPr>
                                                                                                          <p:spPr>
                                                                                                            <a:xfrm>
                                                                                                              <a:off x="1849532" y="2148060"/>
                                                                                                              <a:ext cx="280658" cy="307777"/>
                                                                                                            </a:xfrm>
                                                                                                            <a:prstGeom prst="rect">
                                                                                                              <a:avLst/>
                                                                                                            </a:prstGeom>
                                                                                                            <a:noFill/>
                                                                                                          </p:spPr>
                                                                                                          <p:txBody>
                                                                                                            <a:bodyPr wrap="square" rtlCol="0">
                                                                                                              <a:spAutoFit/>
                                                                                                            </a:bodyPr>
                                                                                                            <a:lstStyle/>
                                                                                                            <a:p>
                                                                                                              <a:pPr algn="ctr"/>
                                                                                                              <a:r>
                                                                                                                <a:rPr lang="it-IT" sz="700" dirty="0"/>
                                                                                                                <a:t>**</a:t>
                                                                                                              </a:r>
                                                                                                            </a:p>
                                                                                                            <a:p>
                                                                                                              <a:pPr algn="ctr"/>
                                                                                                              <a:r>
                                                                                                                <a:rPr lang="it-IT" sz="700" dirty="0"/>
                                                                                                                <a:t>9</a:t>
                                                                                                              </a:r>
                                                                                                            </a:p>
                                                                                                          </p:txBody>
                                                                                                        </p:sp>
                                                                                                      </p:grpSp>
                                                                                                      <p:sp>
                                                                                                        <p:nvSpPr>
                                                                                                          <p:cNvPr id="74" name="CasellaDiTesto 73"/>
                                                                                                          <p:cNvSpPr txBox="1"/>
                                                                                                          <p:nvPr/>
                                                                                                        </p:nvSpPr>
                                                                                                        <p:spPr>
                                                                                                          <a:xfrm>
                                                                                                            <a:off x="1844634" y="5478624"/>
                                                                                                            <a:ext cx="280658" cy="307777"/>
                                                                                                          </a:xfrm>
                                                                                                          <a:prstGeom prst="rect">
                                                                                                            <a:avLst/>
                                                                                                          </a:prstGeom>
                                                                                                          <a:noFill/>
                                                                                                        </p:spPr>
                                                                                                        <p:txBody>
                                                                                                          <a:bodyPr wrap="square" rtlCol="0">
                                                                                                            <a:spAutoFit/>
                                                                                                          </a:bodyPr>
                                                                                                          <a:lstStyle/>
                                                                                                          <a:p>
                                                                                                            <a:pPr algn="ctr"/>
                                                                                                            <a:r>
                                                                                                              <a:rPr lang="it-IT" sz="700" dirty="0"/>
                                                                                                              <a:t>**</a:t>
                                                                                                            </a:r>
                                                                                                          </a:p>
                                                                                                          <a:p>
                                                                                                            <a:pPr algn="ctr"/>
                                                                                                            <a:r>
                                                                                                              <a:rPr lang="it-IT" sz="700" dirty="0"/>
                                                                                                              <a:t>9</a:t>
                                                                                                            </a:r>
                                                                                                          </a:p>
                                                                                                        </p:txBody>
                                                                                                      </p:sp>
                                                                                                    </p:grpSp>
                                                                                                    <p:sp>
                                                                                                      <p:nvSpPr>
                                                                                                        <p:cNvPr id="76" name="CasellaDiTesto 75"/>
                                                                                                        <p:cNvSpPr txBox="1"/>
                                                                                                        <p:nvPr/>
                                                                                                      </p:nvSpPr>
                                                                                                      <p:spPr>
                                                                                                        <a:xfrm>
                                                                                                          <a:off x="2001932" y="1969080"/>
                                                                                                          <a:ext cx="280658" cy="307777"/>
                                                                                                        </a:xfrm>
                                                                                                        <a:prstGeom prst="rect">
                                                                                                          <a:avLst/>
                                                                                                        </a:prstGeom>
                                                                                                        <a:noFill/>
                                                                                                      </p:spPr>
                                                                                                      <p:txBody>
                                                                                                        <a:bodyPr wrap="square" rtlCol="0">
                                                                                                          <a:spAutoFit/>
                                                                                                        </a:bodyPr>
                                                                                                        <a:lstStyle/>
                                                                                                        <a:p>
                                                                                                          <a:pPr algn="ctr"/>
                                                                                                          <a:r>
                                                                                                            <a:rPr lang="it-IT" sz="700" dirty="0"/>
                                                                                                            <a:t>**</a:t>
                                                                                                          </a:r>
                                                                                                        </a:p>
                                                                                                        <a:p>
                                                                                                          <a:pPr algn="ctr"/>
                                                                                                          <a:r>
                                                                                                            <a:rPr lang="it-IT" sz="700" dirty="0"/>
                                                                                                            <a:t>9</a:t>
                                                                                                          </a:r>
                                                                                                        </a:p>
                                                                                                      </p:txBody>
                                                                                                    </p:sp>
                                                                                                  </p:grpSp>
                                                                                                  <p:sp>
                                                                                                    <p:nvSpPr>
                                                                                                      <p:cNvPr id="78" name="CasellaDiTesto 77"/>
                                                                                                      <p:cNvSpPr txBox="1"/>
                                                                                                      <p:nvPr/>
                                                                                                    </p:nvSpPr>
                                                                                                    <p:spPr>
                                                                                                      <a:xfrm>
                                                                                                        <a:off x="2002350" y="5056311"/>
                                                                                                        <a:ext cx="280658" cy="307777"/>
                                                                                                      </a:xfrm>
                                                                                                      <a:prstGeom prst="rect">
                                                                                                        <a:avLst/>
                                                                                                      </a:prstGeom>
                                                                                                      <a:noFill/>
                                                                                                    </p:spPr>
                                                                                                    <p:txBody>
                                                                                                      <a:bodyPr wrap="square" rtlCol="0">
                                                                                                        <a:spAutoFit/>
                                                                                                      </a:bodyPr>
                                                                                                      <a:lstStyle/>
                                                                                                      <a:p>
                                                                                                        <a:pPr algn="ctr"/>
                                                                                                        <a:r>
                                                                                                          <a:rPr lang="it-IT" sz="700" dirty="0"/>
                                                                                                          <a:t>**</a:t>
                                                                                                        </a:r>
                                                                                                      </a:p>
                                                                                                      <a:p>
                                                                                                        <a:pPr algn="ctr"/>
                                                                                                        <a:r>
                                                                                                          <a:rPr lang="it-IT" sz="700" dirty="0"/>
                                                                                                          <a:t>9</a:t>
                                                                                                        </a:r>
                                                                                                      </a:p>
                                                                                                    </p:txBody>
                                                                                                  </p:sp>
                                                                                                </p:grpSp>
                                                                                                <p:sp>
                                                                                                  <p:nvSpPr>
                                                                                                    <p:cNvPr id="80" name="CasellaDiTesto 79"/>
                                                                                                    <p:cNvSpPr txBox="1"/>
                                                                                                    <p:nvPr/>
                                                                                                  </p:nvSpPr>
                                                                                                  <p:spPr>
                                                                                                    <a:xfrm>
                                                                                                      <a:off x="2159648" y="1939600"/>
                                                                                                      <a:ext cx="280658" cy="307777"/>
                                                                                                    </a:xfrm>
                                                                                                    <a:prstGeom prst="rect">
                                                                                                      <a:avLst/>
                                                                                                    </a:prstGeom>
                                                                                                    <a:noFill/>
                                                                                                  </p:spPr>
                                                                                                  <p:txBody>
                                                                                                    <a:bodyPr wrap="square" rtlCol="0">
                                                                                                      <a:spAutoFit/>
                                                                                                    </a:bodyPr>
                                                                                                    <a:lstStyle/>
                                                                                                    <a:p>
                                                                                                      <a:pPr algn="ctr"/>
                                                                                                      <a:r>
                                                                                                        <a:rPr lang="it-IT" sz="700" dirty="0"/>
                                                                                                        <a:t>**</a:t>
                                                                                                      </a:r>
                                                                                                    </a:p>
                                                                                                    <a:p>
                                                                                                      <a:pPr algn="ctr"/>
                                                                                                      <a:r>
                                                                                                        <a:rPr lang="it-IT" sz="700" dirty="0"/>
                                                                                                        <a:t>8</a:t>
                                                                                                      </a:r>
                                                                                                    </a:p>
                                                                                                  </p:txBody>
                                                                                                </p:sp>
                                                                                              </p:grpSp>
                                                                                              <p:sp>
                                                                                                <p:nvSpPr>
                                                                                                  <p:cNvPr id="82" name="CasellaDiTesto 81"/>
                                                                                                  <p:cNvSpPr txBox="1"/>
                                                                                                  <p:nvPr/>
                                                                                                </p:nvSpPr>
                                                                                                <p:spPr>
                                                                                                  <a:xfrm>
                                                                                                    <a:off x="2160066" y="4745496"/>
                                                                                                    <a:ext cx="280658" cy="307777"/>
                                                                                                  </a:xfrm>
                                                                                                  <a:prstGeom prst="rect">
                                                                                                    <a:avLst/>
                                                                                                  </a:prstGeom>
                                                                                                  <a:noFill/>
                                                                                                </p:spPr>
                                                                                                <p:txBody>
                                                                                                  <a:bodyPr wrap="square" rtlCol="0">
                                                                                                    <a:spAutoFit/>
                                                                                                  </a:bodyPr>
                                                                                                  <a:lstStyle/>
                                                                                                  <a:p>
                                                                                                    <a:pPr algn="ctr"/>
                                                                                                    <a:r>
                                                                                                      <a:rPr lang="it-IT" sz="700" dirty="0"/>
                                                                                                      <a:t>**</a:t>
                                                                                                    </a:r>
                                                                                                  </a:p>
                                                                                                  <a:p>
                                                                                                    <a:pPr algn="ctr"/>
                                                                                                    <a:r>
                                                                                                      <a:rPr lang="it-IT" sz="700" dirty="0"/>
                                                                                                      <a:t>8</a:t>
                                                                                                    </a:r>
                                                                                                  </a:p>
                                                                                                </p:txBody>
                                                                                              </p:sp>
                                                                                            </p:grpSp>
                                                                                            <p:sp>
                                                                                              <p:nvSpPr>
                                                                                                <p:cNvPr id="84" name="CasellaDiTesto 83"/>
                                                                                                <p:cNvSpPr txBox="1"/>
                                                                                                <p:nvPr/>
                                                                                              </p:nvSpPr>
                                                                                              <p:spPr>
                                                                                                <a:xfrm>
                                                                                                  <a:off x="2312048" y="2304059"/>
                                                                                                  <a:ext cx="280658" cy="307777"/>
                                                                                                </a:xfrm>
                                                                                                <a:prstGeom prst="rect">
                                                                                                  <a:avLst/>
                                                                                                </a:prstGeom>
                                                                                                <a:noFill/>
                                                                                              </p:spPr>
                                                                                              <p:txBody>
                                                                                                <a:bodyPr wrap="square" rtlCol="0">
                                                                                                  <a:spAutoFit/>
                                                                                                </a:bodyPr>
                                                                                                <a:lstStyle/>
                                                                                                <a:p>
                                                                                                  <a:pPr algn="ctr"/>
                                                                                                  <a:r>
                                                                                                    <a:rPr lang="it-IT" sz="700" dirty="0"/>
                                                                                                    <a:t>**</a:t>
                                                                                                  </a:r>
                                                                                                </a:p>
                                                                                                <a:p>
                                                                                                  <a:pPr algn="ctr"/>
                                                                                                  <a:r>
                                                                                                    <a:rPr lang="it-IT" sz="700" dirty="0"/>
                                                                                                    <a:t>10</a:t>
                                                                                                  </a:r>
                                                                                                </a:p>
                                                                                              </p:txBody>
                                                                                            </p:sp>
                                                                                          </p:grpSp>
                                                                                          <p:sp>
                                                                                            <p:nvSpPr>
                                                                                              <p:cNvPr id="86" name="CasellaDiTesto 85"/>
                                                                                              <p:cNvSpPr txBox="1"/>
                                                                                              <p:nvPr/>
                                                                                            </p:nvSpPr>
                                                                                            <p:spPr>
                                                                                              <a:xfrm>
                                                                                                <a:off x="2312466" y="4919160"/>
                                                                                                <a:ext cx="280658" cy="200055"/>
                                                                                              </a:xfrm>
                                                                                              <a:prstGeom prst="rect">
                                                                                                <a:avLst/>
                                                                                              </a:prstGeom>
                                                                                              <a:noFill/>
                                                                                            </p:spPr>
                                                                                            <p:txBody>
                                                                                              <a:bodyPr wrap="square" rtlCol="0">
                                                                                                <a:spAutoFit/>
                                                                                              </a:bodyPr>
                                                                                              <a:lstStyle/>
                                                                                              <a:p>
                                                                                                <a:pPr algn="ctr"/>
                                                                                                <a:r>
                                                                                                  <a:rPr lang="it-IT" sz="700" dirty="0"/>
                                                                                                  <a:t>10</a:t>
                                                                                                </a:r>
                                                                                              </a:p>
                                                                                            </p:txBody>
                                                                                          </p:sp>
                                                                                        </p:grpSp>
                                                                                        <p:sp>
                                                                                          <p:nvSpPr>
                                                                                            <p:cNvPr id="88" name="CasellaDiTesto 87"/>
                                                                                            <p:cNvSpPr txBox="1"/>
                                                                                            <p:nvPr/>
                                                                                          </p:nvSpPr>
                                                                                          <p:spPr>
                                                                                            <a:xfrm>
                                                                                              <a:off x="2469764" y="2304956"/>
                                                                                              <a:ext cx="280658" cy="307777"/>
                                                                                            </a:xfrm>
                                                                                            <a:prstGeom prst="rect">
                                                                                              <a:avLst/>
                                                                                            </a:prstGeom>
                                                                                            <a:noFill/>
                                                                                          </p:spPr>
                                                                                          <p:txBody>
                                                                                            <a:bodyPr wrap="square" rtlCol="0">
                                                                                              <a:spAutoFit/>
                                                                                            </a:bodyPr>
                                                                                            <a:lstStyle/>
                                                                                            <a:p>
                                                                                              <a:pPr algn="ctr"/>
                                                                                              <a:r>
                                                                                                <a:rPr lang="it-IT" sz="700" dirty="0"/>
                                                                                                <a:t>**</a:t>
                                                                                              </a:r>
                                                                                            </a:p>
                                                                                            <a:p>
                                                                                              <a:pPr algn="ctr"/>
                                                                                              <a:r>
                                                                                                <a:rPr lang="it-IT" sz="700" dirty="0"/>
                                                                                                <a:t>9</a:t>
                                                                                              </a:r>
                                                                                            </a:p>
                                                                                          </p:txBody>
                                                                                        </p:sp>
                                                                                      </p:grpSp>
                                                                                      <p:sp>
                                                                                        <p:nvSpPr>
                                                                                          <p:cNvPr id="90" name="CasellaDiTesto 89"/>
                                                                                          <p:cNvSpPr txBox="1"/>
                                                                                          <p:nvPr/>
                                                                                        </p:nvSpPr>
                                                                                        <p:spPr>
                                                                                          <a:xfrm>
                                                                                            <a:off x="2464866" y="5693751"/>
                                                                                            <a:ext cx="280658" cy="307777"/>
                                                                                          </a:xfrm>
                                                                                          <a:prstGeom prst="rect">
                                                                                            <a:avLst/>
                                                                                          </a:prstGeom>
                                                                                          <a:noFill/>
                                                                                        </p:spPr>
                                                                                        <p:txBody>
                                                                                          <a:bodyPr wrap="square" rtlCol="0">
                                                                                            <a:spAutoFit/>
                                                                                          </a:bodyPr>
                                                                                          <a:lstStyle/>
                                                                                          <a:p>
                                                                                            <a:pPr algn="ctr"/>
                                                                                            <a:r>
                                                                                              <a:rPr lang="it-IT" sz="700" dirty="0"/>
                                                                                              <a:t>**</a:t>
                                                                                            </a:r>
                                                                                          </a:p>
                                                                                          <a:p>
                                                                                            <a:pPr algn="ctr"/>
                                                                                            <a:r>
                                                                                              <a:rPr lang="it-IT" sz="700" dirty="0"/>
                                                                                              <a:t>9</a:t>
                                                                                            </a:r>
                                                                                          </a:p>
                                                                                        </p:txBody>
                                                                                      </p:sp>
                                                                                    </p:grpSp>
                                                                                    <p:sp>
                                                                                      <p:nvSpPr>
                                                                                        <p:cNvPr id="92" name="CasellaDiTesto 91"/>
                                                                                        <p:cNvSpPr txBox="1"/>
                                                                                        <p:nvPr/>
                                                                                      </p:nvSpPr>
                                                                                      <p:spPr>
                                                                                        <a:xfrm>
                                                                                          <a:off x="2622164" y="2211684"/>
                                                                                          <a:ext cx="280658" cy="307777"/>
                                                                                        </a:xfrm>
                                                                                        <a:prstGeom prst="rect">
                                                                                          <a:avLst/>
                                                                                        </a:prstGeom>
                                                                                        <a:noFill/>
                                                                                      </p:spPr>
                                                                                      <p:txBody>
                                                                                        <a:bodyPr wrap="square" rtlCol="0">
                                                                                          <a:spAutoFit/>
                                                                                        </a:bodyPr>
                                                                                        <a:lstStyle/>
                                                                                        <a:p>
                                                                                          <a:pPr algn="ctr"/>
                                                                                          <a:r>
                                                                                            <a:rPr lang="it-IT" sz="700" dirty="0"/>
                                                                                            <a:t>**</a:t>
                                                                                          </a:r>
                                                                                        </a:p>
                                                                                        <a:p>
                                                                                          <a:pPr algn="ctr"/>
                                                                                          <a:r>
                                                                                            <a:rPr lang="it-IT" sz="700" dirty="0"/>
                                                                                            <a:t>9</a:t>
                                                                                          </a:r>
                                                                                        </a:p>
                                                                                      </p:txBody>
                                                                                    </p:sp>
                                                                                  </p:grpSp>
                                                                                  <p:sp>
                                                                                    <p:nvSpPr>
                                                                                      <p:cNvPr id="94" name="CasellaDiTesto 93"/>
                                                                                      <p:cNvSpPr txBox="1"/>
                                                                                      <p:nvPr/>
                                                                                    </p:nvSpPr>
                                                                                    <p:spPr>
                                                                                      <a:xfrm>
                                                                                        <a:off x="2622582" y="4665272"/>
                                                                                        <a:ext cx="280658" cy="307777"/>
                                                                                      </a:xfrm>
                                                                                      <a:prstGeom prst="rect">
                                                                                        <a:avLst/>
                                                                                      </a:prstGeom>
                                                                                      <a:noFill/>
                                                                                    </p:spPr>
                                                                                    <p:txBody>
                                                                                      <a:bodyPr wrap="square" rtlCol="0">
                                                                                        <a:spAutoFit/>
                                                                                      </a:bodyPr>
                                                                                      <a:lstStyle/>
                                                                                      <a:p>
                                                                                        <a:pPr algn="ctr"/>
                                                                                        <a:r>
                                                                                          <a:rPr lang="it-IT" sz="700" dirty="0"/>
                                                                                          <a:t>**</a:t>
                                                                                        </a:r>
                                                                                      </a:p>
                                                                                      <a:p>
                                                                                        <a:pPr algn="ctr"/>
                                                                                        <a:r>
                                                                                          <a:rPr lang="it-IT" sz="700" dirty="0"/>
                                                                                          <a:t>9</a:t>
                                                                                        </a:r>
                                                                                      </a:p>
                                                                                    </p:txBody>
                                                                                  </p:sp>
                                                                                </p:grpSp>
                                                                                <p:sp>
                                                                                  <p:nvSpPr>
                                                                                    <p:cNvPr id="96" name="CasellaDiTesto 95"/>
                                                                                    <p:cNvSpPr txBox="1"/>
                                                                                    <p:nvPr/>
                                                                                  </p:nvSpPr>
                                                                                  <p:spPr>
                                                                                    <a:xfrm>
                                                                                      <a:off x="2774564" y="2067668"/>
                                                                                      <a:ext cx="280658" cy="200055"/>
                                                                                    </a:xfrm>
                                                                                    <a:prstGeom prst="rect">
                                                                                      <a:avLst/>
                                                                                    </a:prstGeom>
                                                                                    <a:noFill/>
                                                                                  </p:spPr>
                                                                                  <p:txBody>
                                                                                    <a:bodyPr wrap="square" rtlCol="0">
                                                                                      <a:spAutoFit/>
                                                                                    </a:bodyPr>
                                                                                    <a:lstStyle/>
                                                                                    <a:p>
                                                                                      <a:pPr algn="ctr"/>
                                                                                      <a:r>
                                                                                        <a:rPr lang="it-IT" sz="700" dirty="0"/>
                                                                                        <a:t>8</a:t>
                                                                                      </a:r>
                                                                                    </a:p>
                                                                                  </p:txBody>
                                                                                </p:sp>
                                                                              </p:grpSp>
                                                                              <p:sp>
                                                                                <p:nvSpPr>
                                                                                  <p:cNvPr id="98" name="CasellaDiTesto 97"/>
                                                                                  <p:cNvSpPr txBox="1"/>
                                                                                  <p:nvPr/>
                                                                                </p:nvSpPr>
                                                                                <p:spPr>
                                                                                  <a:xfrm>
                                                                                    <a:off x="2774982" y="4011884"/>
                                                                                    <a:ext cx="280658" cy="307777"/>
                                                                                  </a:xfrm>
                                                                                  <a:prstGeom prst="rect">
                                                                                    <a:avLst/>
                                                                                  </a:prstGeom>
                                                                                  <a:noFill/>
                                                                                </p:spPr>
                                                                                <p:txBody>
                                                                                  <a:bodyPr wrap="square" rtlCol="0">
                                                                                    <a:spAutoFit/>
                                                                                  </a:bodyPr>
                                                                                  <a:lstStyle/>
                                                                                  <a:p>
                                                                                    <a:pPr algn="ctr"/>
                                                                                    <a:r>
                                                                                      <a:rPr lang="it-IT" sz="700" dirty="0"/>
                                                                                      <a:t>**</a:t>
                                                                                    </a:r>
                                                                                  </a:p>
                                                                                  <a:p>
                                                                                    <a:pPr algn="ctr"/>
                                                                                    <a:r>
                                                                                      <a:rPr lang="it-IT" sz="700" dirty="0"/>
                                                                                      <a:t>8</a:t>
                                                                                    </a:r>
                                                                                  </a:p>
                                                                                </p:txBody>
                                                                              </p:sp>
                                                                            </p:grpSp>
                                                                            <p:sp>
                                                                              <p:nvSpPr>
                                                                                <p:cNvPr id="100" name="CasellaDiTesto 99"/>
                                                                                <p:cNvSpPr txBox="1"/>
                                                                                <p:nvPr/>
                                                                              </p:nvSpPr>
                                                                              <p:spPr>
                                                                                <a:xfrm>
                                                                                  <a:off x="2932280" y="2494400"/>
                                                                                  <a:ext cx="280658" cy="307777"/>
                                                                                </a:xfrm>
                                                                                <a:prstGeom prst="rect">
                                                                                  <a:avLst/>
                                                                                </a:prstGeom>
                                                                                <a:noFill/>
                                                                              </p:spPr>
                                                                              <p:txBody>
                                                                                <a:bodyPr wrap="square" rtlCol="0">
                                                                                  <a:spAutoFit/>
                                                                                </a:bodyPr>
                                                                                <a:lstStyle/>
                                                                                <a:p>
                                                                                  <a:pPr algn="ctr"/>
                                                                                  <a:r>
                                                                                    <a:rPr lang="it-IT" sz="700" dirty="0"/>
                                                                                    <a:t>**8</a:t>
                                                                                  </a:r>
                                                                                </a:p>
                                                                              </p:txBody>
                                                                            </p:sp>
                                                                          </p:grpSp>
                                                                          <p:sp>
                                                                            <p:nvSpPr>
                                                                              <p:cNvPr id="102" name="CasellaDiTesto 101"/>
                                                                              <p:cNvSpPr txBox="1"/>
                                                                              <p:nvPr/>
                                                                            </p:nvSpPr>
                                                                            <p:spPr>
                                                                              <a:xfrm>
                                                                                <a:off x="2932698" y="5236020"/>
                                                                                <a:ext cx="280658" cy="307777"/>
                                                                              </a:xfrm>
                                                                              <a:prstGeom prst="rect">
                                                                                <a:avLst/>
                                                                              </a:prstGeom>
                                                                              <a:noFill/>
                                                                            </p:spPr>
                                                                            <p:txBody>
                                                                              <a:bodyPr wrap="square" rtlCol="0">
                                                                                <a:spAutoFit/>
                                                                              </a:bodyPr>
                                                                              <a:lstStyle/>
                                                                              <a:p>
                                                                                <a:pPr algn="ctr"/>
                                                                                <a:r>
                                                                                  <a:rPr lang="it-IT" sz="700" dirty="0"/>
                                                                                  <a:t>*</a:t>
                                                                                </a:r>
                                                                              </a:p>
                                                                              <a:p>
                                                                                <a:pPr algn="ctr"/>
                                                                                <a:r>
                                                                                  <a:rPr lang="it-IT" sz="700" dirty="0"/>
                                                                                  <a:t>8</a:t>
                                                                                </a:r>
                                                                              </a:p>
                                                                            </p:txBody>
                                                                          </p:sp>
                                                                        </p:grpSp>
                                                                        <p:sp>
                                                                          <p:nvSpPr>
                                                                            <p:cNvPr id="104" name="CasellaDiTesto 103"/>
                                                                            <p:cNvSpPr txBox="1"/>
                                                                            <p:nvPr/>
                                                                          </p:nvSpPr>
                                                                          <p:spPr>
                                                                            <a:xfrm>
                                                                              <a:off x="3084680" y="2211684"/>
                                                                              <a:ext cx="280658" cy="307777"/>
                                                                            </a:xfrm>
                                                                            <a:prstGeom prst="rect">
                                                                              <a:avLst/>
                                                                            </a:prstGeom>
                                                                            <a:noFill/>
                                                                          </p:spPr>
                                                                          <p:txBody>
                                                                            <a:bodyPr wrap="square" rtlCol="0">
                                                                              <a:spAutoFit/>
                                                                            </a:bodyPr>
                                                                            <a:lstStyle/>
                                                                            <a:p>
                                                                              <a:pPr algn="ctr"/>
                                                                              <a:r>
                                                                                <a:rPr lang="it-IT" sz="700" dirty="0"/>
                                                                                <a:t>**8</a:t>
                                                                              </a:r>
                                                                            </a:p>
                                                                          </p:txBody>
                                                                        </p:sp>
                                                                      </p:grpSp>
                                                                      <p:sp>
                                                                        <p:nvSpPr>
                                                                          <p:cNvPr id="106" name="CasellaDiTesto 105"/>
                                                                          <p:cNvSpPr txBox="1"/>
                                                                          <p:nvPr/>
                                                                        </p:nvSpPr>
                                                                        <p:spPr>
                                                                          <a:xfrm>
                                                                            <a:off x="3090414" y="5204124"/>
                                                                            <a:ext cx="280658" cy="307777"/>
                                                                          </a:xfrm>
                                                                          <a:prstGeom prst="rect">
                                                                            <a:avLst/>
                                                                          </a:prstGeom>
                                                                          <a:noFill/>
                                                                        </p:spPr>
                                                                        <p:txBody>
                                                                          <a:bodyPr wrap="square" rtlCol="0">
                                                                            <a:spAutoFit/>
                                                                          </a:bodyPr>
                                                                          <a:lstStyle/>
                                                                          <a:p>
                                                                            <a:pPr algn="ctr"/>
                                                                            <a:r>
                                                                              <a:rPr lang="it-IT" sz="700" dirty="0"/>
                                                                              <a:t>**</a:t>
                                                                            </a:r>
                                                                          </a:p>
                                                                          <a:p>
                                                                            <a:pPr algn="ctr"/>
                                                                            <a:r>
                                                                              <a:rPr lang="it-IT" sz="700" dirty="0"/>
                                                                              <a:t>8</a:t>
                                                                            </a:r>
                                                                          </a:p>
                                                                        </p:txBody>
                                                                      </p:sp>
                                                                    </p:grpSp>
                                                                    <p:sp>
                                                                      <p:nvSpPr>
                                                                        <p:cNvPr id="108" name="CasellaDiTesto 107"/>
                                                                        <p:cNvSpPr txBox="1"/>
                                                                        <p:nvPr/>
                                                                      </p:nvSpPr>
                                                                      <p:spPr>
                                                                        <a:xfrm>
                                                                          <a:off x="3237080" y="1763688"/>
                                                                          <a:ext cx="280658" cy="200055"/>
                                                                        </a:xfrm>
                                                                        <a:prstGeom prst="rect">
                                                                          <a:avLst/>
                                                                        </a:prstGeom>
                                                                        <a:noFill/>
                                                                      </p:spPr>
                                                                      <p:txBody>
                                                                        <a:bodyPr wrap="square" rtlCol="0">
                                                                          <a:spAutoFit/>
                                                                        </a:bodyPr>
                                                                        <a:lstStyle/>
                                                                        <a:p>
                                                                          <a:pPr algn="ctr"/>
                                                                          <a:r>
                                                                            <a:rPr lang="it-IT" sz="700" dirty="0"/>
                                                                            <a:t>8</a:t>
                                                                          </a:r>
                                                                        </a:p>
                                                                      </p:txBody>
                                                                    </p:sp>
                                                                  </p:grpSp>
                                                                  <p:sp>
                                                                    <p:nvSpPr>
                                                                      <p:cNvPr id="110" name="CasellaDiTesto 109"/>
                                                                      <p:cNvSpPr txBox="1"/>
                                                                      <p:nvPr/>
                                                                    </p:nvSpPr>
                                                                    <p:spPr>
                                                                      <a:xfrm>
                                                                        <a:off x="3242814" y="4737280"/>
                                                                        <a:ext cx="280658" cy="307777"/>
                                                                      </a:xfrm>
                                                                      <a:prstGeom prst="rect">
                                                                        <a:avLst/>
                                                                      </a:prstGeom>
                                                                      <a:noFill/>
                                                                    </p:spPr>
                                                                    <p:txBody>
                                                                      <a:bodyPr wrap="square" rtlCol="0">
                                                                        <a:spAutoFit/>
                                                                      </a:bodyPr>
                                                                      <a:lstStyle/>
                                                                      <a:p>
                                                                        <a:pPr algn="ctr"/>
                                                                        <a:r>
                                                                          <a:rPr lang="it-IT" sz="700" dirty="0"/>
                                                                          <a:t>**</a:t>
                                                                        </a:r>
                                                                      </a:p>
                                                                      <a:p>
                                                                        <a:pPr algn="ctr"/>
                                                                        <a:r>
                                                                          <a:rPr lang="it-IT" sz="700" dirty="0"/>
                                                                          <a:t>8</a:t>
                                                                        </a:r>
                                                                      </a:p>
                                                                    </p:txBody>
                                                                  </p:sp>
                                                                </p:grpSp>
                                                                <p:sp>
                                                                  <p:nvSpPr>
                                                                    <p:cNvPr id="112" name="CasellaDiTesto 111"/>
                                                                    <p:cNvSpPr txBox="1"/>
                                                                    <p:nvPr/>
                                                                  </p:nvSpPr>
                                                                  <p:spPr>
                                                                    <a:xfrm>
                                                                      <a:off x="3389480" y="2439859"/>
                                                                      <a:ext cx="280658" cy="307777"/>
                                                                    </a:xfrm>
                                                                    <a:prstGeom prst="rect">
                                                                      <a:avLst/>
                                                                    </a:prstGeom>
                                                                    <a:noFill/>
                                                                  </p:spPr>
                                                                  <p:txBody>
                                                                    <a:bodyPr wrap="square" rtlCol="0">
                                                                      <a:spAutoFit/>
                                                                    </a:bodyPr>
                                                                    <a:lstStyle/>
                                                                    <a:p>
                                                                      <a:pPr algn="ctr"/>
                                                                      <a:r>
                                                                        <a:rPr lang="it-IT" sz="700" dirty="0"/>
                                                                        <a:t>**10</a:t>
                                                                      </a:r>
                                                                    </a:p>
                                                                  </p:txBody>
                                                                </p:sp>
                                                              </p:grpSp>
                                                              <p:sp>
                                                                <p:nvSpPr>
                                                                  <p:cNvPr id="114" name="CasellaDiTesto 113"/>
                                                                  <p:cNvSpPr txBox="1"/>
                                                                  <p:nvPr/>
                                                                </p:nvSpPr>
                                                                <p:spPr>
                                                                  <a:xfrm>
                                                                    <a:off x="3395214" y="4686536"/>
                                                                    <a:ext cx="280658" cy="307777"/>
                                                                  </a:xfrm>
                                                                  <a:prstGeom prst="rect">
                                                                    <a:avLst/>
                                                                  </a:prstGeom>
                                                                  <a:noFill/>
                                                                </p:spPr>
                                                                <p:txBody>
                                                                  <a:bodyPr wrap="square" rtlCol="0">
                                                                    <a:spAutoFit/>
                                                                  </a:bodyPr>
                                                                  <a:lstStyle/>
                                                                  <a:p>
                                                                    <a:pPr algn="ctr"/>
                                                                    <a:r>
                                                                      <a:rPr lang="it-IT" sz="700" dirty="0"/>
                                                                      <a:t>**</a:t>
                                                                    </a:r>
                                                                  </a:p>
                                                                  <a:p>
                                                                    <a:pPr algn="ctr"/>
                                                                    <a:r>
                                                                      <a:rPr lang="it-IT" sz="700" dirty="0"/>
                                                                      <a:t>10</a:t>
                                                                    </a:r>
                                                                  </a:p>
                                                                </p:txBody>
                                                              </p:sp>
                                                            </p:grpSp>
                                                            <p:sp>
                                                              <p:nvSpPr>
                                                                <p:cNvPr id="116" name="CasellaDiTesto 115"/>
                                                                <p:cNvSpPr txBox="1"/>
                                                                <p:nvPr/>
                                                              </p:nvSpPr>
                                                              <p:spPr>
                                                                <a:xfrm>
                                                                  <a:off x="3552512" y="2025140"/>
                                                                  <a:ext cx="280658" cy="307777"/>
                                                                </a:xfrm>
                                                                <a:prstGeom prst="rect">
                                                                  <a:avLst/>
                                                                </a:prstGeom>
                                                                <a:noFill/>
                                                              </p:spPr>
                                                              <p:txBody>
                                                                <a:bodyPr wrap="square" rtlCol="0">
                                                                  <a:spAutoFit/>
                                                                </a:bodyPr>
                                                                <a:lstStyle/>
                                                                <a:p>
                                                                  <a:pPr algn="ctr"/>
                                                                  <a:r>
                                                                    <a:rPr lang="it-IT" sz="700" dirty="0"/>
                                                                    <a:t>**</a:t>
                                                                  </a:r>
                                                                </a:p>
                                                                <a:p>
                                                                  <a:pPr algn="ctr"/>
                                                                  <a:r>
                                                                    <a:rPr lang="it-IT" sz="700" dirty="0"/>
                                                                    <a:t>9</a:t>
                                                                  </a:r>
                                                                </a:p>
                                                              </p:txBody>
                                                            </p:sp>
                                                          </p:grpSp>
                                                          <p:sp>
                                                            <p:nvSpPr>
                                                              <p:cNvPr id="118" name="CasellaDiTesto 117"/>
                                                              <p:cNvSpPr txBox="1"/>
                                                              <p:nvPr/>
                                                            </p:nvSpPr>
                                                            <p:spPr>
                                                              <a:xfrm>
                                                                <a:off x="3552930" y="4718916"/>
                                                                <a:ext cx="280658" cy="307777"/>
                                                              </a:xfrm>
                                                              <a:prstGeom prst="rect">
                                                                <a:avLst/>
                                                              </a:prstGeom>
                                                              <a:noFill/>
                                                            </p:spPr>
                                                            <p:txBody>
                                                              <a:bodyPr wrap="square" rtlCol="0">
                                                                <a:spAutoFit/>
                                                              </a:bodyPr>
                                                              <a:lstStyle/>
                                                              <a:p>
                                                                <a:pPr algn="ctr"/>
                                                                <a:r>
                                                                  <a:rPr lang="it-IT" sz="700" dirty="0"/>
                                                                  <a:t>**</a:t>
                                                                </a:r>
                                                              </a:p>
                                                              <a:p>
                                                                <a:pPr algn="ctr"/>
                                                                <a:r>
                                                                  <a:rPr lang="it-IT" sz="700" dirty="0"/>
                                                                  <a:t>9</a:t>
                                                                </a:r>
                                                              </a:p>
                                                            </p:txBody>
                                                          </p:sp>
                                                        </p:grpSp>
                                                        <p:sp>
                                                          <p:nvSpPr>
                                                            <p:cNvPr id="120" name="CasellaDiTesto 119"/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3704912" y="2067668"/>
                                                              <a:ext cx="280658" cy="307777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r>
                                                                <a:rPr lang="it-IT" sz="700" dirty="0"/>
                                                                <a:t>**</a:t>
                                                              </a:r>
                                                            </a:p>
                                                            <a:p>
                                                              <a:pPr algn="ctr"/>
                                                              <a:r>
                                                                <a:rPr lang="it-IT" sz="700" dirty="0"/>
                                                                <a:t>8</a:t>
                                                              </a:r>
                                                            </a:p>
                                                          </p:txBody>
                                                        </p:sp>
                                                      </p:grpSp>
                                                      <p:sp>
                                                        <p:nvSpPr>
                                                          <p:cNvPr id="122" name="CasellaDiTesto 121"/>
                                                          <p:cNvSpPr txBox="1"/>
                                                          <p:nvPr/>
                                                        </p:nvSpPr>
                                                        <p:spPr>
                                                          <a:xfrm>
                                                            <a:off x="3705330" y="4745496"/>
                                                            <a:ext cx="280658" cy="307777"/>
                                                          </a:xfrm>
                                                          <a:prstGeom prst="rect">
                                                            <a:avLst/>
                                                          </a:prstGeom>
                                                          <a:noFill/>
                                                        </p:spPr>
                                                        <p:txBody>
                                                          <a:bodyPr wrap="square" rtlCol="0">
                                                            <a:spAutoFit/>
                                                          </a:bodyPr>
                                                          <a:lstStyle/>
                                                          <a:p>
                                                            <a:pPr algn="ctr"/>
                                                            <a:r>
                                                              <a:rPr lang="it-IT" sz="700" dirty="0"/>
                                                              <a:t>**</a:t>
                                                            </a:r>
                                                          </a:p>
                                                          <a:p>
                                                            <a:pPr algn="ctr"/>
                                                            <a:r>
                                                              <a:rPr lang="it-IT" sz="700" dirty="0"/>
                                                              <a:t>8</a:t>
                                                            </a:r>
                                                          </a:p>
                                                        </p:txBody>
                                                      </p:sp>
                                                    </p:grpSp>
                                                    <p:sp>
                                                      <p:nvSpPr>
                                                        <p:cNvPr id="124" name="CasellaDiTesto 123"/>
                                                        <p:cNvSpPr txBox="1"/>
                                                        <p:nvPr/>
                                                      </p:nvSpPr>
                                                      <p:spPr>
                                                        <a:xfrm>
                                                          <a:off x="3857312" y="1958448"/>
                                                          <a:ext cx="280658" cy="307777"/>
                                                        </a:xfrm>
                                                        <a:prstGeom prst="rect">
                                                          <a:avLst/>
                                                        </a:prstGeom>
                                                        <a:noFill/>
                                                      </p:spPr>
                                                      <p:txBody>
                                                        <a:bodyPr wrap="square" rtlCol="0">
                                                          <a:spAutoFit/>
                                                        </a:bodyPr>
                                                        <a:lstStyle/>
                                                        <a:p>
                                                          <a:pPr algn="ctr"/>
                                                          <a:r>
                                                            <a:rPr lang="it-IT" sz="700" dirty="0"/>
                                                            <a:t>*</a:t>
                                                          </a:r>
                                                        </a:p>
                                                        <a:p>
                                                          <a:pPr algn="ctr"/>
                                                          <a:r>
                                                            <a:rPr lang="it-IT" sz="700" dirty="0"/>
                                                            <a:t>10</a:t>
                                                          </a:r>
                                                        </a:p>
                                                      </p:txBody>
                                                    </p:sp>
                                                  </p:grpSp>
                                                  <p:sp>
                                                    <p:nvSpPr>
                                                      <p:cNvPr id="126" name="CasellaDiTesto 125"/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3863046" y="5395087"/>
                                                        <a:ext cx="280658" cy="307777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squar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pPr algn="ctr"/>
                                                        <a:r>
                                                          <a:rPr lang="it-IT" sz="700" dirty="0"/>
                                                          <a:t>**</a:t>
                                                        </a:r>
                                                      </a:p>
                                                      <a:p>
                                                        <a:pPr algn="ctr"/>
                                                        <a:r>
                                                          <a:rPr lang="it-IT" sz="700" dirty="0"/>
                                                          <a:t>10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  <p:sp>
                                                  <p:nvSpPr>
                                                    <p:cNvPr id="128" name="CasellaDiTesto 127"/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4015028" y="1774320"/>
                                                      <a:ext cx="280658" cy="200055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squar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pPr algn="ctr"/>
                                                      <a:r>
                                                        <a:rPr lang="it-IT" sz="700" dirty="0"/>
                                                        <a:t>7</a:t>
                                                      </a: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sp>
                                                <p:nvSpPr>
                                                  <p:cNvPr id="130" name="CasellaDiTesto 129"/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4015446" y="5674903"/>
                                                    <a:ext cx="280658" cy="307777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squar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pPr algn="ctr"/>
                                                    <a:r>
                                                      <a:rPr lang="it-IT" sz="700" dirty="0"/>
                                                      <a:t>**</a:t>
                                                    </a:r>
                                                  </a:p>
                                                  <a:p>
                                                    <a:pPr algn="ctr"/>
                                                    <a:r>
                                                      <a:rPr lang="it-IT" sz="700" dirty="0"/>
                                                      <a:t>7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132" name="CasellaDiTesto 131"/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4167428" y="2838513"/>
                                                  <a:ext cx="280658" cy="200055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squar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pPr algn="ctr"/>
                                                  <a:r>
                                                    <a:rPr lang="it-IT" sz="700" dirty="0"/>
                                                    <a:t>9</a:t>
                                                  </a:r>
                                                </a:p>
                                              </p:txBody>
                                            </p:sp>
                                          </p:grpSp>
                                          <p:sp>
                                            <p:nvSpPr>
                                              <p:cNvPr id="134" name="CasellaDiTesto 133"/>
                                              <p:cNvSpPr txBox="1"/>
                                              <p:nvPr/>
                                            </p:nvSpPr>
                                            <p:spPr>
                                              <a:xfrm>
                                                <a:off x="4173162" y="5907043"/>
                                                <a:ext cx="280658" cy="200055"/>
                                              </a:xfrm>
                                              <a:prstGeom prst="rect">
                                                <a:avLst/>
                                              </a:prstGeom>
                                              <a:noFill/>
                                            </p:spPr>
                                            <p:txBody>
                                              <a:bodyPr wrap="square" rtlCol="0">
                                                <a:spAutoFit/>
                                              </a:bodyPr>
                                              <a:lstStyle/>
                                              <a:p>
                                                <a:pPr algn="ctr"/>
                                                <a:r>
                                                  <a:rPr lang="it-IT" sz="700" dirty="0"/>
                                                  <a:t>9</a:t>
                                                </a:r>
                                              </a:p>
                                            </p:txBody>
                                          </p:sp>
                                        </p:grpSp>
                                        <p:sp>
                                          <p:nvSpPr>
                                            <p:cNvPr id="136" name="CasellaDiTesto 135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4325144" y="2433024"/>
                                              <a:ext cx="280658" cy="307777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it-IT" sz="700" dirty="0"/>
                                                <a:t>**</a:t>
                                              </a:r>
                                            </a:p>
                                            <a:p>
                                              <a:pPr algn="ctr"/>
                                              <a:r>
                                                <a:rPr lang="it-IT" sz="700" dirty="0"/>
                                                <a:t>7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138" name="CasellaDiTesto 137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4329950" y="5662752"/>
                                            <a:ext cx="280658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it-IT" sz="700" dirty="0"/>
                                              <a:t>**</a:t>
                                            </a:r>
                                          </a:p>
                                          <a:p>
                                            <a:pPr algn="ctr"/>
                                            <a:r>
                                              <a:rPr lang="it-IT" sz="700" dirty="0"/>
                                              <a:t>7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140" name="CasellaDiTesto 139"/>
                                        <p:cNvSpPr txBox="1"/>
                                        <p:nvPr/>
                                      </p:nvSpPr>
                                      <p:spPr>
                                        <a:xfrm>
                                          <a:off x="4477544" y="2355700"/>
                                          <a:ext cx="280658" cy="307777"/>
                                        </a:xfrm>
                                        <a:prstGeom prst="rect">
                                          <a:avLst/>
                                        </a:prstGeom>
                                        <a:noFill/>
                                      </p:spPr>
                                      <p:txBody>
                                        <a:bodyPr wrap="square" rtlCol="0">
                                          <a:spAutoFit/>
                                        </a:bodyPr>
                                        <a:lstStyle/>
                                        <a:p>
                                          <a:pPr algn="ctr"/>
                                          <a:r>
                                            <a:rPr lang="it-IT" sz="700" dirty="0"/>
                                            <a:t>**</a:t>
                                          </a:r>
                                        </a:p>
                                        <a:p>
                                          <a:pPr algn="ctr"/>
                                          <a:r>
                                            <a:rPr lang="it-IT" sz="700" dirty="0"/>
                                            <a:t>9</a:t>
                                          </a:r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142" name="CasellaDiTesto 141"/>
                                      <p:cNvSpPr txBox="1"/>
                                      <p:nvPr/>
                                    </p:nvSpPr>
                                    <p:spPr>
                                      <a:xfrm>
                                        <a:off x="4482350" y="4180064"/>
                                        <a:ext cx="280658" cy="307777"/>
                                      </a:xfrm>
                                      <a:prstGeom prst="rect">
                                        <a:avLst/>
                                      </a:prstGeom>
                                      <a:noFill/>
                                    </p:spPr>
                                    <p:txBody>
                                      <a:bodyPr wrap="square" rtlCol="0">
                                        <a:spAutoFit/>
                                      </a:bodyPr>
                                      <a:lstStyle/>
                                      <a:p>
                                        <a:pPr algn="ctr"/>
                                        <a:r>
                                          <a:rPr lang="it-IT" sz="700" dirty="0"/>
                                          <a:t>**</a:t>
                                        </a:r>
                                      </a:p>
                                      <a:p>
                                        <a:pPr algn="ctr"/>
                                        <a:r>
                                          <a:rPr lang="it-IT" sz="700" dirty="0"/>
                                          <a:t>9</a:t>
                                        </a:r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144" name="CasellaDiTesto 143"/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4629944" y="1910604"/>
                                      <a:ext cx="280658" cy="307777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square" rtlCol="0">
                                      <a:spAutoFit/>
                                    </a:bodyPr>
                                    <a:lstStyle/>
                                    <a:p>
                                      <a:pPr algn="ctr"/>
                                      <a:r>
                                        <a:rPr lang="it-IT" sz="700" dirty="0"/>
                                        <a:t>**</a:t>
                                      </a:r>
                                    </a:p>
                                    <a:p>
                                      <a:pPr algn="ctr"/>
                                      <a:r>
                                        <a:rPr lang="it-IT" sz="700" dirty="0"/>
                                        <a:t>7</a:t>
                                      </a:r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146" name="CasellaDiTesto 145"/>
                                  <p:cNvSpPr txBox="1"/>
                                  <p:nvPr/>
                                </p:nvSpPr>
                                <p:spPr>
                                  <a:xfrm>
                                    <a:off x="4640066" y="5277651"/>
                                    <a:ext cx="280658" cy="307777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pPr algn="ctr"/>
                                    <a:r>
                                      <a:rPr lang="it-IT" sz="700" dirty="0"/>
                                      <a:t>**</a:t>
                                    </a:r>
                                  </a:p>
                                  <a:p>
                                    <a:pPr algn="ctr"/>
                                    <a:r>
                                      <a:rPr lang="it-IT" sz="700" dirty="0"/>
                                      <a:t>7</a:t>
                                    </a:r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148" name="CasellaDiTesto 147"/>
                                <p:cNvSpPr txBox="1"/>
                                <p:nvPr/>
                              </p:nvSpPr>
                              <p:spPr>
                                <a:xfrm>
                                  <a:off x="4787660" y="2278376"/>
                                  <a:ext cx="280658" cy="307777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it-IT" sz="700" dirty="0"/>
                                    <a:t>**</a:t>
                                  </a:r>
                                </a:p>
                                <a:p>
                                  <a:pPr algn="ctr"/>
                                  <a:r>
                                    <a:rPr lang="it-IT" sz="700" dirty="0"/>
                                    <a:t>8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150" name="CasellaDiTesto 149"/>
                              <p:cNvSpPr txBox="1"/>
                              <p:nvPr/>
                            </p:nvSpPr>
                            <p:spPr>
                              <a:xfrm>
                                <a:off x="4797782" y="4587948"/>
                                <a:ext cx="280658" cy="307777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pPr algn="ctr"/>
                                <a:r>
                                  <a:rPr lang="it-IT" sz="700" dirty="0"/>
                                  <a:t>**</a:t>
                                </a:r>
                              </a:p>
                              <a:p>
                                <a:pPr algn="ctr"/>
                                <a:r>
                                  <a:rPr lang="it-IT" sz="700" dirty="0"/>
                                  <a:t>8</a:t>
                                </a:r>
                              </a:p>
                            </p:txBody>
                          </p:sp>
                        </p:grpSp>
                        <p:sp>
                          <p:nvSpPr>
                            <p:cNvPr id="152" name="CasellaDiTesto 151"/>
                            <p:cNvSpPr txBox="1"/>
                            <p:nvPr/>
                          </p:nvSpPr>
                          <p:spPr>
                            <a:xfrm>
                              <a:off x="4945376" y="2313172"/>
                              <a:ext cx="280658" cy="307777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it-IT" sz="700" dirty="0"/>
                                <a:t>**</a:t>
                              </a:r>
                            </a:p>
                            <a:p>
                              <a:pPr algn="ctr"/>
                              <a:r>
                                <a:rPr lang="it-IT" sz="700" dirty="0"/>
                                <a:t>9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154" name="CasellaDiTesto 153"/>
                          <p:cNvSpPr txBox="1"/>
                          <p:nvPr/>
                        </p:nvSpPr>
                        <p:spPr>
                          <a:xfrm>
                            <a:off x="4950182" y="5539103"/>
                            <a:ext cx="280658" cy="307777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it-IT" sz="700" dirty="0"/>
                              <a:t>**</a:t>
                            </a:r>
                          </a:p>
                          <a:p>
                            <a:pPr algn="ctr"/>
                            <a:r>
                              <a:rPr lang="it-IT" sz="700" dirty="0"/>
                              <a:t>9</a:t>
                            </a:r>
                          </a:p>
                        </p:txBody>
                      </p:sp>
                    </p:grpSp>
                    <p:sp>
                      <p:nvSpPr>
                        <p:cNvPr id="156" name="CasellaDiTesto 155"/>
                        <p:cNvSpPr txBox="1"/>
                        <p:nvPr/>
                      </p:nvSpPr>
                      <p:spPr>
                        <a:xfrm>
                          <a:off x="5097776" y="1027660"/>
                          <a:ext cx="280658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it-IT" sz="700" dirty="0"/>
                            <a:t>**</a:t>
                          </a:r>
                        </a:p>
                        <a:p>
                          <a:pPr algn="ctr"/>
                          <a:r>
                            <a:rPr lang="it-IT" sz="700" dirty="0"/>
                            <a:t>9</a:t>
                          </a:r>
                        </a:p>
                      </p:txBody>
                    </p:sp>
                  </p:grpSp>
                  <p:sp>
                    <p:nvSpPr>
                      <p:cNvPr id="158" name="CasellaDiTesto 157"/>
                      <p:cNvSpPr txBox="1"/>
                      <p:nvPr/>
                    </p:nvSpPr>
                    <p:spPr>
                      <a:xfrm>
                        <a:off x="5102582" y="6018995"/>
                        <a:ext cx="280658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it-IT" sz="700" dirty="0"/>
                          <a:t>**</a:t>
                        </a:r>
                      </a:p>
                      <a:p>
                        <a:pPr algn="ctr"/>
                        <a:r>
                          <a:rPr lang="it-IT" sz="700" dirty="0"/>
                          <a:t>9</a:t>
                        </a:r>
                      </a:p>
                    </p:txBody>
                  </p:sp>
                </p:grpSp>
                <p:sp>
                  <p:nvSpPr>
                    <p:cNvPr id="160" name="CasellaDiTesto 159"/>
                    <p:cNvSpPr txBox="1"/>
                    <p:nvPr/>
                  </p:nvSpPr>
                  <p:spPr>
                    <a:xfrm>
                      <a:off x="5250176" y="2517183"/>
                      <a:ext cx="28065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it-IT" sz="700" dirty="0"/>
                        <a:t>**</a:t>
                      </a:r>
                    </a:p>
                    <a:p>
                      <a:pPr algn="ctr"/>
                      <a:r>
                        <a:rPr lang="it-IT" sz="700" dirty="0"/>
                        <a:t>8</a:t>
                      </a:r>
                    </a:p>
                  </p:txBody>
                </p:sp>
              </p:grpSp>
              <p:sp>
                <p:nvSpPr>
                  <p:cNvPr id="162" name="CasellaDiTesto 161"/>
                  <p:cNvSpPr txBox="1"/>
                  <p:nvPr/>
                </p:nvSpPr>
                <p:spPr>
                  <a:xfrm>
                    <a:off x="5260298" y="5236020"/>
                    <a:ext cx="280658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it-IT" sz="700" dirty="0"/>
                      <a:t>**</a:t>
                    </a:r>
                  </a:p>
                  <a:p>
                    <a:pPr algn="ctr"/>
                    <a:r>
                      <a:rPr lang="it-IT" sz="700" dirty="0"/>
                      <a:t>8</a:t>
                    </a:r>
                  </a:p>
                </p:txBody>
              </p:sp>
            </p:grpSp>
            <p:sp>
              <p:nvSpPr>
                <p:cNvPr id="164" name="CasellaDiTesto 163"/>
                <p:cNvSpPr txBox="1"/>
                <p:nvPr/>
              </p:nvSpPr>
              <p:spPr>
                <a:xfrm>
                  <a:off x="5412698" y="5580133"/>
                  <a:ext cx="28065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700" dirty="0"/>
                    <a:t>9</a:t>
                  </a:r>
                </a:p>
              </p:txBody>
            </p:sp>
          </p:grpSp>
          <p:sp>
            <p:nvSpPr>
              <p:cNvPr id="166" name="CasellaDiTesto 165"/>
              <p:cNvSpPr txBox="1"/>
              <p:nvPr/>
            </p:nvSpPr>
            <p:spPr>
              <a:xfrm>
                <a:off x="5407892" y="1691680"/>
                <a:ext cx="28065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700" dirty="0"/>
                  <a:t>9</a:t>
                </a:r>
              </a:p>
            </p:txBody>
          </p:sp>
        </p:grpSp>
      </p:grpSp>
      <p:sp>
        <p:nvSpPr>
          <p:cNvPr id="168" name="CasellaDiTesto 167"/>
          <p:cNvSpPr txBox="1"/>
          <p:nvPr/>
        </p:nvSpPr>
        <p:spPr>
          <a:xfrm>
            <a:off x="836712" y="98212"/>
            <a:ext cx="4536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S9</a:t>
            </a:r>
            <a:r>
              <a:rPr lang="it-IT" dirty="0"/>
              <a:t>: Heavy metal mobilization assay</a:t>
            </a:r>
          </a:p>
        </p:txBody>
      </p:sp>
    </p:spTree>
    <p:extLst>
      <p:ext uri="{BB962C8B-B14F-4D97-AF65-F5344CB8AC3E}">
        <p14:creationId xmlns:p14="http://schemas.microsoft.com/office/powerpoint/2010/main" val="24392324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35B267E86190B489C08C8BB0A2802E5" ma:contentTypeVersion="11" ma:contentTypeDescription="Create a new document." ma:contentTypeScope="" ma:versionID="49bb1ea486012dfb924947ef2868eb7b">
  <xsd:schema xmlns:xsd="http://www.w3.org/2001/XMLSchema" xmlns:xs="http://www.w3.org/2001/XMLSchema" xmlns:p="http://schemas.microsoft.com/office/2006/metadata/properties" xmlns:ns3="78080c2c-6a1f-4cc7-96e6-b3fe7f8f50a3" xmlns:ns4="0e955481-44cf-4f91-ac07-8c131b063785" targetNamespace="http://schemas.microsoft.com/office/2006/metadata/properties" ma:root="true" ma:fieldsID="34ecb023a06f6261894acf6b2ed0caf4" ns3:_="" ns4:_="">
    <xsd:import namespace="78080c2c-6a1f-4cc7-96e6-b3fe7f8f50a3"/>
    <xsd:import namespace="0e955481-44cf-4f91-ac07-8c131b06378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80c2c-6a1f-4cc7-96e6-b3fe7f8f50a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e955481-44cf-4f91-ac07-8c131b063785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E4F077D-A851-45A8-B163-F69DF1A8A3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80c2c-6a1f-4cc7-96e6-b3fe7f8f50a3"/>
    <ds:schemaRef ds:uri="0e955481-44cf-4f91-ac07-8c131b06378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57E593D-7AD3-433B-84D4-D7AF2448EB80}">
  <ds:schemaRefs>
    <ds:schemaRef ds:uri="http://schemas.microsoft.com/office/2006/metadata/properties"/>
    <ds:schemaRef ds:uri="78080c2c-6a1f-4cc7-96e6-b3fe7f8f50a3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0e955481-44cf-4f91-ac07-8c131b063785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66350AF9-30E4-43DC-A97B-EA13C6E97B1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4</Words>
  <Application>Microsoft Office PowerPoint</Application>
  <PresentationFormat>Bildschirmpräsentation (4:3)</PresentationFormat>
  <Paragraphs>178</Paragraphs>
  <Slides>1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6" baseType="lpstr">
      <vt:lpstr>Arial</vt:lpstr>
      <vt:lpstr>Calibri</vt:lpstr>
      <vt:lpstr>Tema di 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rika</dc:creator>
  <cp:lastModifiedBy>Brader Günter</cp:lastModifiedBy>
  <cp:revision>179</cp:revision>
  <dcterms:created xsi:type="dcterms:W3CDTF">2016-07-08T09:56:00Z</dcterms:created>
  <dcterms:modified xsi:type="dcterms:W3CDTF">2020-07-08T19:42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35B267E86190B489C08C8BB0A2802E5</vt:lpwstr>
  </property>
</Properties>
</file>